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14400213" cy="10799763"/>
  <p:notesSz cx="6858000" cy="9144000"/>
  <p:defaultTextStyle>
    <a:defPPr>
      <a:defRPr lang="es-ES"/>
    </a:defPPr>
    <a:lvl1pPr marL="0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1pPr>
    <a:lvl2pPr marL="604784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2pPr>
    <a:lvl3pPr marL="1209568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3pPr>
    <a:lvl4pPr marL="1814352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4pPr>
    <a:lvl5pPr marL="2419137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5pPr>
    <a:lvl6pPr marL="3023921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6pPr>
    <a:lvl7pPr marL="3628705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7pPr>
    <a:lvl8pPr marL="4233489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8pPr>
    <a:lvl9pPr marL="4838273" algn="l" defTabSz="1209568" rtl="0" eaLnBrk="1" latinLnBrk="0" hangingPunct="1">
      <a:defRPr sz="238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02" userDrawn="1">
          <p15:clr>
            <a:srgbClr val="A4A3A4"/>
          </p15:clr>
        </p15:guide>
        <p15:guide id="2" pos="45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D579"/>
    <a:srgbClr val="FFFFFF"/>
    <a:srgbClr val="945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625EFE-2EDD-D04B-8416-C12E36C31FC2}" v="6" dt="2021-09-20T10:45:50.82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/>
    <p:restoredTop sz="85016"/>
  </p:normalViewPr>
  <p:slideViewPr>
    <p:cSldViewPr snapToGrid="0" snapToObjects="1" showGuides="1">
      <p:cViewPr varScale="1">
        <p:scale>
          <a:sx n="61" d="100"/>
          <a:sy n="61" d="100"/>
        </p:scale>
        <p:origin x="2616" y="72"/>
      </p:cViewPr>
      <p:guideLst>
        <p:guide orient="horz" pos="3402"/>
        <p:guide pos="45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241703-5AA5-E64D-95F6-51161BC427D6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8ED22B-1977-FB44-B237-95BEDA25F76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6492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1pPr>
    <a:lvl2pPr marL="604784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2pPr>
    <a:lvl3pPr marL="1209568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3pPr>
    <a:lvl4pPr marL="1814352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4pPr>
    <a:lvl5pPr marL="2419137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5pPr>
    <a:lvl6pPr marL="3023921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6pPr>
    <a:lvl7pPr marL="3628705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7pPr>
    <a:lvl8pPr marL="4233489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8pPr>
    <a:lvl9pPr marL="4838273" algn="l" defTabSz="1209568" rtl="0" eaLnBrk="1" latinLnBrk="0" hangingPunct="1">
      <a:defRPr sz="158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587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2.</a:t>
            </a:r>
            <a:r>
              <a:rPr lang="en-US" sz="1587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raphical scheme of early immune response in septic shock patients showing released cytokines and mediators from different immune cells and endothelium analyzed in our work . The scheme presents an overview of the regulation of the early immune molecular response in septic shock patients. Up arrow indicates overexpression, Down arrow indicates down-regulation, ∼ indicates no variation in comparison to control samples. Orange names are pro-inflammatory cytokines, Green names are anti-inflammatory cytokines, blue names are cells. </a:t>
            </a:r>
            <a:endParaRPr lang="es-ES" sz="1587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8ED22B-1977-FB44-B237-95BEDA25F76D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40584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1767462"/>
            <a:ext cx="12240181" cy="375991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5672376"/>
            <a:ext cx="10800160" cy="2607442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5316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1092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574987"/>
            <a:ext cx="3105046" cy="9152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574987"/>
            <a:ext cx="9135135" cy="9152300"/>
          </a:xfrm>
        </p:spPr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3942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2225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2692444"/>
            <a:ext cx="12420184" cy="449240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7227345"/>
            <a:ext cx="12420184" cy="2362447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9548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2874937"/>
            <a:ext cx="6120091" cy="6852350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2874937"/>
            <a:ext cx="6120091" cy="6852350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9100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574990"/>
            <a:ext cx="12420184" cy="208745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2647443"/>
            <a:ext cx="6091964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3944914"/>
            <a:ext cx="6091964" cy="5802373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2647443"/>
            <a:ext cx="6121966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3944914"/>
            <a:ext cx="6121966" cy="5802373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9857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1380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8152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19984"/>
            <a:ext cx="4644444" cy="251994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1554968"/>
            <a:ext cx="7290108" cy="767483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239929"/>
            <a:ext cx="4644444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9536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19984"/>
            <a:ext cx="4644444" cy="251994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1554968"/>
            <a:ext cx="7290108" cy="767483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239929"/>
            <a:ext cx="4644444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6543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574990"/>
            <a:ext cx="12420184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2874937"/>
            <a:ext cx="12420184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0009783"/>
            <a:ext cx="324004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A557D-7E05-4041-A3E7-1881BAF2E170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0009783"/>
            <a:ext cx="4860072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0009783"/>
            <a:ext cx="324004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D1EE0-B6C9-564C-ACE2-07BC4AEEF27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9248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tif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2" name="Grupo 571">
            <a:extLst>
              <a:ext uri="{FF2B5EF4-FFF2-40B4-BE49-F238E27FC236}">
                <a16:creationId xmlns:a16="http://schemas.microsoft.com/office/drawing/2014/main" id="{681B8789-4199-D74E-986B-3B971D67F12F}"/>
              </a:ext>
            </a:extLst>
          </p:cNvPr>
          <p:cNvGrpSpPr/>
          <p:nvPr/>
        </p:nvGrpSpPr>
        <p:grpSpPr>
          <a:xfrm rot="21002179">
            <a:off x="11271144" y="6790466"/>
            <a:ext cx="222395" cy="2077057"/>
            <a:chOff x="12362213" y="2324548"/>
            <a:chExt cx="222395" cy="466053"/>
          </a:xfrm>
        </p:grpSpPr>
        <p:cxnSp>
          <p:nvCxnSpPr>
            <p:cNvPr id="573" name="Conector recto 572">
              <a:extLst>
                <a:ext uri="{FF2B5EF4-FFF2-40B4-BE49-F238E27FC236}">
                  <a16:creationId xmlns:a16="http://schemas.microsoft.com/office/drawing/2014/main" id="{1C69EAA4-29B1-4A4F-8CB9-F2884DFFAB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4" name="Conector recto 573">
              <a:extLst>
                <a:ext uri="{FF2B5EF4-FFF2-40B4-BE49-F238E27FC236}">
                  <a16:creationId xmlns:a16="http://schemas.microsoft.com/office/drawing/2014/main" id="{5F01A168-0CBF-1646-ABC3-4787A172053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62213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8" name="Rectángulo 327">
            <a:extLst>
              <a:ext uri="{FF2B5EF4-FFF2-40B4-BE49-F238E27FC236}">
                <a16:creationId xmlns:a16="http://schemas.microsoft.com/office/drawing/2014/main" id="{DC8860A3-67FE-C141-9101-B2A4485A72A1}"/>
              </a:ext>
            </a:extLst>
          </p:cNvPr>
          <p:cNvSpPr/>
          <p:nvPr/>
        </p:nvSpPr>
        <p:spPr>
          <a:xfrm>
            <a:off x="6226815" y="876305"/>
            <a:ext cx="6192000" cy="8973276"/>
          </a:xfrm>
          <a:prstGeom prst="rect">
            <a:avLst/>
          </a:prstGeom>
          <a:solidFill>
            <a:srgbClr val="9411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8" name="Forma libre 167">
            <a:extLst>
              <a:ext uri="{FF2B5EF4-FFF2-40B4-BE49-F238E27FC236}">
                <a16:creationId xmlns:a16="http://schemas.microsoft.com/office/drawing/2014/main" id="{0E287864-F923-464E-B675-4FC78A41E3C7}"/>
              </a:ext>
            </a:extLst>
          </p:cNvPr>
          <p:cNvSpPr/>
          <p:nvPr/>
        </p:nvSpPr>
        <p:spPr>
          <a:xfrm rot="17025814">
            <a:off x="6462060" y="4009924"/>
            <a:ext cx="536801" cy="201807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491" name="Grupo 490">
            <a:extLst>
              <a:ext uri="{FF2B5EF4-FFF2-40B4-BE49-F238E27FC236}">
                <a16:creationId xmlns:a16="http://schemas.microsoft.com/office/drawing/2014/main" id="{1D28F2DF-7455-6C42-9B68-93896D939F29}"/>
              </a:ext>
            </a:extLst>
          </p:cNvPr>
          <p:cNvGrpSpPr/>
          <p:nvPr/>
        </p:nvGrpSpPr>
        <p:grpSpPr>
          <a:xfrm>
            <a:off x="8641117" y="7519486"/>
            <a:ext cx="539518" cy="1327676"/>
            <a:chOff x="9262225" y="7674965"/>
            <a:chExt cx="539518" cy="1327676"/>
          </a:xfrm>
        </p:grpSpPr>
        <p:cxnSp>
          <p:nvCxnSpPr>
            <p:cNvPr id="480" name="Conector recto 479">
              <a:extLst>
                <a:ext uri="{FF2B5EF4-FFF2-40B4-BE49-F238E27FC236}">
                  <a16:creationId xmlns:a16="http://schemas.microsoft.com/office/drawing/2014/main" id="{8022815A-591F-374A-B67C-B1098215430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262225" y="7677194"/>
              <a:ext cx="431425" cy="1325447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0" name="Conector recto 489">
              <a:extLst>
                <a:ext uri="{FF2B5EF4-FFF2-40B4-BE49-F238E27FC236}">
                  <a16:creationId xmlns:a16="http://schemas.microsoft.com/office/drawing/2014/main" id="{844147ED-9221-B142-B313-565DC24F7E4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579348" y="7674965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5" name="Grupo 494">
            <a:extLst>
              <a:ext uri="{FF2B5EF4-FFF2-40B4-BE49-F238E27FC236}">
                <a16:creationId xmlns:a16="http://schemas.microsoft.com/office/drawing/2014/main" id="{D07D7FA0-18F0-4C41-B4DD-4FDBF319A071}"/>
              </a:ext>
            </a:extLst>
          </p:cNvPr>
          <p:cNvGrpSpPr/>
          <p:nvPr/>
        </p:nvGrpSpPr>
        <p:grpSpPr>
          <a:xfrm>
            <a:off x="7100200" y="7988520"/>
            <a:ext cx="1284534" cy="828899"/>
            <a:chOff x="7721308" y="8143999"/>
            <a:chExt cx="1284534" cy="828899"/>
          </a:xfrm>
        </p:grpSpPr>
        <p:cxnSp>
          <p:nvCxnSpPr>
            <p:cNvPr id="477" name="Conector recto 476">
              <a:extLst>
                <a:ext uri="{FF2B5EF4-FFF2-40B4-BE49-F238E27FC236}">
                  <a16:creationId xmlns:a16="http://schemas.microsoft.com/office/drawing/2014/main" id="{231342E0-C7FE-B14C-83F3-4B98734B54D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767255" y="8243720"/>
              <a:ext cx="1238587" cy="729178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2" name="Conector recto 491">
              <a:extLst>
                <a:ext uri="{FF2B5EF4-FFF2-40B4-BE49-F238E27FC236}">
                  <a16:creationId xmlns:a16="http://schemas.microsoft.com/office/drawing/2014/main" id="{9FBC3DB6-F47C-0E4C-8BD7-1CC5A473978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21308" y="8143999"/>
              <a:ext cx="116415" cy="197128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8" name="Grupo 497">
            <a:extLst>
              <a:ext uri="{FF2B5EF4-FFF2-40B4-BE49-F238E27FC236}">
                <a16:creationId xmlns:a16="http://schemas.microsoft.com/office/drawing/2014/main" id="{36989CD7-DE5F-C34B-9256-E4C097859F15}"/>
              </a:ext>
            </a:extLst>
          </p:cNvPr>
          <p:cNvGrpSpPr/>
          <p:nvPr/>
        </p:nvGrpSpPr>
        <p:grpSpPr>
          <a:xfrm>
            <a:off x="8491935" y="5929130"/>
            <a:ext cx="272557" cy="2907016"/>
            <a:chOff x="9113043" y="6084609"/>
            <a:chExt cx="272557" cy="2907016"/>
          </a:xfrm>
        </p:grpSpPr>
        <p:cxnSp>
          <p:nvCxnSpPr>
            <p:cNvPr id="473" name="Conector recto 472">
              <a:extLst>
                <a:ext uri="{FF2B5EF4-FFF2-40B4-BE49-F238E27FC236}">
                  <a16:creationId xmlns:a16="http://schemas.microsoft.com/office/drawing/2014/main" id="{E03CB051-2696-5A4B-BF69-8EFBC97BBC8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46287" y="6088396"/>
              <a:ext cx="102558" cy="290322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6" name="Conector recto 495">
              <a:extLst>
                <a:ext uri="{FF2B5EF4-FFF2-40B4-BE49-F238E27FC236}">
                  <a16:creationId xmlns:a16="http://schemas.microsoft.com/office/drawing/2014/main" id="{3AF52199-89F6-EA49-A0DB-1B4EA08805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13043" y="6084609"/>
              <a:ext cx="272557" cy="5425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07" name="Conector recto 406">
            <a:extLst>
              <a:ext uri="{FF2B5EF4-FFF2-40B4-BE49-F238E27FC236}">
                <a16:creationId xmlns:a16="http://schemas.microsoft.com/office/drawing/2014/main" id="{3ABD1EAA-FF4E-C248-833D-4DE35311C94E}"/>
              </a:ext>
            </a:extLst>
          </p:cNvPr>
          <p:cNvCxnSpPr>
            <a:cxnSpLocks/>
          </p:cNvCxnSpPr>
          <p:nvPr/>
        </p:nvCxnSpPr>
        <p:spPr>
          <a:xfrm flipH="1" flipV="1">
            <a:off x="7427200" y="4423750"/>
            <a:ext cx="1097418" cy="408146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9" name="Imagen 348">
            <a:extLst>
              <a:ext uri="{FF2B5EF4-FFF2-40B4-BE49-F238E27FC236}">
                <a16:creationId xmlns:a16="http://schemas.microsoft.com/office/drawing/2014/main" id="{8B9ED6DC-9028-C549-9142-10B50C082520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schemeClr val="accent4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 rot="5400000">
            <a:off x="12218811" y="999640"/>
            <a:ext cx="1525175" cy="1106178"/>
          </a:xfrm>
          <a:prstGeom prst="rect">
            <a:avLst/>
          </a:prstGeom>
        </p:spPr>
      </p:pic>
      <p:pic>
        <p:nvPicPr>
          <p:cNvPr id="350" name="Imagen 349">
            <a:extLst>
              <a:ext uri="{FF2B5EF4-FFF2-40B4-BE49-F238E27FC236}">
                <a16:creationId xmlns:a16="http://schemas.microsoft.com/office/drawing/2014/main" id="{C9E0F1C1-E328-C943-B5F6-7F3D6084A780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schemeClr val="accent4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 rot="5400000">
            <a:off x="12218811" y="2531792"/>
            <a:ext cx="1525175" cy="1106178"/>
          </a:xfrm>
          <a:prstGeom prst="rect">
            <a:avLst/>
          </a:prstGeom>
        </p:spPr>
      </p:pic>
      <p:pic>
        <p:nvPicPr>
          <p:cNvPr id="351" name="Imagen 350">
            <a:extLst>
              <a:ext uri="{FF2B5EF4-FFF2-40B4-BE49-F238E27FC236}">
                <a16:creationId xmlns:a16="http://schemas.microsoft.com/office/drawing/2014/main" id="{475008F6-9BFE-774E-B7C8-9CE8CD407848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schemeClr val="accent4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 rot="5400000">
            <a:off x="12218811" y="4052628"/>
            <a:ext cx="1525175" cy="1106178"/>
          </a:xfrm>
          <a:prstGeom prst="rect">
            <a:avLst/>
          </a:prstGeom>
        </p:spPr>
      </p:pic>
      <p:sp>
        <p:nvSpPr>
          <p:cNvPr id="329" name="Circular 328">
            <a:extLst>
              <a:ext uri="{FF2B5EF4-FFF2-40B4-BE49-F238E27FC236}">
                <a16:creationId xmlns:a16="http://schemas.microsoft.com/office/drawing/2014/main" id="{BC7CCE23-C175-804C-8115-DAC10DD329BD}"/>
              </a:ext>
            </a:extLst>
          </p:cNvPr>
          <p:cNvSpPr/>
          <p:nvPr/>
        </p:nvSpPr>
        <p:spPr>
          <a:xfrm rot="10800000">
            <a:off x="6246827" y="522953"/>
            <a:ext cx="6192000" cy="783446"/>
          </a:xfrm>
          <a:prstGeom prst="pie">
            <a:avLst>
              <a:gd name="adj1" fmla="val 0"/>
              <a:gd name="adj2" fmla="val 10796662"/>
            </a:avLst>
          </a:prstGeom>
          <a:solidFill>
            <a:srgbClr val="9411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0" name="Circular 329">
            <a:extLst>
              <a:ext uri="{FF2B5EF4-FFF2-40B4-BE49-F238E27FC236}">
                <a16:creationId xmlns:a16="http://schemas.microsoft.com/office/drawing/2014/main" id="{76A5EE31-B536-484C-B831-29F4268274F4}"/>
              </a:ext>
            </a:extLst>
          </p:cNvPr>
          <p:cNvSpPr/>
          <p:nvPr/>
        </p:nvSpPr>
        <p:spPr>
          <a:xfrm rot="10800000">
            <a:off x="6246827" y="9493364"/>
            <a:ext cx="6192000" cy="783446"/>
          </a:xfrm>
          <a:prstGeom prst="pie">
            <a:avLst>
              <a:gd name="adj1" fmla="val 0"/>
              <a:gd name="adj2" fmla="val 10796662"/>
            </a:avLst>
          </a:prstGeom>
          <a:solidFill>
            <a:srgbClr val="9411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321" name="Imagen 320">
            <a:extLst>
              <a:ext uri="{FF2B5EF4-FFF2-40B4-BE49-F238E27FC236}">
                <a16:creationId xmlns:a16="http://schemas.microsoft.com/office/drawing/2014/main" id="{516BBD49-5E05-3645-B5E4-84B3DD2FB5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4899288" y="5560372"/>
            <a:ext cx="1522115" cy="1126343"/>
          </a:xfrm>
          <a:prstGeom prst="rect">
            <a:avLst/>
          </a:prstGeom>
        </p:spPr>
      </p:pic>
      <p:pic>
        <p:nvPicPr>
          <p:cNvPr id="322" name="Imagen 321">
            <a:extLst>
              <a:ext uri="{FF2B5EF4-FFF2-40B4-BE49-F238E27FC236}">
                <a16:creationId xmlns:a16="http://schemas.microsoft.com/office/drawing/2014/main" id="{20524475-950B-4440-95F5-D17151FB33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4899288" y="7081208"/>
            <a:ext cx="1522115" cy="1126343"/>
          </a:xfrm>
          <a:prstGeom prst="rect">
            <a:avLst/>
          </a:prstGeom>
        </p:spPr>
      </p:pic>
      <p:pic>
        <p:nvPicPr>
          <p:cNvPr id="323" name="Imagen 322">
            <a:extLst>
              <a:ext uri="{FF2B5EF4-FFF2-40B4-BE49-F238E27FC236}">
                <a16:creationId xmlns:a16="http://schemas.microsoft.com/office/drawing/2014/main" id="{7C36AF91-7E9C-AB45-A1F5-0417A43D99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4899288" y="8588023"/>
            <a:ext cx="1522115" cy="1126343"/>
          </a:xfrm>
          <a:prstGeom prst="rect">
            <a:avLst/>
          </a:prstGeom>
        </p:spPr>
      </p:pic>
      <p:grpSp>
        <p:nvGrpSpPr>
          <p:cNvPr id="8" name="Grupo 7">
            <a:extLst>
              <a:ext uri="{FF2B5EF4-FFF2-40B4-BE49-F238E27FC236}">
                <a16:creationId xmlns:a16="http://schemas.microsoft.com/office/drawing/2014/main" id="{C8E73597-0DB9-4A46-B936-EC41889F749C}"/>
              </a:ext>
            </a:extLst>
          </p:cNvPr>
          <p:cNvGrpSpPr/>
          <p:nvPr/>
        </p:nvGrpSpPr>
        <p:grpSpPr>
          <a:xfrm>
            <a:off x="6339195" y="2348797"/>
            <a:ext cx="817853" cy="507668"/>
            <a:chOff x="9331589" y="1532656"/>
            <a:chExt cx="817853" cy="507668"/>
          </a:xfrm>
        </p:grpSpPr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54269AA9-2E1C-BC4C-9FE2-B708FD8A3354}"/>
                </a:ext>
              </a:extLst>
            </p:cNvPr>
            <p:cNvSpPr txBox="1"/>
            <p:nvPr/>
          </p:nvSpPr>
          <p:spPr>
            <a:xfrm>
              <a:off x="9331589" y="1670992"/>
              <a:ext cx="8178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IL-18</a:t>
              </a:r>
            </a:p>
          </p:txBody>
        </p:sp>
        <p:sp>
          <p:nvSpPr>
            <p:cNvPr id="10" name="Elipse 9">
              <a:extLst>
                <a:ext uri="{FF2B5EF4-FFF2-40B4-BE49-F238E27FC236}">
                  <a16:creationId xmlns:a16="http://schemas.microsoft.com/office/drawing/2014/main" id="{0338A762-EFF5-BB41-8E73-CC13BE06B1F0}"/>
                </a:ext>
              </a:extLst>
            </p:cNvPr>
            <p:cNvSpPr>
              <a:spLocks/>
            </p:cNvSpPr>
            <p:nvPr/>
          </p:nvSpPr>
          <p:spPr>
            <a:xfrm>
              <a:off x="9637272" y="1532656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grpSp>
        <p:nvGrpSpPr>
          <p:cNvPr id="11" name="Grupo 10">
            <a:extLst>
              <a:ext uri="{FF2B5EF4-FFF2-40B4-BE49-F238E27FC236}">
                <a16:creationId xmlns:a16="http://schemas.microsoft.com/office/drawing/2014/main" id="{365CDDA4-8CBF-7B4A-B4DD-C7775CEBF86D}"/>
              </a:ext>
            </a:extLst>
          </p:cNvPr>
          <p:cNvGrpSpPr/>
          <p:nvPr/>
        </p:nvGrpSpPr>
        <p:grpSpPr>
          <a:xfrm>
            <a:off x="7142026" y="1335585"/>
            <a:ext cx="833883" cy="537609"/>
            <a:chOff x="10658864" y="1544379"/>
            <a:chExt cx="833883" cy="537609"/>
          </a:xfrm>
        </p:grpSpPr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74CAE0E9-F50A-2249-BE88-A34C171BEE12}"/>
                </a:ext>
              </a:extLst>
            </p:cNvPr>
            <p:cNvSpPr txBox="1"/>
            <p:nvPr/>
          </p:nvSpPr>
          <p:spPr>
            <a:xfrm>
              <a:off x="10658864" y="1712656"/>
              <a:ext cx="8338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IL-1⍺</a:t>
              </a:r>
            </a:p>
          </p:txBody>
        </p:sp>
        <p:sp>
          <p:nvSpPr>
            <p:cNvPr id="13" name="Elipse 12">
              <a:extLst>
                <a:ext uri="{FF2B5EF4-FFF2-40B4-BE49-F238E27FC236}">
                  <a16:creationId xmlns:a16="http://schemas.microsoft.com/office/drawing/2014/main" id="{0A32E797-B751-7549-8433-D4AA165F4E8B}"/>
                </a:ext>
              </a:extLst>
            </p:cNvPr>
            <p:cNvSpPr>
              <a:spLocks/>
            </p:cNvSpPr>
            <p:nvPr/>
          </p:nvSpPr>
          <p:spPr>
            <a:xfrm>
              <a:off x="10972562" y="1544379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grpSp>
        <p:nvGrpSpPr>
          <p:cNvPr id="14" name="Grupo 13">
            <a:extLst>
              <a:ext uri="{FF2B5EF4-FFF2-40B4-BE49-F238E27FC236}">
                <a16:creationId xmlns:a16="http://schemas.microsoft.com/office/drawing/2014/main" id="{71CAECCB-2D6B-0A4C-AA36-753A87C5F93F}"/>
              </a:ext>
            </a:extLst>
          </p:cNvPr>
          <p:cNvGrpSpPr/>
          <p:nvPr/>
        </p:nvGrpSpPr>
        <p:grpSpPr>
          <a:xfrm>
            <a:off x="7200280" y="2615803"/>
            <a:ext cx="875561" cy="553938"/>
            <a:chOff x="11794737" y="1712716"/>
            <a:chExt cx="875561" cy="553938"/>
          </a:xfrm>
        </p:grpSpPr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78710B66-F74C-A44B-A714-66756FA1D7CD}"/>
                </a:ext>
              </a:extLst>
            </p:cNvPr>
            <p:cNvSpPr txBox="1"/>
            <p:nvPr/>
          </p:nvSpPr>
          <p:spPr>
            <a:xfrm>
              <a:off x="11794737" y="1897322"/>
              <a:ext cx="8755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∼ IL-1β</a:t>
              </a:r>
            </a:p>
          </p:txBody>
        </p:sp>
        <p:sp>
          <p:nvSpPr>
            <p:cNvPr id="16" name="Elipse 15">
              <a:extLst>
                <a:ext uri="{FF2B5EF4-FFF2-40B4-BE49-F238E27FC236}">
                  <a16:creationId xmlns:a16="http://schemas.microsoft.com/office/drawing/2014/main" id="{82B56B1D-4FD3-FD43-9525-46E2BC594D56}"/>
                </a:ext>
              </a:extLst>
            </p:cNvPr>
            <p:cNvSpPr>
              <a:spLocks/>
            </p:cNvSpPr>
            <p:nvPr/>
          </p:nvSpPr>
          <p:spPr>
            <a:xfrm>
              <a:off x="12232667" y="1712716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pic>
        <p:nvPicPr>
          <p:cNvPr id="17" name="Imagen 16">
            <a:extLst>
              <a:ext uri="{FF2B5EF4-FFF2-40B4-BE49-F238E27FC236}">
                <a16:creationId xmlns:a16="http://schemas.microsoft.com/office/drawing/2014/main" id="{D7E5D59A-B876-7F44-B874-3B346AA6C0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43014" y="1402162"/>
            <a:ext cx="720000" cy="683301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64B14B71-75E2-C540-89A3-A9C25DC2D3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97474" y="2691048"/>
            <a:ext cx="724450" cy="625737"/>
          </a:xfrm>
          <a:prstGeom prst="rect">
            <a:avLst/>
          </a:prstGeom>
        </p:spPr>
      </p:pic>
      <p:sp>
        <p:nvSpPr>
          <p:cNvPr id="19" name="Forma libre 18">
            <a:extLst>
              <a:ext uri="{FF2B5EF4-FFF2-40B4-BE49-F238E27FC236}">
                <a16:creationId xmlns:a16="http://schemas.microsoft.com/office/drawing/2014/main" id="{03EEE0D0-441A-FA4C-83BE-02C7602AEDD6}"/>
              </a:ext>
            </a:extLst>
          </p:cNvPr>
          <p:cNvSpPr/>
          <p:nvPr/>
        </p:nvSpPr>
        <p:spPr>
          <a:xfrm rot="16200000">
            <a:off x="9277863" y="2316124"/>
            <a:ext cx="625712" cy="201807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0" name="Grupo 19">
            <a:extLst>
              <a:ext uri="{FF2B5EF4-FFF2-40B4-BE49-F238E27FC236}">
                <a16:creationId xmlns:a16="http://schemas.microsoft.com/office/drawing/2014/main" id="{0DA8219C-0750-B84C-A783-72370AEAEDF2}"/>
              </a:ext>
            </a:extLst>
          </p:cNvPr>
          <p:cNvGrpSpPr/>
          <p:nvPr/>
        </p:nvGrpSpPr>
        <p:grpSpPr>
          <a:xfrm>
            <a:off x="9040260" y="1635340"/>
            <a:ext cx="817853" cy="507668"/>
            <a:chOff x="9775668" y="2748849"/>
            <a:chExt cx="817853" cy="507668"/>
          </a:xfrm>
        </p:grpSpPr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56D84181-6F5B-3C4A-9E68-1DAC904A2EEF}"/>
                </a:ext>
              </a:extLst>
            </p:cNvPr>
            <p:cNvSpPr txBox="1"/>
            <p:nvPr/>
          </p:nvSpPr>
          <p:spPr>
            <a:xfrm>
              <a:off x="9775668" y="2887185"/>
              <a:ext cx="8178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IL-12</a:t>
              </a:r>
            </a:p>
          </p:txBody>
        </p:sp>
        <p:sp>
          <p:nvSpPr>
            <p:cNvPr id="22" name="Elipse 21">
              <a:extLst>
                <a:ext uri="{FF2B5EF4-FFF2-40B4-BE49-F238E27FC236}">
                  <a16:creationId xmlns:a16="http://schemas.microsoft.com/office/drawing/2014/main" id="{183EF0BD-2DA1-ED48-93DB-463C77EC3BDD}"/>
                </a:ext>
              </a:extLst>
            </p:cNvPr>
            <p:cNvSpPr>
              <a:spLocks/>
            </p:cNvSpPr>
            <p:nvPr/>
          </p:nvSpPr>
          <p:spPr>
            <a:xfrm>
              <a:off x="10100319" y="2748849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cxnSp>
        <p:nvCxnSpPr>
          <p:cNvPr id="23" name="Conector recto 22">
            <a:extLst>
              <a:ext uri="{FF2B5EF4-FFF2-40B4-BE49-F238E27FC236}">
                <a16:creationId xmlns:a16="http://schemas.microsoft.com/office/drawing/2014/main" id="{C1F532D4-6FE9-0345-A4C2-5B4847C19BA6}"/>
              </a:ext>
            </a:extLst>
          </p:cNvPr>
          <p:cNvCxnSpPr>
            <a:cxnSpLocks/>
          </p:cNvCxnSpPr>
          <p:nvPr/>
        </p:nvCxnSpPr>
        <p:spPr>
          <a:xfrm flipH="1">
            <a:off x="8670504" y="1950383"/>
            <a:ext cx="432000" cy="0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Forma libre 23">
            <a:extLst>
              <a:ext uri="{FF2B5EF4-FFF2-40B4-BE49-F238E27FC236}">
                <a16:creationId xmlns:a16="http://schemas.microsoft.com/office/drawing/2014/main" id="{34EC6A8E-6200-C548-84EE-9DEC8264A476}"/>
              </a:ext>
            </a:extLst>
          </p:cNvPr>
          <p:cNvSpPr/>
          <p:nvPr/>
        </p:nvSpPr>
        <p:spPr>
          <a:xfrm rot="6055167">
            <a:off x="8256218" y="2408931"/>
            <a:ext cx="536801" cy="201807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090C8005-AB67-394A-A701-6584BCCF2F21}"/>
              </a:ext>
            </a:extLst>
          </p:cNvPr>
          <p:cNvSpPr txBox="1"/>
          <p:nvPr/>
        </p:nvSpPr>
        <p:spPr>
          <a:xfrm>
            <a:off x="8147533" y="2707510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￪ INF-𝛾</a:t>
            </a:r>
          </a:p>
        </p:txBody>
      </p:sp>
      <p:sp>
        <p:nvSpPr>
          <p:cNvPr id="26" name="Elipse 25">
            <a:extLst>
              <a:ext uri="{FF2B5EF4-FFF2-40B4-BE49-F238E27FC236}">
                <a16:creationId xmlns:a16="http://schemas.microsoft.com/office/drawing/2014/main" id="{192FC136-1C09-644D-AACD-8523BACFEFF1}"/>
              </a:ext>
            </a:extLst>
          </p:cNvPr>
          <p:cNvSpPr>
            <a:spLocks/>
          </p:cNvSpPr>
          <p:nvPr/>
        </p:nvSpPr>
        <p:spPr>
          <a:xfrm>
            <a:off x="8490505" y="3036961"/>
            <a:ext cx="180000" cy="180000"/>
          </a:xfrm>
          <a:prstGeom prst="ellipse">
            <a:avLst/>
          </a:prstGeom>
          <a:solidFill>
            <a:srgbClr val="FF7E79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9AD9AC71-C566-0448-B28C-F652D920DDDF}"/>
              </a:ext>
            </a:extLst>
          </p:cNvPr>
          <p:cNvCxnSpPr>
            <a:cxnSpLocks/>
          </p:cNvCxnSpPr>
          <p:nvPr/>
        </p:nvCxnSpPr>
        <p:spPr>
          <a:xfrm>
            <a:off x="8748983" y="3099293"/>
            <a:ext cx="432000" cy="0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7" name="Grupo 176">
            <a:extLst>
              <a:ext uri="{FF2B5EF4-FFF2-40B4-BE49-F238E27FC236}">
                <a16:creationId xmlns:a16="http://schemas.microsoft.com/office/drawing/2014/main" id="{C3F09058-DB4E-2740-A614-5CD9F2647765}"/>
              </a:ext>
            </a:extLst>
          </p:cNvPr>
          <p:cNvGrpSpPr/>
          <p:nvPr/>
        </p:nvGrpSpPr>
        <p:grpSpPr>
          <a:xfrm>
            <a:off x="7048047" y="1932958"/>
            <a:ext cx="877163" cy="489153"/>
            <a:chOff x="8464395" y="2043822"/>
            <a:chExt cx="877163" cy="489153"/>
          </a:xfrm>
        </p:grpSpPr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2C2C7808-536A-794C-B10F-4BE82EA1CD76}"/>
                </a:ext>
              </a:extLst>
            </p:cNvPr>
            <p:cNvSpPr txBox="1"/>
            <p:nvPr/>
          </p:nvSpPr>
          <p:spPr>
            <a:xfrm>
              <a:off x="8464395" y="2163643"/>
              <a:ext cx="877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INF-⍺</a:t>
              </a:r>
            </a:p>
          </p:txBody>
        </p:sp>
        <p:sp>
          <p:nvSpPr>
            <p:cNvPr id="29" name="Elipse 28">
              <a:extLst>
                <a:ext uri="{FF2B5EF4-FFF2-40B4-BE49-F238E27FC236}">
                  <a16:creationId xmlns:a16="http://schemas.microsoft.com/office/drawing/2014/main" id="{D13C4380-514A-7247-95AC-4E8AB4AE421F}"/>
                </a:ext>
              </a:extLst>
            </p:cNvPr>
            <p:cNvSpPr>
              <a:spLocks/>
            </p:cNvSpPr>
            <p:nvPr/>
          </p:nvSpPr>
          <p:spPr>
            <a:xfrm>
              <a:off x="8813091" y="2043822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cxnSp>
        <p:nvCxnSpPr>
          <p:cNvPr id="30" name="Conector recto 29">
            <a:extLst>
              <a:ext uri="{FF2B5EF4-FFF2-40B4-BE49-F238E27FC236}">
                <a16:creationId xmlns:a16="http://schemas.microsoft.com/office/drawing/2014/main" id="{ECC88F43-0320-E243-A46B-4F11450DE329}"/>
              </a:ext>
            </a:extLst>
          </p:cNvPr>
          <p:cNvCxnSpPr>
            <a:cxnSpLocks/>
          </p:cNvCxnSpPr>
          <p:nvPr/>
        </p:nvCxnSpPr>
        <p:spPr>
          <a:xfrm flipV="1">
            <a:off x="7687527" y="1895401"/>
            <a:ext cx="306258" cy="240403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Forma libre 30">
            <a:extLst>
              <a:ext uri="{FF2B5EF4-FFF2-40B4-BE49-F238E27FC236}">
                <a16:creationId xmlns:a16="http://schemas.microsoft.com/office/drawing/2014/main" id="{CA9D6E81-8658-6A48-9679-4775C4EFF928}"/>
              </a:ext>
            </a:extLst>
          </p:cNvPr>
          <p:cNvSpPr/>
          <p:nvPr/>
        </p:nvSpPr>
        <p:spPr>
          <a:xfrm rot="19784720">
            <a:off x="9743735" y="2371066"/>
            <a:ext cx="625712" cy="201807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768B08E3-9F1E-E947-849A-E6974100731B}"/>
              </a:ext>
            </a:extLst>
          </p:cNvPr>
          <p:cNvSpPr txBox="1"/>
          <p:nvPr/>
        </p:nvSpPr>
        <p:spPr>
          <a:xfrm>
            <a:off x="9901998" y="1876247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￪ IL-6</a:t>
            </a:r>
          </a:p>
        </p:txBody>
      </p:sp>
      <p:sp>
        <p:nvSpPr>
          <p:cNvPr id="33" name="Elipse 32">
            <a:extLst>
              <a:ext uri="{FF2B5EF4-FFF2-40B4-BE49-F238E27FC236}">
                <a16:creationId xmlns:a16="http://schemas.microsoft.com/office/drawing/2014/main" id="{941A1482-02D3-DE4C-AA22-10EFFEE2F0C7}"/>
              </a:ext>
            </a:extLst>
          </p:cNvPr>
          <p:cNvSpPr>
            <a:spLocks/>
          </p:cNvSpPr>
          <p:nvPr/>
        </p:nvSpPr>
        <p:spPr>
          <a:xfrm>
            <a:off x="10226649" y="1737911"/>
            <a:ext cx="180000" cy="180000"/>
          </a:xfrm>
          <a:prstGeom prst="ellipse">
            <a:avLst/>
          </a:prstGeom>
          <a:solidFill>
            <a:srgbClr val="FF7E79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pic>
        <p:nvPicPr>
          <p:cNvPr id="34" name="Imagen 33">
            <a:extLst>
              <a:ext uri="{FF2B5EF4-FFF2-40B4-BE49-F238E27FC236}">
                <a16:creationId xmlns:a16="http://schemas.microsoft.com/office/drawing/2014/main" id="{A7C0CB5D-74AA-AE44-9E5C-8911C0A8FC3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146915" y="2939238"/>
            <a:ext cx="720000" cy="720000"/>
          </a:xfrm>
          <a:prstGeom prst="rect">
            <a:avLst/>
          </a:prstGeom>
        </p:spPr>
      </p:pic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578CC9A2-8389-3147-AFDC-630D2834704E}"/>
              </a:ext>
            </a:extLst>
          </p:cNvPr>
          <p:cNvCxnSpPr>
            <a:cxnSpLocks/>
          </p:cNvCxnSpPr>
          <p:nvPr/>
        </p:nvCxnSpPr>
        <p:spPr>
          <a:xfrm>
            <a:off x="10418036" y="2285928"/>
            <a:ext cx="75160" cy="542071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Imagen 39">
            <a:extLst>
              <a:ext uri="{FF2B5EF4-FFF2-40B4-BE49-F238E27FC236}">
                <a16:creationId xmlns:a16="http://schemas.microsoft.com/office/drawing/2014/main" id="{E832C422-3A7A-2344-B09F-CAF7A4A22EF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097897" y="1556381"/>
            <a:ext cx="526985" cy="501403"/>
          </a:xfrm>
          <a:prstGeom prst="rect">
            <a:avLst/>
          </a:prstGeom>
        </p:spPr>
      </p:pic>
      <p:cxnSp>
        <p:nvCxnSpPr>
          <p:cNvPr id="41" name="Conector recto 40">
            <a:extLst>
              <a:ext uri="{FF2B5EF4-FFF2-40B4-BE49-F238E27FC236}">
                <a16:creationId xmlns:a16="http://schemas.microsoft.com/office/drawing/2014/main" id="{533396D2-CDC9-4B46-BF1A-1D969E78DB85}"/>
              </a:ext>
            </a:extLst>
          </p:cNvPr>
          <p:cNvCxnSpPr>
            <a:cxnSpLocks/>
          </p:cNvCxnSpPr>
          <p:nvPr/>
        </p:nvCxnSpPr>
        <p:spPr>
          <a:xfrm>
            <a:off x="10500484" y="1896231"/>
            <a:ext cx="570402" cy="0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Imagen 41">
            <a:extLst>
              <a:ext uri="{FF2B5EF4-FFF2-40B4-BE49-F238E27FC236}">
                <a16:creationId xmlns:a16="http://schemas.microsoft.com/office/drawing/2014/main" id="{E03D606F-4EA2-254A-BF60-1174811C181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420767" y="2049414"/>
            <a:ext cx="360000" cy="342525"/>
          </a:xfrm>
          <a:prstGeom prst="rect">
            <a:avLst/>
          </a:prstGeom>
        </p:spPr>
      </p:pic>
      <p:pic>
        <p:nvPicPr>
          <p:cNvPr id="43" name="Imagen 42">
            <a:extLst>
              <a:ext uri="{FF2B5EF4-FFF2-40B4-BE49-F238E27FC236}">
                <a16:creationId xmlns:a16="http://schemas.microsoft.com/office/drawing/2014/main" id="{75A27B5B-9327-E041-9E48-194E5112614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966800" y="2057593"/>
            <a:ext cx="360000" cy="342525"/>
          </a:xfrm>
          <a:prstGeom prst="rect">
            <a:avLst/>
          </a:prstGeom>
        </p:spPr>
      </p:pic>
      <p:sp>
        <p:nvSpPr>
          <p:cNvPr id="44" name="CuadroTexto 43">
            <a:extLst>
              <a:ext uri="{FF2B5EF4-FFF2-40B4-BE49-F238E27FC236}">
                <a16:creationId xmlns:a16="http://schemas.microsoft.com/office/drawing/2014/main" id="{ABBEBDB7-F72C-514D-99AE-306849F23ADF}"/>
              </a:ext>
            </a:extLst>
          </p:cNvPr>
          <p:cNvSpPr txBox="1"/>
          <p:nvPr/>
        </p:nvSpPr>
        <p:spPr>
          <a:xfrm>
            <a:off x="8384758" y="4136106"/>
            <a:ext cx="6479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solidFill>
                  <a:srgbClr val="0070C0"/>
                </a:solidFill>
              </a:rPr>
              <a:t>L</a:t>
            </a:r>
            <a:r>
              <a:rPr lang="es-ES" sz="1800" b="1" dirty="0">
                <a:solidFill>
                  <a:srgbClr val="0070C0"/>
                </a:solidFill>
              </a:rPr>
              <a:t>Th1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BDC83339-4425-ED4C-9E70-B83CF784A131}"/>
              </a:ext>
            </a:extLst>
          </p:cNvPr>
          <p:cNvSpPr txBox="1"/>
          <p:nvPr/>
        </p:nvSpPr>
        <p:spPr>
          <a:xfrm>
            <a:off x="11669951" y="1042160"/>
            <a:ext cx="6992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 err="1">
                <a:solidFill>
                  <a:srgbClr val="0070C0"/>
                </a:solidFill>
              </a:rPr>
              <a:t>L</a:t>
            </a:r>
            <a:r>
              <a:rPr lang="es-ES" sz="1800" b="1" dirty="0" err="1">
                <a:solidFill>
                  <a:srgbClr val="0070C0"/>
                </a:solidFill>
              </a:rPr>
              <a:t>Treg</a:t>
            </a:r>
            <a:endParaRPr lang="es-ES" sz="1800" b="1" dirty="0">
              <a:solidFill>
                <a:srgbClr val="0070C0"/>
              </a:solidFill>
            </a:endParaRPr>
          </a:p>
        </p:txBody>
      </p:sp>
      <p:grpSp>
        <p:nvGrpSpPr>
          <p:cNvPr id="47" name="Grupo 46">
            <a:extLst>
              <a:ext uri="{FF2B5EF4-FFF2-40B4-BE49-F238E27FC236}">
                <a16:creationId xmlns:a16="http://schemas.microsoft.com/office/drawing/2014/main" id="{C1E2EC96-58C8-3646-A331-89BADA506C40}"/>
              </a:ext>
            </a:extLst>
          </p:cNvPr>
          <p:cNvGrpSpPr/>
          <p:nvPr/>
        </p:nvGrpSpPr>
        <p:grpSpPr>
          <a:xfrm rot="2678166">
            <a:off x="11491845" y="1321798"/>
            <a:ext cx="197703" cy="318192"/>
            <a:chOff x="12324113" y="1992529"/>
            <a:chExt cx="222395" cy="466053"/>
          </a:xfrm>
        </p:grpSpPr>
        <p:cxnSp>
          <p:nvCxnSpPr>
            <p:cNvPr id="48" name="Conector recto 47">
              <a:extLst>
                <a:ext uri="{FF2B5EF4-FFF2-40B4-BE49-F238E27FC236}">
                  <a16:creationId xmlns:a16="http://schemas.microsoft.com/office/drawing/2014/main" id="{D7165CA9-ACDD-3A44-BD63-2CFF1C0C93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35310" y="1992983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recto 48">
              <a:extLst>
                <a:ext uri="{FF2B5EF4-FFF2-40B4-BE49-F238E27FC236}">
                  <a16:creationId xmlns:a16="http://schemas.microsoft.com/office/drawing/2014/main" id="{9F995D31-9AE7-904B-8871-3CBE837804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24113" y="1992529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Forma libre 49">
            <a:extLst>
              <a:ext uri="{FF2B5EF4-FFF2-40B4-BE49-F238E27FC236}">
                <a16:creationId xmlns:a16="http://schemas.microsoft.com/office/drawing/2014/main" id="{86A0BA19-0FC8-6348-85B0-DD77FC7869CA}"/>
              </a:ext>
            </a:extLst>
          </p:cNvPr>
          <p:cNvSpPr/>
          <p:nvPr/>
        </p:nvSpPr>
        <p:spPr>
          <a:xfrm rot="5400000" flipV="1">
            <a:off x="9140100" y="3358250"/>
            <a:ext cx="444113" cy="183926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51" name="Grupo 50">
            <a:extLst>
              <a:ext uri="{FF2B5EF4-FFF2-40B4-BE49-F238E27FC236}">
                <a16:creationId xmlns:a16="http://schemas.microsoft.com/office/drawing/2014/main" id="{0371871C-3704-5546-81B1-197E4C4DFFA0}"/>
              </a:ext>
            </a:extLst>
          </p:cNvPr>
          <p:cNvGrpSpPr/>
          <p:nvPr/>
        </p:nvGrpSpPr>
        <p:grpSpPr>
          <a:xfrm>
            <a:off x="8766338" y="3578064"/>
            <a:ext cx="700833" cy="538206"/>
            <a:chOff x="9775668" y="2887185"/>
            <a:chExt cx="700833" cy="538206"/>
          </a:xfrm>
        </p:grpSpPr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D63071A4-0C07-4D42-A22F-D7DE69DD16AA}"/>
                </a:ext>
              </a:extLst>
            </p:cNvPr>
            <p:cNvSpPr txBox="1"/>
            <p:nvPr/>
          </p:nvSpPr>
          <p:spPr>
            <a:xfrm>
              <a:off x="9775668" y="2887185"/>
              <a:ext cx="7008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IL-8</a:t>
              </a:r>
            </a:p>
          </p:txBody>
        </p:sp>
        <p:sp>
          <p:nvSpPr>
            <p:cNvPr id="53" name="Elipse 52">
              <a:extLst>
                <a:ext uri="{FF2B5EF4-FFF2-40B4-BE49-F238E27FC236}">
                  <a16:creationId xmlns:a16="http://schemas.microsoft.com/office/drawing/2014/main" id="{49B79C4D-C015-CD44-9B57-199C88FD77B5}"/>
                </a:ext>
              </a:extLst>
            </p:cNvPr>
            <p:cNvSpPr>
              <a:spLocks/>
            </p:cNvSpPr>
            <p:nvPr/>
          </p:nvSpPr>
          <p:spPr>
            <a:xfrm>
              <a:off x="10079180" y="3245391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cxnSp>
        <p:nvCxnSpPr>
          <p:cNvPr id="54" name="Conector recto 53">
            <a:extLst>
              <a:ext uri="{FF2B5EF4-FFF2-40B4-BE49-F238E27FC236}">
                <a16:creationId xmlns:a16="http://schemas.microsoft.com/office/drawing/2014/main" id="{DEAFA2A6-9D43-6646-B810-85F83A1CA850}"/>
              </a:ext>
            </a:extLst>
          </p:cNvPr>
          <p:cNvCxnSpPr>
            <a:cxnSpLocks/>
          </p:cNvCxnSpPr>
          <p:nvPr/>
        </p:nvCxnSpPr>
        <p:spPr>
          <a:xfrm flipV="1">
            <a:off x="9482921" y="2859727"/>
            <a:ext cx="2672480" cy="1140212"/>
          </a:xfrm>
          <a:prstGeom prst="line">
            <a:avLst/>
          </a:prstGeom>
          <a:ln w="28575">
            <a:solidFill>
              <a:srgbClr val="C00000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5" name="Grupo 54">
            <a:extLst>
              <a:ext uri="{FF2B5EF4-FFF2-40B4-BE49-F238E27FC236}">
                <a16:creationId xmlns:a16="http://schemas.microsoft.com/office/drawing/2014/main" id="{52F577FF-A96E-1F4F-A86F-980B04752738}"/>
              </a:ext>
            </a:extLst>
          </p:cNvPr>
          <p:cNvGrpSpPr/>
          <p:nvPr/>
        </p:nvGrpSpPr>
        <p:grpSpPr>
          <a:xfrm>
            <a:off x="12234293" y="2635936"/>
            <a:ext cx="286446" cy="483603"/>
            <a:chOff x="12992003" y="4485422"/>
            <a:chExt cx="286446" cy="483603"/>
          </a:xfrm>
        </p:grpSpPr>
        <p:sp>
          <p:nvSpPr>
            <p:cNvPr id="56" name="Elipse 55">
              <a:extLst>
                <a:ext uri="{FF2B5EF4-FFF2-40B4-BE49-F238E27FC236}">
                  <a16:creationId xmlns:a16="http://schemas.microsoft.com/office/drawing/2014/main" id="{7DC13AFC-AD80-E941-9133-BB97832B85B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2992003" y="4485422"/>
              <a:ext cx="252000" cy="252000"/>
            </a:xfrm>
            <a:prstGeom prst="ellipse">
              <a:avLst/>
            </a:prstGeom>
            <a:gradFill flip="none" rotWithShape="1">
              <a:gsLst>
                <a:gs pos="3000">
                  <a:srgbClr val="FFFC00">
                    <a:shade val="30000"/>
                    <a:satMod val="115000"/>
                  </a:srgbClr>
                </a:gs>
                <a:gs pos="40000">
                  <a:srgbClr val="FFFC00">
                    <a:shade val="67500"/>
                    <a:satMod val="115000"/>
                  </a:srgbClr>
                </a:gs>
                <a:gs pos="34000">
                  <a:srgbClr val="FFFC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7" name="Elipse 56">
              <a:extLst>
                <a:ext uri="{FF2B5EF4-FFF2-40B4-BE49-F238E27FC236}">
                  <a16:creationId xmlns:a16="http://schemas.microsoft.com/office/drawing/2014/main" id="{27D52AB8-3325-A848-880A-9E1D9C30BBA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3026449" y="4717025"/>
              <a:ext cx="252000" cy="252000"/>
            </a:xfrm>
            <a:prstGeom prst="ellipse">
              <a:avLst/>
            </a:prstGeom>
            <a:gradFill flip="none" rotWithShape="1">
              <a:gsLst>
                <a:gs pos="3000">
                  <a:srgbClr val="FFFC00">
                    <a:shade val="30000"/>
                    <a:satMod val="115000"/>
                  </a:srgbClr>
                </a:gs>
                <a:gs pos="40000">
                  <a:srgbClr val="FFFC00">
                    <a:shade val="67500"/>
                    <a:satMod val="115000"/>
                  </a:srgbClr>
                </a:gs>
                <a:gs pos="34000">
                  <a:srgbClr val="FFFC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pic>
        <p:nvPicPr>
          <p:cNvPr id="58" name="Imagen 57">
            <a:extLst>
              <a:ext uri="{FF2B5EF4-FFF2-40B4-BE49-F238E27FC236}">
                <a16:creationId xmlns:a16="http://schemas.microsoft.com/office/drawing/2014/main" id="{1E068853-C21B-4E41-AA6F-922E1A33B25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669951" y="2441954"/>
            <a:ext cx="360000" cy="360000"/>
          </a:xfrm>
          <a:prstGeom prst="rect">
            <a:avLst/>
          </a:prstGeom>
        </p:spPr>
      </p:pic>
      <p:pic>
        <p:nvPicPr>
          <p:cNvPr id="59" name="Imagen 58">
            <a:extLst>
              <a:ext uri="{FF2B5EF4-FFF2-40B4-BE49-F238E27FC236}">
                <a16:creationId xmlns:a16="http://schemas.microsoft.com/office/drawing/2014/main" id="{F1411CBB-24E2-F748-B7BF-8D80957BD4E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496543" y="2891848"/>
            <a:ext cx="360000" cy="360000"/>
          </a:xfrm>
          <a:prstGeom prst="rect">
            <a:avLst/>
          </a:prstGeom>
        </p:spPr>
      </p:pic>
      <p:pic>
        <p:nvPicPr>
          <p:cNvPr id="60" name="Imagen 59">
            <a:extLst>
              <a:ext uri="{FF2B5EF4-FFF2-40B4-BE49-F238E27FC236}">
                <a16:creationId xmlns:a16="http://schemas.microsoft.com/office/drawing/2014/main" id="{28733878-BAE4-C346-8841-10B45573931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817155" y="2679727"/>
            <a:ext cx="360000" cy="360000"/>
          </a:xfrm>
          <a:prstGeom prst="rect">
            <a:avLst/>
          </a:prstGeom>
        </p:spPr>
      </p:pic>
      <p:pic>
        <p:nvPicPr>
          <p:cNvPr id="61" name="Imagen 60">
            <a:extLst>
              <a:ext uri="{FF2B5EF4-FFF2-40B4-BE49-F238E27FC236}">
                <a16:creationId xmlns:a16="http://schemas.microsoft.com/office/drawing/2014/main" id="{A75AD306-0059-5945-8925-F15C58CADE7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997155" y="3161868"/>
            <a:ext cx="360000" cy="360000"/>
          </a:xfrm>
          <a:prstGeom prst="rect">
            <a:avLst/>
          </a:prstGeom>
        </p:spPr>
      </p:pic>
      <p:sp>
        <p:nvSpPr>
          <p:cNvPr id="62" name="Elipse 61">
            <a:extLst>
              <a:ext uri="{FF2B5EF4-FFF2-40B4-BE49-F238E27FC236}">
                <a16:creationId xmlns:a16="http://schemas.microsoft.com/office/drawing/2014/main" id="{A0E5A6D4-2EBF-1A44-96FF-10CC1E38614C}"/>
              </a:ext>
            </a:extLst>
          </p:cNvPr>
          <p:cNvSpPr>
            <a:spLocks noChangeAspect="1"/>
          </p:cNvSpPr>
          <p:nvPr/>
        </p:nvSpPr>
        <p:spPr>
          <a:xfrm>
            <a:off x="12233072" y="3522223"/>
            <a:ext cx="252000" cy="252000"/>
          </a:xfrm>
          <a:prstGeom prst="ellipse">
            <a:avLst/>
          </a:prstGeom>
          <a:gradFill flip="none" rotWithShape="1">
            <a:gsLst>
              <a:gs pos="3000">
                <a:srgbClr val="FFFC00">
                  <a:shade val="30000"/>
                  <a:satMod val="115000"/>
                </a:srgbClr>
              </a:gs>
              <a:gs pos="40000">
                <a:srgbClr val="FFFC00">
                  <a:shade val="67500"/>
                  <a:satMod val="115000"/>
                </a:srgbClr>
              </a:gs>
              <a:gs pos="34000">
                <a:srgbClr val="FFFC00">
                  <a:shade val="100000"/>
                  <a:satMod val="115000"/>
                </a:srgbClr>
              </a:gs>
            </a:gsLst>
            <a:path path="circle">
              <a:fillToRect l="50000" t="50000" r="50000" b="50000"/>
            </a:path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3" name="Elipse 62">
            <a:extLst>
              <a:ext uri="{FF2B5EF4-FFF2-40B4-BE49-F238E27FC236}">
                <a16:creationId xmlns:a16="http://schemas.microsoft.com/office/drawing/2014/main" id="{A28DC6BF-8740-F947-B513-1723A62A3FB8}"/>
              </a:ext>
            </a:extLst>
          </p:cNvPr>
          <p:cNvSpPr>
            <a:spLocks noChangeAspect="1"/>
          </p:cNvSpPr>
          <p:nvPr/>
        </p:nvSpPr>
        <p:spPr>
          <a:xfrm>
            <a:off x="12245216" y="3887638"/>
            <a:ext cx="252000" cy="252000"/>
          </a:xfrm>
          <a:prstGeom prst="ellipse">
            <a:avLst/>
          </a:prstGeom>
          <a:gradFill flip="none" rotWithShape="1">
            <a:gsLst>
              <a:gs pos="3000">
                <a:srgbClr val="FFFC00">
                  <a:shade val="30000"/>
                  <a:satMod val="115000"/>
                </a:srgbClr>
              </a:gs>
              <a:gs pos="40000">
                <a:srgbClr val="FFFC00">
                  <a:shade val="67500"/>
                  <a:satMod val="115000"/>
                </a:srgbClr>
              </a:gs>
              <a:gs pos="34000">
                <a:srgbClr val="FFFC00">
                  <a:shade val="100000"/>
                  <a:satMod val="115000"/>
                </a:srgbClr>
              </a:gs>
            </a:gsLst>
            <a:path path="circle">
              <a:fillToRect l="50000" t="50000" r="50000" b="50000"/>
            </a:path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4" name="Forma libre 63">
            <a:extLst>
              <a:ext uri="{FF2B5EF4-FFF2-40B4-BE49-F238E27FC236}">
                <a16:creationId xmlns:a16="http://schemas.microsoft.com/office/drawing/2014/main" id="{AA0AC894-111F-204D-81FF-39B8241EB5A5}"/>
              </a:ext>
            </a:extLst>
          </p:cNvPr>
          <p:cNvSpPr/>
          <p:nvPr/>
        </p:nvSpPr>
        <p:spPr>
          <a:xfrm>
            <a:off x="9679831" y="3257770"/>
            <a:ext cx="2430966" cy="783286"/>
          </a:xfrm>
          <a:custGeom>
            <a:avLst/>
            <a:gdLst>
              <a:gd name="connsiteX0" fmla="*/ 0 w 2430966"/>
              <a:gd name="connsiteY0" fmla="*/ 0 h 761895"/>
              <a:gd name="connsiteX1" fmla="*/ 367990 w 2430966"/>
              <a:gd name="connsiteY1" fmla="*/ 680224 h 761895"/>
              <a:gd name="connsiteX2" fmla="*/ 1862254 w 2430966"/>
              <a:gd name="connsiteY2" fmla="*/ 747132 h 761895"/>
              <a:gd name="connsiteX3" fmla="*/ 2430966 w 2430966"/>
              <a:gd name="connsiteY3" fmla="*/ 657922 h 761895"/>
              <a:gd name="connsiteX0" fmla="*/ 0 w 2430966"/>
              <a:gd name="connsiteY0" fmla="*/ 0 h 768914"/>
              <a:gd name="connsiteX1" fmla="*/ 367990 w 2430966"/>
              <a:gd name="connsiteY1" fmla="*/ 680224 h 768914"/>
              <a:gd name="connsiteX2" fmla="*/ 1605776 w 2430966"/>
              <a:gd name="connsiteY2" fmla="*/ 758284 h 768914"/>
              <a:gd name="connsiteX3" fmla="*/ 2430966 w 2430966"/>
              <a:gd name="connsiteY3" fmla="*/ 657922 h 768914"/>
              <a:gd name="connsiteX0" fmla="*/ 0 w 2430966"/>
              <a:gd name="connsiteY0" fmla="*/ 0 h 768914"/>
              <a:gd name="connsiteX1" fmla="*/ 367990 w 2430966"/>
              <a:gd name="connsiteY1" fmla="*/ 680224 h 768914"/>
              <a:gd name="connsiteX2" fmla="*/ 1605776 w 2430966"/>
              <a:gd name="connsiteY2" fmla="*/ 758284 h 768914"/>
              <a:gd name="connsiteX3" fmla="*/ 2430966 w 2430966"/>
              <a:gd name="connsiteY3" fmla="*/ 657922 h 768914"/>
              <a:gd name="connsiteX0" fmla="*/ 0 w 2430966"/>
              <a:gd name="connsiteY0" fmla="*/ 0 h 783286"/>
              <a:gd name="connsiteX1" fmla="*/ 367990 w 2430966"/>
              <a:gd name="connsiteY1" fmla="*/ 680224 h 783286"/>
              <a:gd name="connsiteX2" fmla="*/ 1605776 w 2430966"/>
              <a:gd name="connsiteY2" fmla="*/ 758284 h 783286"/>
              <a:gd name="connsiteX3" fmla="*/ 2430966 w 2430966"/>
              <a:gd name="connsiteY3" fmla="*/ 657922 h 7832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30966" h="783286">
                <a:moveTo>
                  <a:pt x="0" y="0"/>
                </a:moveTo>
                <a:cubicBezTo>
                  <a:pt x="28807" y="277851"/>
                  <a:pt x="100361" y="553843"/>
                  <a:pt x="367990" y="680224"/>
                </a:cubicBezTo>
                <a:cubicBezTo>
                  <a:pt x="635619" y="806605"/>
                  <a:pt x="1261947" y="795455"/>
                  <a:pt x="1605776" y="758284"/>
                </a:cubicBezTo>
                <a:cubicBezTo>
                  <a:pt x="1949605" y="721113"/>
                  <a:pt x="2106651" y="689517"/>
                  <a:pt x="2430966" y="657922"/>
                </a:cubicBezTo>
              </a:path>
            </a:pathLst>
          </a:custGeom>
          <a:noFill/>
          <a:ln w="28575">
            <a:solidFill>
              <a:srgbClr val="C00000"/>
            </a:solidFill>
            <a:prstDash val="sysDash"/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65" name="Imagen 64">
            <a:extLst>
              <a:ext uri="{FF2B5EF4-FFF2-40B4-BE49-F238E27FC236}">
                <a16:creationId xmlns:a16="http://schemas.microsoft.com/office/drawing/2014/main" id="{1EC3E916-DACC-EE45-952C-7F52F50FDB0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5400000">
            <a:off x="11455543" y="3260397"/>
            <a:ext cx="777456" cy="720000"/>
          </a:xfrm>
          <a:prstGeom prst="rect">
            <a:avLst/>
          </a:prstGeom>
        </p:spPr>
      </p:pic>
      <p:pic>
        <p:nvPicPr>
          <p:cNvPr id="66" name="Imagen 65">
            <a:extLst>
              <a:ext uri="{FF2B5EF4-FFF2-40B4-BE49-F238E27FC236}">
                <a16:creationId xmlns:a16="http://schemas.microsoft.com/office/drawing/2014/main" id="{EB92D6BE-8199-2846-97EB-9865AB85D75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669951" y="4077824"/>
            <a:ext cx="764011" cy="720000"/>
          </a:xfrm>
          <a:prstGeom prst="rect">
            <a:avLst/>
          </a:prstGeom>
        </p:spPr>
      </p:pic>
      <p:sp>
        <p:nvSpPr>
          <p:cNvPr id="67" name="CuadroTexto 66">
            <a:extLst>
              <a:ext uri="{FF2B5EF4-FFF2-40B4-BE49-F238E27FC236}">
                <a16:creationId xmlns:a16="http://schemas.microsoft.com/office/drawing/2014/main" id="{BF026BB3-C0E6-FF47-933C-F333888465C5}"/>
              </a:ext>
            </a:extLst>
          </p:cNvPr>
          <p:cNvSpPr txBox="1"/>
          <p:nvPr/>
        </p:nvSpPr>
        <p:spPr>
          <a:xfrm>
            <a:off x="10544626" y="4006042"/>
            <a:ext cx="13374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hagocytosis </a:t>
            </a:r>
            <a:endParaRPr lang="es-ES" sz="1600" b="1" dirty="0"/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F8658A8C-EDC0-3549-88F2-44E10C0D1B44}"/>
              </a:ext>
            </a:extLst>
          </p:cNvPr>
          <p:cNvSpPr txBox="1"/>
          <p:nvPr/>
        </p:nvSpPr>
        <p:spPr>
          <a:xfrm>
            <a:off x="10932660" y="2631242"/>
            <a:ext cx="10086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migration</a:t>
            </a:r>
            <a:endParaRPr lang="es-ES" sz="1600" b="1" dirty="0"/>
          </a:p>
        </p:txBody>
      </p:sp>
      <p:pic>
        <p:nvPicPr>
          <p:cNvPr id="136" name="Imagen 135">
            <a:extLst>
              <a:ext uri="{FF2B5EF4-FFF2-40B4-BE49-F238E27FC236}">
                <a16:creationId xmlns:a16="http://schemas.microsoft.com/office/drawing/2014/main" id="{4CC7C971-D0DD-DE48-A358-C840F02E6ED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856006" y="3273507"/>
            <a:ext cx="720000" cy="720000"/>
          </a:xfrm>
          <a:prstGeom prst="rect">
            <a:avLst/>
          </a:prstGeom>
        </p:spPr>
      </p:pic>
      <p:sp>
        <p:nvSpPr>
          <p:cNvPr id="137" name="Forma libre 136">
            <a:extLst>
              <a:ext uri="{FF2B5EF4-FFF2-40B4-BE49-F238E27FC236}">
                <a16:creationId xmlns:a16="http://schemas.microsoft.com/office/drawing/2014/main" id="{9D066011-1C1F-C149-9DE2-009D3B833483}"/>
              </a:ext>
            </a:extLst>
          </p:cNvPr>
          <p:cNvSpPr/>
          <p:nvPr/>
        </p:nvSpPr>
        <p:spPr>
          <a:xfrm rot="8289813">
            <a:off x="7854930" y="4201551"/>
            <a:ext cx="536801" cy="201807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422" name="Grupo 421">
            <a:extLst>
              <a:ext uri="{FF2B5EF4-FFF2-40B4-BE49-F238E27FC236}">
                <a16:creationId xmlns:a16="http://schemas.microsoft.com/office/drawing/2014/main" id="{3BA1F1F5-7B82-AC45-82E7-78A5E1D6C24F}"/>
              </a:ext>
            </a:extLst>
          </p:cNvPr>
          <p:cNvGrpSpPr/>
          <p:nvPr/>
        </p:nvGrpSpPr>
        <p:grpSpPr>
          <a:xfrm>
            <a:off x="7537936" y="4587115"/>
            <a:ext cx="817853" cy="509451"/>
            <a:chOff x="8159044" y="4657924"/>
            <a:chExt cx="817853" cy="509451"/>
          </a:xfrm>
        </p:grpSpPr>
        <p:sp>
          <p:nvSpPr>
            <p:cNvPr id="138" name="CuadroTexto 137">
              <a:extLst>
                <a:ext uri="{FF2B5EF4-FFF2-40B4-BE49-F238E27FC236}">
                  <a16:creationId xmlns:a16="http://schemas.microsoft.com/office/drawing/2014/main" id="{3613122D-A80B-F446-87FD-E509BDCC0106}"/>
                </a:ext>
              </a:extLst>
            </p:cNvPr>
            <p:cNvSpPr txBox="1"/>
            <p:nvPr/>
          </p:nvSpPr>
          <p:spPr>
            <a:xfrm>
              <a:off x="8159044" y="4657924"/>
              <a:ext cx="8178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rgbClr val="00B050"/>
                  </a:solidFill>
                </a:rPr>
                <a:t>￪ IL-10</a:t>
              </a:r>
            </a:p>
          </p:txBody>
        </p:sp>
        <p:sp>
          <p:nvSpPr>
            <p:cNvPr id="139" name="Elipse 138">
              <a:extLst>
                <a:ext uri="{FF2B5EF4-FFF2-40B4-BE49-F238E27FC236}">
                  <a16:creationId xmlns:a16="http://schemas.microsoft.com/office/drawing/2014/main" id="{477D1BF5-4BED-9346-BEFC-1765C1BFF7BA}"/>
                </a:ext>
              </a:extLst>
            </p:cNvPr>
            <p:cNvSpPr>
              <a:spLocks/>
            </p:cNvSpPr>
            <p:nvPr/>
          </p:nvSpPr>
          <p:spPr>
            <a:xfrm>
              <a:off x="8502016" y="4987375"/>
              <a:ext cx="180000" cy="180000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pic>
        <p:nvPicPr>
          <p:cNvPr id="140" name="Imagen 139">
            <a:extLst>
              <a:ext uri="{FF2B5EF4-FFF2-40B4-BE49-F238E27FC236}">
                <a16:creationId xmlns:a16="http://schemas.microsoft.com/office/drawing/2014/main" id="{5713452F-42E8-0D46-963A-A96208795B3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79290" y="4406531"/>
            <a:ext cx="526985" cy="501403"/>
          </a:xfrm>
          <a:prstGeom prst="rect">
            <a:avLst/>
          </a:prstGeom>
        </p:spPr>
      </p:pic>
      <p:cxnSp>
        <p:nvCxnSpPr>
          <p:cNvPr id="141" name="Conector recto 140">
            <a:extLst>
              <a:ext uri="{FF2B5EF4-FFF2-40B4-BE49-F238E27FC236}">
                <a16:creationId xmlns:a16="http://schemas.microsoft.com/office/drawing/2014/main" id="{738B2370-440A-1C42-B6FD-352A4BCC0138}"/>
              </a:ext>
            </a:extLst>
          </p:cNvPr>
          <p:cNvCxnSpPr>
            <a:cxnSpLocks/>
          </p:cNvCxnSpPr>
          <p:nvPr/>
        </p:nvCxnSpPr>
        <p:spPr>
          <a:xfrm flipH="1" flipV="1">
            <a:off x="6959455" y="4673231"/>
            <a:ext cx="571611" cy="243117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2" name="Imagen 141">
            <a:extLst>
              <a:ext uri="{FF2B5EF4-FFF2-40B4-BE49-F238E27FC236}">
                <a16:creationId xmlns:a16="http://schemas.microsoft.com/office/drawing/2014/main" id="{B1B57557-E2A0-FE42-8366-49553C902A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38186" y="4099959"/>
            <a:ext cx="526985" cy="501403"/>
          </a:xfrm>
          <a:prstGeom prst="rect">
            <a:avLst/>
          </a:prstGeom>
        </p:spPr>
      </p:pic>
      <p:grpSp>
        <p:nvGrpSpPr>
          <p:cNvPr id="143" name="Grupo 142">
            <a:extLst>
              <a:ext uri="{FF2B5EF4-FFF2-40B4-BE49-F238E27FC236}">
                <a16:creationId xmlns:a16="http://schemas.microsoft.com/office/drawing/2014/main" id="{A3A5C835-E96C-AA4F-A993-900DA4FE1891}"/>
              </a:ext>
            </a:extLst>
          </p:cNvPr>
          <p:cNvGrpSpPr>
            <a:grpSpLocks noChangeAspect="1"/>
          </p:cNvGrpSpPr>
          <p:nvPr/>
        </p:nvGrpSpPr>
        <p:grpSpPr>
          <a:xfrm rot="4072961">
            <a:off x="6356031" y="3242134"/>
            <a:ext cx="720000" cy="575110"/>
            <a:chOff x="13182994" y="1880366"/>
            <a:chExt cx="1104511" cy="882244"/>
          </a:xfrm>
        </p:grpSpPr>
        <p:grpSp>
          <p:nvGrpSpPr>
            <p:cNvPr id="144" name="Grupo 143">
              <a:extLst>
                <a:ext uri="{FF2B5EF4-FFF2-40B4-BE49-F238E27FC236}">
                  <a16:creationId xmlns:a16="http://schemas.microsoft.com/office/drawing/2014/main" id="{14FB8782-27C1-DC4B-AEDB-D1D002C76D23}"/>
                </a:ext>
              </a:extLst>
            </p:cNvPr>
            <p:cNvGrpSpPr>
              <a:grpSpLocks noChangeAspect="1"/>
            </p:cNvGrpSpPr>
            <p:nvPr/>
          </p:nvGrpSpPr>
          <p:grpSpPr>
            <a:xfrm rot="19797694">
              <a:off x="13182994" y="2000886"/>
              <a:ext cx="167764" cy="288000"/>
              <a:chOff x="12293211" y="8469082"/>
              <a:chExt cx="435722" cy="707576"/>
            </a:xfrm>
          </p:grpSpPr>
          <p:sp>
            <p:nvSpPr>
              <p:cNvPr id="166" name="Forma libre 165">
                <a:extLst>
                  <a:ext uri="{FF2B5EF4-FFF2-40B4-BE49-F238E27FC236}">
                    <a16:creationId xmlns:a16="http://schemas.microsoft.com/office/drawing/2014/main" id="{EDBBA9AF-81E7-6848-88AA-E48CB7468859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67" name="Forma libre 166">
                <a:extLst>
                  <a:ext uri="{FF2B5EF4-FFF2-40B4-BE49-F238E27FC236}">
                    <a16:creationId xmlns:a16="http://schemas.microsoft.com/office/drawing/2014/main" id="{503BA622-2F48-7448-A700-4D3ECC307811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45" name="Grupo 144">
              <a:extLst>
                <a:ext uri="{FF2B5EF4-FFF2-40B4-BE49-F238E27FC236}">
                  <a16:creationId xmlns:a16="http://schemas.microsoft.com/office/drawing/2014/main" id="{BD2D1D0F-91F0-224D-B870-A1E8390FA598}"/>
                </a:ext>
              </a:extLst>
            </p:cNvPr>
            <p:cNvGrpSpPr>
              <a:grpSpLocks noChangeAspect="1"/>
            </p:cNvGrpSpPr>
            <p:nvPr/>
          </p:nvGrpSpPr>
          <p:grpSpPr>
            <a:xfrm rot="20087550">
              <a:off x="13717324" y="1883934"/>
              <a:ext cx="167764" cy="288000"/>
              <a:chOff x="12293211" y="8469082"/>
              <a:chExt cx="435722" cy="707576"/>
            </a:xfrm>
          </p:grpSpPr>
          <p:sp>
            <p:nvSpPr>
              <p:cNvPr id="164" name="Forma libre 163">
                <a:extLst>
                  <a:ext uri="{FF2B5EF4-FFF2-40B4-BE49-F238E27FC236}">
                    <a16:creationId xmlns:a16="http://schemas.microsoft.com/office/drawing/2014/main" id="{721524E8-160F-8A42-BB64-6F8BB6417FD0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65" name="Forma libre 164">
                <a:extLst>
                  <a:ext uri="{FF2B5EF4-FFF2-40B4-BE49-F238E27FC236}">
                    <a16:creationId xmlns:a16="http://schemas.microsoft.com/office/drawing/2014/main" id="{E137542C-4AAD-C942-9B0B-D2DD0DAB4554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46" name="Grupo 145">
              <a:extLst>
                <a:ext uri="{FF2B5EF4-FFF2-40B4-BE49-F238E27FC236}">
                  <a16:creationId xmlns:a16="http://schemas.microsoft.com/office/drawing/2014/main" id="{0E5B2CDC-F9D1-C042-BA19-EB307B2EA1D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4119741" y="1880366"/>
              <a:ext cx="167764" cy="288000"/>
              <a:chOff x="12293211" y="8469082"/>
              <a:chExt cx="435722" cy="707576"/>
            </a:xfrm>
          </p:grpSpPr>
          <p:sp>
            <p:nvSpPr>
              <p:cNvPr id="162" name="Forma libre 161">
                <a:extLst>
                  <a:ext uri="{FF2B5EF4-FFF2-40B4-BE49-F238E27FC236}">
                    <a16:creationId xmlns:a16="http://schemas.microsoft.com/office/drawing/2014/main" id="{0BE19227-93FF-0E47-8BA3-908EA5DB2D33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63" name="Forma libre 162">
                <a:extLst>
                  <a:ext uri="{FF2B5EF4-FFF2-40B4-BE49-F238E27FC236}">
                    <a16:creationId xmlns:a16="http://schemas.microsoft.com/office/drawing/2014/main" id="{1B75C96B-434B-D94C-8CD6-2751CBA5FEC2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47" name="Grupo 146">
              <a:extLst>
                <a:ext uri="{FF2B5EF4-FFF2-40B4-BE49-F238E27FC236}">
                  <a16:creationId xmlns:a16="http://schemas.microsoft.com/office/drawing/2014/main" id="{9799AA79-B483-F149-B314-8632E327B3D1}"/>
                </a:ext>
              </a:extLst>
            </p:cNvPr>
            <p:cNvGrpSpPr>
              <a:grpSpLocks noChangeAspect="1"/>
            </p:cNvGrpSpPr>
            <p:nvPr/>
          </p:nvGrpSpPr>
          <p:grpSpPr>
            <a:xfrm rot="12837040">
              <a:off x="13195292" y="2433104"/>
              <a:ext cx="167764" cy="288000"/>
              <a:chOff x="12293211" y="8469082"/>
              <a:chExt cx="435722" cy="707576"/>
            </a:xfrm>
          </p:grpSpPr>
          <p:sp>
            <p:nvSpPr>
              <p:cNvPr id="160" name="Forma libre 159">
                <a:extLst>
                  <a:ext uri="{FF2B5EF4-FFF2-40B4-BE49-F238E27FC236}">
                    <a16:creationId xmlns:a16="http://schemas.microsoft.com/office/drawing/2014/main" id="{4407BACD-FF05-F348-9523-369D8C3C509E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61" name="Forma libre 160">
                <a:extLst>
                  <a:ext uri="{FF2B5EF4-FFF2-40B4-BE49-F238E27FC236}">
                    <a16:creationId xmlns:a16="http://schemas.microsoft.com/office/drawing/2014/main" id="{B6912FC3-ED3D-4E4F-BFD6-D96CF268006F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48" name="Grupo 147">
              <a:extLst>
                <a:ext uri="{FF2B5EF4-FFF2-40B4-BE49-F238E27FC236}">
                  <a16:creationId xmlns:a16="http://schemas.microsoft.com/office/drawing/2014/main" id="{65DB47A0-7853-F14E-B937-ABFDD82FABA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829375" y="2463051"/>
              <a:ext cx="167764" cy="288000"/>
              <a:chOff x="12293211" y="8469082"/>
              <a:chExt cx="435722" cy="707576"/>
            </a:xfrm>
          </p:grpSpPr>
          <p:sp>
            <p:nvSpPr>
              <p:cNvPr id="158" name="Forma libre 157">
                <a:extLst>
                  <a:ext uri="{FF2B5EF4-FFF2-40B4-BE49-F238E27FC236}">
                    <a16:creationId xmlns:a16="http://schemas.microsoft.com/office/drawing/2014/main" id="{F0E3DA91-6E67-194F-90FD-E77992DC066D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59" name="Forma libre 158">
                <a:extLst>
                  <a:ext uri="{FF2B5EF4-FFF2-40B4-BE49-F238E27FC236}">
                    <a16:creationId xmlns:a16="http://schemas.microsoft.com/office/drawing/2014/main" id="{BCDC2C28-6BF4-4D4B-B7C5-AACAA428045F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49" name="Grupo 148">
              <a:extLst>
                <a:ext uri="{FF2B5EF4-FFF2-40B4-BE49-F238E27FC236}">
                  <a16:creationId xmlns:a16="http://schemas.microsoft.com/office/drawing/2014/main" id="{254CD78A-DC3A-8349-948D-3F27E551FDAE}"/>
                </a:ext>
              </a:extLst>
            </p:cNvPr>
            <p:cNvGrpSpPr>
              <a:grpSpLocks noChangeAspect="1"/>
            </p:cNvGrpSpPr>
            <p:nvPr/>
          </p:nvGrpSpPr>
          <p:grpSpPr>
            <a:xfrm rot="4254917">
              <a:off x="13505771" y="2534728"/>
              <a:ext cx="167764" cy="288000"/>
              <a:chOff x="12293211" y="8469082"/>
              <a:chExt cx="435722" cy="707576"/>
            </a:xfrm>
          </p:grpSpPr>
          <p:sp>
            <p:nvSpPr>
              <p:cNvPr id="156" name="Forma libre 155">
                <a:extLst>
                  <a:ext uri="{FF2B5EF4-FFF2-40B4-BE49-F238E27FC236}">
                    <a16:creationId xmlns:a16="http://schemas.microsoft.com/office/drawing/2014/main" id="{9E066FA1-0DD9-8443-820D-72FE5B5737AD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57" name="Forma libre 156">
                <a:extLst>
                  <a:ext uri="{FF2B5EF4-FFF2-40B4-BE49-F238E27FC236}">
                    <a16:creationId xmlns:a16="http://schemas.microsoft.com/office/drawing/2014/main" id="{4D5697DF-3417-2E4B-B2F4-67DF4547C9CF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50" name="Grupo 149">
              <a:extLst>
                <a:ext uri="{FF2B5EF4-FFF2-40B4-BE49-F238E27FC236}">
                  <a16:creationId xmlns:a16="http://schemas.microsoft.com/office/drawing/2014/main" id="{2E5A3154-3FCE-2943-A438-6E9F4CC5AD4B}"/>
                </a:ext>
              </a:extLst>
            </p:cNvPr>
            <p:cNvGrpSpPr>
              <a:grpSpLocks noChangeAspect="1"/>
            </p:cNvGrpSpPr>
            <p:nvPr/>
          </p:nvGrpSpPr>
          <p:grpSpPr>
            <a:xfrm rot="3206025">
              <a:off x="13932061" y="2131458"/>
              <a:ext cx="167764" cy="288000"/>
              <a:chOff x="12293211" y="8469082"/>
              <a:chExt cx="435722" cy="707576"/>
            </a:xfrm>
          </p:grpSpPr>
          <p:sp>
            <p:nvSpPr>
              <p:cNvPr id="154" name="Forma libre 153">
                <a:extLst>
                  <a:ext uri="{FF2B5EF4-FFF2-40B4-BE49-F238E27FC236}">
                    <a16:creationId xmlns:a16="http://schemas.microsoft.com/office/drawing/2014/main" id="{873288D1-8ACE-964C-9E75-0F5EDDBD6949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55" name="Forma libre 154">
                <a:extLst>
                  <a:ext uri="{FF2B5EF4-FFF2-40B4-BE49-F238E27FC236}">
                    <a16:creationId xmlns:a16="http://schemas.microsoft.com/office/drawing/2014/main" id="{958158E4-50F3-FE4F-BBE4-85814199547E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51" name="Grupo 150">
              <a:extLst>
                <a:ext uri="{FF2B5EF4-FFF2-40B4-BE49-F238E27FC236}">
                  <a16:creationId xmlns:a16="http://schemas.microsoft.com/office/drawing/2014/main" id="{BF4A97EC-1576-E24D-A799-228A78EF0AF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454428" y="2112572"/>
              <a:ext cx="167764" cy="288000"/>
              <a:chOff x="12293211" y="8469082"/>
              <a:chExt cx="435722" cy="707576"/>
            </a:xfrm>
          </p:grpSpPr>
          <p:sp>
            <p:nvSpPr>
              <p:cNvPr id="152" name="Forma libre 151">
                <a:extLst>
                  <a:ext uri="{FF2B5EF4-FFF2-40B4-BE49-F238E27FC236}">
                    <a16:creationId xmlns:a16="http://schemas.microsoft.com/office/drawing/2014/main" id="{75CF14D7-C2A8-1A41-9FB4-C110AE2A2CBD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53" name="Forma libre 152">
                <a:extLst>
                  <a:ext uri="{FF2B5EF4-FFF2-40B4-BE49-F238E27FC236}">
                    <a16:creationId xmlns:a16="http://schemas.microsoft.com/office/drawing/2014/main" id="{8A8052BF-6F5C-AA41-B951-16F6D6B33A76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</p:grpSp>
      <p:grpSp>
        <p:nvGrpSpPr>
          <p:cNvPr id="172" name="Grupo 171">
            <a:extLst>
              <a:ext uri="{FF2B5EF4-FFF2-40B4-BE49-F238E27FC236}">
                <a16:creationId xmlns:a16="http://schemas.microsoft.com/office/drawing/2014/main" id="{FA233075-E158-9C49-BFE9-48B210E48800}"/>
              </a:ext>
            </a:extLst>
          </p:cNvPr>
          <p:cNvGrpSpPr/>
          <p:nvPr/>
        </p:nvGrpSpPr>
        <p:grpSpPr>
          <a:xfrm rot="13589337" flipV="1">
            <a:off x="8259274" y="4539788"/>
            <a:ext cx="222395" cy="466053"/>
            <a:chOff x="12362213" y="2324548"/>
            <a:chExt cx="222395" cy="466053"/>
          </a:xfrm>
        </p:grpSpPr>
        <p:cxnSp>
          <p:nvCxnSpPr>
            <p:cNvPr id="170" name="Conector recto 169">
              <a:extLst>
                <a:ext uri="{FF2B5EF4-FFF2-40B4-BE49-F238E27FC236}">
                  <a16:creationId xmlns:a16="http://schemas.microsoft.com/office/drawing/2014/main" id="{98A06063-F44E-F049-AA95-D9CB1B92AC6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Conector recto 170">
              <a:extLst>
                <a:ext uri="{FF2B5EF4-FFF2-40B4-BE49-F238E27FC236}">
                  <a16:creationId xmlns:a16="http://schemas.microsoft.com/office/drawing/2014/main" id="{3CF8C7D4-E152-934D-B297-693EA5107A8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62213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3" name="CuadroTexto 172">
            <a:extLst>
              <a:ext uri="{FF2B5EF4-FFF2-40B4-BE49-F238E27FC236}">
                <a16:creationId xmlns:a16="http://schemas.microsoft.com/office/drawing/2014/main" id="{7F6650DE-2111-E447-B595-356A7EC3E485}"/>
              </a:ext>
            </a:extLst>
          </p:cNvPr>
          <p:cNvSpPr txBox="1"/>
          <p:nvPr/>
        </p:nvSpPr>
        <p:spPr>
          <a:xfrm>
            <a:off x="6501550" y="4964607"/>
            <a:ext cx="846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rgbClr val="0070C0"/>
                </a:solidFill>
              </a:rPr>
              <a:t>MHC-II</a:t>
            </a:r>
            <a:endParaRPr lang="es-ES" sz="1600" b="1" dirty="0">
              <a:solidFill>
                <a:srgbClr val="0070C0"/>
              </a:solidFill>
            </a:endParaRPr>
          </a:p>
        </p:txBody>
      </p:sp>
      <p:grpSp>
        <p:nvGrpSpPr>
          <p:cNvPr id="174" name="Grupo 173">
            <a:extLst>
              <a:ext uri="{FF2B5EF4-FFF2-40B4-BE49-F238E27FC236}">
                <a16:creationId xmlns:a16="http://schemas.microsoft.com/office/drawing/2014/main" id="{79EED25F-18AE-7F45-9284-1FB887086A09}"/>
              </a:ext>
            </a:extLst>
          </p:cNvPr>
          <p:cNvGrpSpPr/>
          <p:nvPr/>
        </p:nvGrpSpPr>
        <p:grpSpPr>
          <a:xfrm rot="8548229">
            <a:off x="8079409" y="5113077"/>
            <a:ext cx="222395" cy="385631"/>
            <a:chOff x="12362213" y="2324548"/>
            <a:chExt cx="222395" cy="466053"/>
          </a:xfrm>
        </p:grpSpPr>
        <p:cxnSp>
          <p:nvCxnSpPr>
            <p:cNvPr id="175" name="Conector recto 174">
              <a:extLst>
                <a:ext uri="{FF2B5EF4-FFF2-40B4-BE49-F238E27FC236}">
                  <a16:creationId xmlns:a16="http://schemas.microsoft.com/office/drawing/2014/main" id="{A595A3E3-B846-E04E-BF84-E7B067B02A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Conector recto 175">
              <a:extLst>
                <a:ext uri="{FF2B5EF4-FFF2-40B4-BE49-F238E27FC236}">
                  <a16:creationId xmlns:a16="http://schemas.microsoft.com/office/drawing/2014/main" id="{F8F0815E-84D3-2F4B-906A-B6FD048AB7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62213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1" name="CuadroTexto 190">
            <a:extLst>
              <a:ext uri="{FF2B5EF4-FFF2-40B4-BE49-F238E27FC236}">
                <a16:creationId xmlns:a16="http://schemas.microsoft.com/office/drawing/2014/main" id="{7CA271EA-7A70-8343-9610-F34C2F50F21C}"/>
              </a:ext>
            </a:extLst>
          </p:cNvPr>
          <p:cNvSpPr txBox="1"/>
          <p:nvPr/>
        </p:nvSpPr>
        <p:spPr>
          <a:xfrm>
            <a:off x="11912484" y="1466445"/>
            <a:ext cx="5309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 err="1">
                <a:solidFill>
                  <a:srgbClr val="0070C0"/>
                </a:solidFill>
              </a:rPr>
              <a:t>L</a:t>
            </a:r>
            <a:r>
              <a:rPr lang="es-ES" sz="1800" b="1" dirty="0" err="1">
                <a:solidFill>
                  <a:srgbClr val="0070C0"/>
                </a:solidFill>
              </a:rPr>
              <a:t>Th</a:t>
            </a:r>
            <a:endParaRPr lang="es-ES" sz="1800" b="1" dirty="0">
              <a:solidFill>
                <a:srgbClr val="0070C0"/>
              </a:solidFill>
            </a:endParaRPr>
          </a:p>
        </p:txBody>
      </p:sp>
      <p:cxnSp>
        <p:nvCxnSpPr>
          <p:cNvPr id="192" name="Conector recto 191">
            <a:extLst>
              <a:ext uri="{FF2B5EF4-FFF2-40B4-BE49-F238E27FC236}">
                <a16:creationId xmlns:a16="http://schemas.microsoft.com/office/drawing/2014/main" id="{1FE40A67-3DB0-DC4B-A358-A3945DA9206D}"/>
              </a:ext>
            </a:extLst>
          </p:cNvPr>
          <p:cNvCxnSpPr>
            <a:cxnSpLocks/>
          </p:cNvCxnSpPr>
          <p:nvPr/>
        </p:nvCxnSpPr>
        <p:spPr>
          <a:xfrm flipV="1">
            <a:off x="11794755" y="1818204"/>
            <a:ext cx="276825" cy="290834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3" name="Grupo 192">
            <a:extLst>
              <a:ext uri="{FF2B5EF4-FFF2-40B4-BE49-F238E27FC236}">
                <a16:creationId xmlns:a16="http://schemas.microsoft.com/office/drawing/2014/main" id="{EFC98262-85A0-1F41-A579-C64EA790B6DE}"/>
              </a:ext>
            </a:extLst>
          </p:cNvPr>
          <p:cNvGrpSpPr/>
          <p:nvPr/>
        </p:nvGrpSpPr>
        <p:grpSpPr>
          <a:xfrm rot="15468561" flipH="1">
            <a:off x="7466883" y="4785267"/>
            <a:ext cx="222395" cy="487609"/>
            <a:chOff x="12362213" y="2324548"/>
            <a:chExt cx="222395" cy="466053"/>
          </a:xfrm>
        </p:grpSpPr>
        <p:cxnSp>
          <p:nvCxnSpPr>
            <p:cNvPr id="194" name="Conector recto 193">
              <a:extLst>
                <a:ext uri="{FF2B5EF4-FFF2-40B4-BE49-F238E27FC236}">
                  <a16:creationId xmlns:a16="http://schemas.microsoft.com/office/drawing/2014/main" id="{82329C76-7549-3547-8055-0B590FA9709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ector recto 194">
              <a:extLst>
                <a:ext uri="{FF2B5EF4-FFF2-40B4-BE49-F238E27FC236}">
                  <a16:creationId xmlns:a16="http://schemas.microsoft.com/office/drawing/2014/main" id="{B6CCBD58-2ED2-D347-A592-C887E7A8D19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62213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6" name="Grupo 195">
            <a:extLst>
              <a:ext uri="{FF2B5EF4-FFF2-40B4-BE49-F238E27FC236}">
                <a16:creationId xmlns:a16="http://schemas.microsoft.com/office/drawing/2014/main" id="{D46953A0-CC83-AF4C-A489-B55543AE7D49}"/>
              </a:ext>
            </a:extLst>
          </p:cNvPr>
          <p:cNvGrpSpPr/>
          <p:nvPr/>
        </p:nvGrpSpPr>
        <p:grpSpPr>
          <a:xfrm>
            <a:off x="7963359" y="5510224"/>
            <a:ext cx="978153" cy="489153"/>
            <a:chOff x="8407243" y="2043822"/>
            <a:chExt cx="978153" cy="489153"/>
          </a:xfrm>
        </p:grpSpPr>
        <p:sp>
          <p:nvSpPr>
            <p:cNvPr id="197" name="CuadroTexto 196">
              <a:extLst>
                <a:ext uri="{FF2B5EF4-FFF2-40B4-BE49-F238E27FC236}">
                  <a16:creationId xmlns:a16="http://schemas.microsoft.com/office/drawing/2014/main" id="{AC66E746-77E2-DB46-B85F-5516C05470D0}"/>
                </a:ext>
              </a:extLst>
            </p:cNvPr>
            <p:cNvSpPr txBox="1"/>
            <p:nvPr/>
          </p:nvSpPr>
          <p:spPr>
            <a:xfrm>
              <a:off x="8407243" y="2163643"/>
              <a:ext cx="9781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∼ TNF-⍺</a:t>
              </a:r>
            </a:p>
          </p:txBody>
        </p:sp>
        <p:sp>
          <p:nvSpPr>
            <p:cNvPr id="198" name="Elipse 197">
              <a:extLst>
                <a:ext uri="{FF2B5EF4-FFF2-40B4-BE49-F238E27FC236}">
                  <a16:creationId xmlns:a16="http://schemas.microsoft.com/office/drawing/2014/main" id="{D115D404-2582-A740-90EF-6B968644B1FA}"/>
                </a:ext>
              </a:extLst>
            </p:cNvPr>
            <p:cNvSpPr>
              <a:spLocks/>
            </p:cNvSpPr>
            <p:nvPr/>
          </p:nvSpPr>
          <p:spPr>
            <a:xfrm>
              <a:off x="8813091" y="2043822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cxnSp>
        <p:nvCxnSpPr>
          <p:cNvPr id="199" name="Conector recto 198">
            <a:extLst>
              <a:ext uri="{FF2B5EF4-FFF2-40B4-BE49-F238E27FC236}">
                <a16:creationId xmlns:a16="http://schemas.microsoft.com/office/drawing/2014/main" id="{50CBC73F-A991-D546-AE2C-154BDE0B0B88}"/>
              </a:ext>
            </a:extLst>
          </p:cNvPr>
          <p:cNvCxnSpPr>
            <a:cxnSpLocks/>
          </p:cNvCxnSpPr>
          <p:nvPr/>
        </p:nvCxnSpPr>
        <p:spPr>
          <a:xfrm flipH="1" flipV="1">
            <a:off x="7705805" y="5623679"/>
            <a:ext cx="310528" cy="83016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0" name="Imagen 199">
            <a:extLst>
              <a:ext uri="{FF2B5EF4-FFF2-40B4-BE49-F238E27FC236}">
                <a16:creationId xmlns:a16="http://schemas.microsoft.com/office/drawing/2014/main" id="{9AC72769-0D7C-D647-836C-F29EB081DE8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28263" y="5214338"/>
            <a:ext cx="432000" cy="432000"/>
          </a:xfrm>
          <a:prstGeom prst="rect">
            <a:avLst/>
          </a:prstGeom>
        </p:spPr>
      </p:pic>
      <p:pic>
        <p:nvPicPr>
          <p:cNvPr id="201" name="Imagen 200">
            <a:extLst>
              <a:ext uri="{FF2B5EF4-FFF2-40B4-BE49-F238E27FC236}">
                <a16:creationId xmlns:a16="http://schemas.microsoft.com/office/drawing/2014/main" id="{A6D5B597-30DD-C14D-A713-ABA0404EDBA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060924" y="6330769"/>
            <a:ext cx="360000" cy="360000"/>
          </a:xfrm>
          <a:prstGeom prst="rect">
            <a:avLst/>
          </a:prstGeom>
        </p:spPr>
      </p:pic>
      <p:cxnSp>
        <p:nvCxnSpPr>
          <p:cNvPr id="202" name="Conector recto 201">
            <a:extLst>
              <a:ext uri="{FF2B5EF4-FFF2-40B4-BE49-F238E27FC236}">
                <a16:creationId xmlns:a16="http://schemas.microsoft.com/office/drawing/2014/main" id="{720A092D-E0F5-AE4A-9E52-F8A25A6AA5F9}"/>
              </a:ext>
            </a:extLst>
          </p:cNvPr>
          <p:cNvCxnSpPr>
            <a:cxnSpLocks/>
          </p:cNvCxnSpPr>
          <p:nvPr/>
        </p:nvCxnSpPr>
        <p:spPr>
          <a:xfrm flipH="1">
            <a:off x="8342974" y="5952897"/>
            <a:ext cx="83520" cy="377872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" name="Imagen 204">
            <a:extLst>
              <a:ext uri="{FF2B5EF4-FFF2-40B4-BE49-F238E27FC236}">
                <a16:creationId xmlns:a16="http://schemas.microsoft.com/office/drawing/2014/main" id="{64A163C2-DE7A-E240-B9FF-72C1BD707A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29042" y="6061766"/>
            <a:ext cx="540000" cy="466418"/>
          </a:xfrm>
          <a:prstGeom prst="rect">
            <a:avLst/>
          </a:prstGeom>
        </p:spPr>
      </p:pic>
      <p:sp>
        <p:nvSpPr>
          <p:cNvPr id="206" name="Forma libre 205">
            <a:extLst>
              <a:ext uri="{FF2B5EF4-FFF2-40B4-BE49-F238E27FC236}">
                <a16:creationId xmlns:a16="http://schemas.microsoft.com/office/drawing/2014/main" id="{EA542B6C-F12D-F34A-BBA3-DA541B9FE87E}"/>
              </a:ext>
            </a:extLst>
          </p:cNvPr>
          <p:cNvSpPr/>
          <p:nvPr/>
        </p:nvSpPr>
        <p:spPr>
          <a:xfrm rot="8610980">
            <a:off x="8787135" y="5482812"/>
            <a:ext cx="481891" cy="108499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09" name="Imagen 208">
            <a:extLst>
              <a:ext uri="{FF2B5EF4-FFF2-40B4-BE49-F238E27FC236}">
                <a16:creationId xmlns:a16="http://schemas.microsoft.com/office/drawing/2014/main" id="{0BFEFB2A-D4AC-7E46-BFFE-E4F0103AF3D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16200000">
            <a:off x="5848203" y="5277585"/>
            <a:ext cx="749300" cy="711200"/>
          </a:xfrm>
          <a:prstGeom prst="rect">
            <a:avLst/>
          </a:prstGeom>
        </p:spPr>
      </p:pic>
      <p:cxnSp>
        <p:nvCxnSpPr>
          <p:cNvPr id="210" name="Conector recto 209">
            <a:extLst>
              <a:ext uri="{FF2B5EF4-FFF2-40B4-BE49-F238E27FC236}">
                <a16:creationId xmlns:a16="http://schemas.microsoft.com/office/drawing/2014/main" id="{F6211966-3F4A-A442-8263-0DFF031F58BA}"/>
              </a:ext>
            </a:extLst>
          </p:cNvPr>
          <p:cNvCxnSpPr>
            <a:cxnSpLocks/>
          </p:cNvCxnSpPr>
          <p:nvPr/>
        </p:nvCxnSpPr>
        <p:spPr>
          <a:xfrm flipH="1" flipV="1">
            <a:off x="6622886" y="5680919"/>
            <a:ext cx="1282491" cy="210229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Forma libre 211">
            <a:extLst>
              <a:ext uri="{FF2B5EF4-FFF2-40B4-BE49-F238E27FC236}">
                <a16:creationId xmlns:a16="http://schemas.microsoft.com/office/drawing/2014/main" id="{DC4F1AED-9F19-9245-8C50-BA339372B6B3}"/>
              </a:ext>
            </a:extLst>
          </p:cNvPr>
          <p:cNvSpPr/>
          <p:nvPr/>
        </p:nvSpPr>
        <p:spPr>
          <a:xfrm rot="2910183">
            <a:off x="7754761" y="5438965"/>
            <a:ext cx="450722" cy="169351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13" name="Imagen 212">
            <a:extLst>
              <a:ext uri="{FF2B5EF4-FFF2-40B4-BE49-F238E27FC236}">
                <a16:creationId xmlns:a16="http://schemas.microsoft.com/office/drawing/2014/main" id="{DC33BF81-8D8B-8447-AC22-0645C5ED32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43123" y="4878588"/>
            <a:ext cx="540000" cy="512476"/>
          </a:xfrm>
          <a:prstGeom prst="rect">
            <a:avLst/>
          </a:prstGeom>
        </p:spPr>
      </p:pic>
      <p:sp>
        <p:nvSpPr>
          <p:cNvPr id="214" name="Forma libre 213">
            <a:extLst>
              <a:ext uri="{FF2B5EF4-FFF2-40B4-BE49-F238E27FC236}">
                <a16:creationId xmlns:a16="http://schemas.microsoft.com/office/drawing/2014/main" id="{B44F7731-264F-ED47-9E94-D5F8A1B820AF}"/>
              </a:ext>
            </a:extLst>
          </p:cNvPr>
          <p:cNvSpPr/>
          <p:nvPr/>
        </p:nvSpPr>
        <p:spPr>
          <a:xfrm rot="13606760">
            <a:off x="8799838" y="6011232"/>
            <a:ext cx="481891" cy="108499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16" name="Imagen 215">
            <a:extLst>
              <a:ext uri="{FF2B5EF4-FFF2-40B4-BE49-F238E27FC236}">
                <a16:creationId xmlns:a16="http://schemas.microsoft.com/office/drawing/2014/main" id="{991E7185-067B-B749-9192-D966BDE33B2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873470">
            <a:off x="9433375" y="5521680"/>
            <a:ext cx="763002" cy="355793"/>
          </a:xfrm>
          <a:prstGeom prst="rect">
            <a:avLst/>
          </a:prstGeom>
        </p:spPr>
      </p:pic>
      <p:sp>
        <p:nvSpPr>
          <p:cNvPr id="217" name="Forma libre 216">
            <a:extLst>
              <a:ext uri="{FF2B5EF4-FFF2-40B4-BE49-F238E27FC236}">
                <a16:creationId xmlns:a16="http://schemas.microsoft.com/office/drawing/2014/main" id="{A0D997FB-ED85-5B45-9FC6-DEBAAF5D9338}"/>
              </a:ext>
            </a:extLst>
          </p:cNvPr>
          <p:cNvSpPr/>
          <p:nvPr/>
        </p:nvSpPr>
        <p:spPr>
          <a:xfrm rot="11298072">
            <a:off x="8891682" y="5688700"/>
            <a:ext cx="649901" cy="199581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8" name="Forma libre 217">
            <a:extLst>
              <a:ext uri="{FF2B5EF4-FFF2-40B4-BE49-F238E27FC236}">
                <a16:creationId xmlns:a16="http://schemas.microsoft.com/office/drawing/2014/main" id="{A7A3E758-6AEB-5C41-A407-8BFEA10A258C}"/>
              </a:ext>
            </a:extLst>
          </p:cNvPr>
          <p:cNvSpPr/>
          <p:nvPr/>
        </p:nvSpPr>
        <p:spPr>
          <a:xfrm rot="727166">
            <a:off x="9682522" y="5138397"/>
            <a:ext cx="850064" cy="123815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9" name="Forma libre 218">
            <a:extLst>
              <a:ext uri="{FF2B5EF4-FFF2-40B4-BE49-F238E27FC236}">
                <a16:creationId xmlns:a16="http://schemas.microsoft.com/office/drawing/2014/main" id="{F515B860-B16E-6D44-823D-FC6885F660F7}"/>
              </a:ext>
            </a:extLst>
          </p:cNvPr>
          <p:cNvSpPr/>
          <p:nvPr/>
        </p:nvSpPr>
        <p:spPr>
          <a:xfrm rot="18752359" flipV="1">
            <a:off x="9677605" y="5913698"/>
            <a:ext cx="1098192" cy="198512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0" name="Forma libre 219">
            <a:extLst>
              <a:ext uri="{FF2B5EF4-FFF2-40B4-BE49-F238E27FC236}">
                <a16:creationId xmlns:a16="http://schemas.microsoft.com/office/drawing/2014/main" id="{12395A94-1E58-7E4D-9F8C-2D3F8329CE3A}"/>
              </a:ext>
            </a:extLst>
          </p:cNvPr>
          <p:cNvSpPr/>
          <p:nvPr/>
        </p:nvSpPr>
        <p:spPr>
          <a:xfrm>
            <a:off x="10055329" y="5458444"/>
            <a:ext cx="481891" cy="108499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21" name="Grupo 220">
            <a:extLst>
              <a:ext uri="{FF2B5EF4-FFF2-40B4-BE49-F238E27FC236}">
                <a16:creationId xmlns:a16="http://schemas.microsoft.com/office/drawing/2014/main" id="{6274EFF9-2EC8-6246-9F71-8986B6EBA9A7}"/>
              </a:ext>
            </a:extLst>
          </p:cNvPr>
          <p:cNvGrpSpPr/>
          <p:nvPr/>
        </p:nvGrpSpPr>
        <p:grpSpPr>
          <a:xfrm>
            <a:off x="10433209" y="5143300"/>
            <a:ext cx="1111202" cy="489194"/>
            <a:chOff x="8608829" y="2124312"/>
            <a:chExt cx="1111202" cy="489194"/>
          </a:xfrm>
        </p:grpSpPr>
        <p:sp>
          <p:nvSpPr>
            <p:cNvPr id="222" name="CuadroTexto 221">
              <a:extLst>
                <a:ext uri="{FF2B5EF4-FFF2-40B4-BE49-F238E27FC236}">
                  <a16:creationId xmlns:a16="http://schemas.microsoft.com/office/drawing/2014/main" id="{B6B845E3-D9E6-A044-99BF-B9259506E692}"/>
                </a:ext>
              </a:extLst>
            </p:cNvPr>
            <p:cNvSpPr txBox="1"/>
            <p:nvPr/>
          </p:nvSpPr>
          <p:spPr>
            <a:xfrm>
              <a:off x="8608829" y="2244174"/>
              <a:ext cx="1111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GM-CSF</a:t>
              </a:r>
            </a:p>
          </p:txBody>
        </p:sp>
        <p:sp>
          <p:nvSpPr>
            <p:cNvPr id="223" name="Elipse 222">
              <a:extLst>
                <a:ext uri="{FF2B5EF4-FFF2-40B4-BE49-F238E27FC236}">
                  <a16:creationId xmlns:a16="http://schemas.microsoft.com/office/drawing/2014/main" id="{43AFAC8C-FCFF-6D4D-8EAF-38D5B4B0508D}"/>
                </a:ext>
              </a:extLst>
            </p:cNvPr>
            <p:cNvSpPr>
              <a:spLocks/>
            </p:cNvSpPr>
            <p:nvPr/>
          </p:nvSpPr>
          <p:spPr>
            <a:xfrm>
              <a:off x="9005963" y="2124312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cxnSp>
        <p:nvCxnSpPr>
          <p:cNvPr id="224" name="Conector recto 223">
            <a:extLst>
              <a:ext uri="{FF2B5EF4-FFF2-40B4-BE49-F238E27FC236}">
                <a16:creationId xmlns:a16="http://schemas.microsoft.com/office/drawing/2014/main" id="{3FE704C1-0B6C-B043-A217-B3A8A8143B97}"/>
              </a:ext>
            </a:extLst>
          </p:cNvPr>
          <p:cNvCxnSpPr>
            <a:cxnSpLocks/>
          </p:cNvCxnSpPr>
          <p:nvPr/>
        </p:nvCxnSpPr>
        <p:spPr>
          <a:xfrm>
            <a:off x="11454722" y="5566943"/>
            <a:ext cx="272689" cy="172171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5" name="Imagen 224">
            <a:extLst>
              <a:ext uri="{FF2B5EF4-FFF2-40B4-BE49-F238E27FC236}">
                <a16:creationId xmlns:a16="http://schemas.microsoft.com/office/drawing/2014/main" id="{2D680AAF-024C-1041-AAFB-5334DFD58EE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727411" y="5663940"/>
            <a:ext cx="360000" cy="360000"/>
          </a:xfrm>
          <a:prstGeom prst="rect">
            <a:avLst/>
          </a:prstGeom>
        </p:spPr>
      </p:pic>
      <p:pic>
        <p:nvPicPr>
          <p:cNvPr id="226" name="Imagen 225">
            <a:extLst>
              <a:ext uri="{FF2B5EF4-FFF2-40B4-BE49-F238E27FC236}">
                <a16:creationId xmlns:a16="http://schemas.microsoft.com/office/drawing/2014/main" id="{AD2FE0AF-CA19-CE41-849E-2DBD1DF4C9E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691956" y="4911572"/>
            <a:ext cx="360000" cy="360000"/>
          </a:xfrm>
          <a:prstGeom prst="rect">
            <a:avLst/>
          </a:prstGeom>
        </p:spPr>
      </p:pic>
      <p:cxnSp>
        <p:nvCxnSpPr>
          <p:cNvPr id="227" name="Conector recto 226">
            <a:extLst>
              <a:ext uri="{FF2B5EF4-FFF2-40B4-BE49-F238E27FC236}">
                <a16:creationId xmlns:a16="http://schemas.microsoft.com/office/drawing/2014/main" id="{1C014FF2-B4A6-7C4E-82AC-1418AE7DC7E6}"/>
              </a:ext>
            </a:extLst>
          </p:cNvPr>
          <p:cNvCxnSpPr>
            <a:cxnSpLocks/>
          </p:cNvCxnSpPr>
          <p:nvPr/>
        </p:nvCxnSpPr>
        <p:spPr>
          <a:xfrm flipV="1">
            <a:off x="11466183" y="5207093"/>
            <a:ext cx="203768" cy="124850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Forma libre 234">
            <a:extLst>
              <a:ext uri="{FF2B5EF4-FFF2-40B4-BE49-F238E27FC236}">
                <a16:creationId xmlns:a16="http://schemas.microsoft.com/office/drawing/2014/main" id="{9C19FAA7-06C5-A941-A261-CDA885E3515F}"/>
              </a:ext>
            </a:extLst>
          </p:cNvPr>
          <p:cNvSpPr/>
          <p:nvPr/>
        </p:nvSpPr>
        <p:spPr>
          <a:xfrm>
            <a:off x="9771495" y="3654705"/>
            <a:ext cx="1082998" cy="1305969"/>
          </a:xfrm>
          <a:custGeom>
            <a:avLst/>
            <a:gdLst>
              <a:gd name="connsiteX0" fmla="*/ 533017 w 1223750"/>
              <a:gd name="connsiteY0" fmla="*/ 0 h 1657761"/>
              <a:gd name="connsiteX1" fmla="*/ 118576 w 1223750"/>
              <a:gd name="connsiteY1" fmla="*/ 171039 h 1657761"/>
              <a:gd name="connsiteX2" fmla="*/ 165 w 1223750"/>
              <a:gd name="connsiteY2" fmla="*/ 276294 h 1657761"/>
              <a:gd name="connsiteX3" fmla="*/ 111998 w 1223750"/>
              <a:gd name="connsiteY3" fmla="*/ 605215 h 1657761"/>
              <a:gd name="connsiteX4" fmla="*/ 671163 w 1223750"/>
              <a:gd name="connsiteY4" fmla="*/ 934135 h 1657761"/>
              <a:gd name="connsiteX5" fmla="*/ 1223750 w 1223750"/>
              <a:gd name="connsiteY5" fmla="*/ 1657761 h 1657761"/>
              <a:gd name="connsiteX6" fmla="*/ 1223750 w 1223750"/>
              <a:gd name="connsiteY6" fmla="*/ 1657761 h 1657761"/>
              <a:gd name="connsiteX0" fmla="*/ 538385 w 1229118"/>
              <a:gd name="connsiteY0" fmla="*/ 0 h 1657761"/>
              <a:gd name="connsiteX1" fmla="*/ 123944 w 1229118"/>
              <a:gd name="connsiteY1" fmla="*/ 171039 h 1657761"/>
              <a:gd name="connsiteX2" fmla="*/ 5533 w 1229118"/>
              <a:gd name="connsiteY2" fmla="*/ 276294 h 1657761"/>
              <a:gd name="connsiteX3" fmla="*/ 117366 w 1229118"/>
              <a:gd name="connsiteY3" fmla="*/ 605215 h 1657761"/>
              <a:gd name="connsiteX4" fmla="*/ 923741 w 1229118"/>
              <a:gd name="connsiteY4" fmla="*/ 976955 h 1657761"/>
              <a:gd name="connsiteX5" fmla="*/ 1229118 w 1229118"/>
              <a:gd name="connsiteY5" fmla="*/ 1657761 h 1657761"/>
              <a:gd name="connsiteX6" fmla="*/ 1229118 w 1229118"/>
              <a:gd name="connsiteY6" fmla="*/ 1657761 h 1657761"/>
              <a:gd name="connsiteX0" fmla="*/ 552783 w 1243516"/>
              <a:gd name="connsiteY0" fmla="*/ 0 h 1657761"/>
              <a:gd name="connsiteX1" fmla="*/ 138342 w 1243516"/>
              <a:gd name="connsiteY1" fmla="*/ 171039 h 1657761"/>
              <a:gd name="connsiteX2" fmla="*/ 19931 w 1243516"/>
              <a:gd name="connsiteY2" fmla="*/ 276294 h 1657761"/>
              <a:gd name="connsiteX3" fmla="*/ 99866 w 1243516"/>
              <a:gd name="connsiteY3" fmla="*/ 807079 h 1657761"/>
              <a:gd name="connsiteX4" fmla="*/ 938139 w 1243516"/>
              <a:gd name="connsiteY4" fmla="*/ 976955 h 1657761"/>
              <a:gd name="connsiteX5" fmla="*/ 1243516 w 1243516"/>
              <a:gd name="connsiteY5" fmla="*/ 1657761 h 1657761"/>
              <a:gd name="connsiteX6" fmla="*/ 1243516 w 1243516"/>
              <a:gd name="connsiteY6" fmla="*/ 1657761 h 1657761"/>
              <a:gd name="connsiteX0" fmla="*/ 622102 w 1312835"/>
              <a:gd name="connsiteY0" fmla="*/ 0 h 1657761"/>
              <a:gd name="connsiteX1" fmla="*/ 207661 w 1312835"/>
              <a:gd name="connsiteY1" fmla="*/ 171039 h 1657761"/>
              <a:gd name="connsiteX2" fmla="*/ 1532 w 1312835"/>
              <a:gd name="connsiteY2" fmla="*/ 441455 h 1657761"/>
              <a:gd name="connsiteX3" fmla="*/ 169185 w 1312835"/>
              <a:gd name="connsiteY3" fmla="*/ 807079 h 1657761"/>
              <a:gd name="connsiteX4" fmla="*/ 1007458 w 1312835"/>
              <a:gd name="connsiteY4" fmla="*/ 976955 h 1657761"/>
              <a:gd name="connsiteX5" fmla="*/ 1312835 w 1312835"/>
              <a:gd name="connsiteY5" fmla="*/ 1657761 h 1657761"/>
              <a:gd name="connsiteX6" fmla="*/ 1312835 w 1312835"/>
              <a:gd name="connsiteY6" fmla="*/ 1657761 h 1657761"/>
              <a:gd name="connsiteX0" fmla="*/ 622102 w 1312835"/>
              <a:gd name="connsiteY0" fmla="*/ 0 h 1657761"/>
              <a:gd name="connsiteX1" fmla="*/ 207661 w 1312835"/>
              <a:gd name="connsiteY1" fmla="*/ 195508 h 1657761"/>
              <a:gd name="connsiteX2" fmla="*/ 1532 w 1312835"/>
              <a:gd name="connsiteY2" fmla="*/ 441455 h 1657761"/>
              <a:gd name="connsiteX3" fmla="*/ 169185 w 1312835"/>
              <a:gd name="connsiteY3" fmla="*/ 807079 h 1657761"/>
              <a:gd name="connsiteX4" fmla="*/ 1007458 w 1312835"/>
              <a:gd name="connsiteY4" fmla="*/ 976955 h 1657761"/>
              <a:gd name="connsiteX5" fmla="*/ 1312835 w 1312835"/>
              <a:gd name="connsiteY5" fmla="*/ 1657761 h 1657761"/>
              <a:gd name="connsiteX6" fmla="*/ 1312835 w 1312835"/>
              <a:gd name="connsiteY6" fmla="*/ 1657761 h 16577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312835" h="1657761">
                <a:moveTo>
                  <a:pt x="622102" y="0"/>
                </a:moveTo>
                <a:cubicBezTo>
                  <a:pt x="459286" y="62495"/>
                  <a:pt x="311089" y="121932"/>
                  <a:pt x="207661" y="195508"/>
                </a:cubicBezTo>
                <a:cubicBezTo>
                  <a:pt x="104233" y="269084"/>
                  <a:pt x="7945" y="339527"/>
                  <a:pt x="1532" y="441455"/>
                </a:cubicBezTo>
                <a:cubicBezTo>
                  <a:pt x="-4881" y="543384"/>
                  <a:pt x="1531" y="717829"/>
                  <a:pt x="169185" y="807079"/>
                </a:cubicBezTo>
                <a:cubicBezTo>
                  <a:pt x="336839" y="896329"/>
                  <a:pt x="816850" y="835175"/>
                  <a:pt x="1007458" y="976955"/>
                </a:cubicBezTo>
                <a:cubicBezTo>
                  <a:pt x="1198066" y="1118735"/>
                  <a:pt x="1261939" y="1544293"/>
                  <a:pt x="1312835" y="1657761"/>
                </a:cubicBezTo>
                <a:lnTo>
                  <a:pt x="1312835" y="1657761"/>
                </a:lnTo>
              </a:path>
            </a:pathLst>
          </a:cu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7" name="Forma libre 236">
            <a:extLst>
              <a:ext uri="{FF2B5EF4-FFF2-40B4-BE49-F238E27FC236}">
                <a16:creationId xmlns:a16="http://schemas.microsoft.com/office/drawing/2014/main" id="{F3851DA7-599C-A54A-B4D0-DFC89CB688C8}"/>
              </a:ext>
            </a:extLst>
          </p:cNvPr>
          <p:cNvSpPr/>
          <p:nvPr/>
        </p:nvSpPr>
        <p:spPr>
          <a:xfrm rot="8489053">
            <a:off x="8851912" y="6469010"/>
            <a:ext cx="481891" cy="108499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8" name="Forma libre 237">
            <a:extLst>
              <a:ext uri="{FF2B5EF4-FFF2-40B4-BE49-F238E27FC236}">
                <a16:creationId xmlns:a16="http://schemas.microsoft.com/office/drawing/2014/main" id="{B4A9190E-90F4-8042-AC38-8170770BEEF0}"/>
              </a:ext>
            </a:extLst>
          </p:cNvPr>
          <p:cNvSpPr/>
          <p:nvPr/>
        </p:nvSpPr>
        <p:spPr>
          <a:xfrm rot="2442417">
            <a:off x="8440808" y="6551035"/>
            <a:ext cx="481891" cy="108499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9" name="CuadroTexto 238">
            <a:extLst>
              <a:ext uri="{FF2B5EF4-FFF2-40B4-BE49-F238E27FC236}">
                <a16:creationId xmlns:a16="http://schemas.microsoft.com/office/drawing/2014/main" id="{63FD555D-1B90-D042-8D98-DF6E0C41330B}"/>
              </a:ext>
            </a:extLst>
          </p:cNvPr>
          <p:cNvSpPr txBox="1"/>
          <p:nvPr/>
        </p:nvSpPr>
        <p:spPr>
          <a:xfrm>
            <a:off x="8497969" y="6854494"/>
            <a:ext cx="110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∼ MIP-1⍺</a:t>
            </a:r>
          </a:p>
        </p:txBody>
      </p:sp>
      <p:sp>
        <p:nvSpPr>
          <p:cNvPr id="240" name="CuadroTexto 239">
            <a:extLst>
              <a:ext uri="{FF2B5EF4-FFF2-40B4-BE49-F238E27FC236}">
                <a16:creationId xmlns:a16="http://schemas.microsoft.com/office/drawing/2014/main" id="{72798FD8-82EC-424E-B62C-8C1FC5D7CBF2}"/>
              </a:ext>
            </a:extLst>
          </p:cNvPr>
          <p:cNvSpPr txBox="1"/>
          <p:nvPr/>
        </p:nvSpPr>
        <p:spPr>
          <a:xfrm>
            <a:off x="8556765" y="7110164"/>
            <a:ext cx="1050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￪ MIP-1β</a:t>
            </a:r>
          </a:p>
        </p:txBody>
      </p:sp>
      <p:cxnSp>
        <p:nvCxnSpPr>
          <p:cNvPr id="241" name="Conector recto 240">
            <a:extLst>
              <a:ext uri="{FF2B5EF4-FFF2-40B4-BE49-F238E27FC236}">
                <a16:creationId xmlns:a16="http://schemas.microsoft.com/office/drawing/2014/main" id="{DF3DBD5E-32FC-FA4E-B348-5AC73369E0AC}"/>
              </a:ext>
            </a:extLst>
          </p:cNvPr>
          <p:cNvCxnSpPr>
            <a:cxnSpLocks/>
          </p:cNvCxnSpPr>
          <p:nvPr/>
        </p:nvCxnSpPr>
        <p:spPr>
          <a:xfrm flipH="1" flipV="1">
            <a:off x="8170273" y="7102351"/>
            <a:ext cx="324000" cy="87366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2" name="Imagen 241">
            <a:extLst>
              <a:ext uri="{FF2B5EF4-FFF2-40B4-BE49-F238E27FC236}">
                <a16:creationId xmlns:a16="http://schemas.microsoft.com/office/drawing/2014/main" id="{DA154008-34CB-8E44-A1DC-B9D4AAC5E78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95675" y="6838179"/>
            <a:ext cx="360000" cy="360000"/>
          </a:xfrm>
          <a:prstGeom prst="rect">
            <a:avLst/>
          </a:prstGeom>
        </p:spPr>
      </p:pic>
      <p:sp>
        <p:nvSpPr>
          <p:cNvPr id="244" name="Forma libre 243">
            <a:extLst>
              <a:ext uri="{FF2B5EF4-FFF2-40B4-BE49-F238E27FC236}">
                <a16:creationId xmlns:a16="http://schemas.microsoft.com/office/drawing/2014/main" id="{6ADD9B98-CB9B-7F4C-B798-BEFF89F8134E}"/>
              </a:ext>
            </a:extLst>
          </p:cNvPr>
          <p:cNvSpPr/>
          <p:nvPr/>
        </p:nvSpPr>
        <p:spPr>
          <a:xfrm rot="7560074">
            <a:off x="6872815" y="7195475"/>
            <a:ext cx="450722" cy="169351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46" name="Imagen 245">
            <a:extLst>
              <a:ext uri="{FF2B5EF4-FFF2-40B4-BE49-F238E27FC236}">
                <a16:creationId xmlns:a16="http://schemas.microsoft.com/office/drawing/2014/main" id="{BBD8392F-B762-B14C-A18E-DF095ED7EF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91066" y="6650112"/>
            <a:ext cx="540000" cy="466418"/>
          </a:xfrm>
          <a:prstGeom prst="rect">
            <a:avLst/>
          </a:prstGeom>
        </p:spPr>
      </p:pic>
      <p:grpSp>
        <p:nvGrpSpPr>
          <p:cNvPr id="256" name="Grupo 255">
            <a:extLst>
              <a:ext uri="{FF2B5EF4-FFF2-40B4-BE49-F238E27FC236}">
                <a16:creationId xmlns:a16="http://schemas.microsoft.com/office/drawing/2014/main" id="{1ACEEBA6-23C0-AC4E-BC3C-73656C5A4086}"/>
              </a:ext>
            </a:extLst>
          </p:cNvPr>
          <p:cNvGrpSpPr/>
          <p:nvPr/>
        </p:nvGrpSpPr>
        <p:grpSpPr>
          <a:xfrm>
            <a:off x="6600841" y="7322242"/>
            <a:ext cx="663964" cy="801228"/>
            <a:chOff x="10794336" y="1566226"/>
            <a:chExt cx="663964" cy="801228"/>
          </a:xfrm>
        </p:grpSpPr>
        <p:sp>
          <p:nvSpPr>
            <p:cNvPr id="257" name="CuadroTexto 256">
              <a:extLst>
                <a:ext uri="{FF2B5EF4-FFF2-40B4-BE49-F238E27FC236}">
                  <a16:creationId xmlns:a16="http://schemas.microsoft.com/office/drawing/2014/main" id="{DF052C97-2BD2-A143-B14C-EBF811637276}"/>
                </a:ext>
              </a:extLst>
            </p:cNvPr>
            <p:cNvSpPr txBox="1"/>
            <p:nvPr/>
          </p:nvSpPr>
          <p:spPr>
            <a:xfrm>
              <a:off x="10794336" y="1721123"/>
              <a:ext cx="66396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IL-1⍺</a:t>
              </a:r>
            </a:p>
            <a:p>
              <a:r>
                <a:rPr lang="es-ES" sz="1800" b="1" dirty="0">
                  <a:solidFill>
                    <a:schemeClr val="accent2"/>
                  </a:solidFill>
                </a:rPr>
                <a:t>IL-1β</a:t>
              </a:r>
            </a:p>
          </p:txBody>
        </p:sp>
        <p:sp>
          <p:nvSpPr>
            <p:cNvPr id="258" name="Elipse 257">
              <a:extLst>
                <a:ext uri="{FF2B5EF4-FFF2-40B4-BE49-F238E27FC236}">
                  <a16:creationId xmlns:a16="http://schemas.microsoft.com/office/drawing/2014/main" id="{BE930138-725E-3F4C-9BFD-EB5F7AFB70B4}"/>
                </a:ext>
              </a:extLst>
            </p:cNvPr>
            <p:cNvSpPr>
              <a:spLocks/>
            </p:cNvSpPr>
            <p:nvPr/>
          </p:nvSpPr>
          <p:spPr>
            <a:xfrm>
              <a:off x="11009934" y="1566226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sp>
        <p:nvSpPr>
          <p:cNvPr id="259" name="Forma libre 258">
            <a:extLst>
              <a:ext uri="{FF2B5EF4-FFF2-40B4-BE49-F238E27FC236}">
                <a16:creationId xmlns:a16="http://schemas.microsoft.com/office/drawing/2014/main" id="{DC75E5EB-B49B-BA41-A781-F5BDEB5E8389}"/>
              </a:ext>
            </a:extLst>
          </p:cNvPr>
          <p:cNvSpPr/>
          <p:nvPr/>
        </p:nvSpPr>
        <p:spPr>
          <a:xfrm rot="19300513">
            <a:off x="7404789" y="6294344"/>
            <a:ext cx="1001176" cy="193487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  <a:gd name="connsiteX0" fmla="*/ 0 w 712205"/>
              <a:gd name="connsiteY0" fmla="*/ 318190 h 460935"/>
              <a:gd name="connsiteX1" fmla="*/ 115595 w 712205"/>
              <a:gd name="connsiteY1" fmla="*/ 250673 h 460935"/>
              <a:gd name="connsiteX2" fmla="*/ 235234 w 712205"/>
              <a:gd name="connsiteY2" fmla="*/ 459162 h 460935"/>
              <a:gd name="connsiteX3" fmla="*/ 282407 w 712205"/>
              <a:gd name="connsiteY3" fmla="*/ 112637 h 460935"/>
              <a:gd name="connsiteX4" fmla="*/ 396590 w 712205"/>
              <a:gd name="connsiteY4" fmla="*/ 362447 h 460935"/>
              <a:gd name="connsiteX5" fmla="*/ 466324 w 712205"/>
              <a:gd name="connsiteY5" fmla="*/ 112886 h 460935"/>
              <a:gd name="connsiteX6" fmla="*/ 593130 w 712205"/>
              <a:gd name="connsiteY6" fmla="*/ 69141 h 460935"/>
              <a:gd name="connsiteX7" fmla="*/ 712205 w 712205"/>
              <a:gd name="connsiteY7" fmla="*/ 0 h 460935"/>
              <a:gd name="connsiteX0" fmla="*/ 0 w 712205"/>
              <a:gd name="connsiteY0" fmla="*/ 318190 h 460935"/>
              <a:gd name="connsiteX1" fmla="*/ 115595 w 712205"/>
              <a:gd name="connsiteY1" fmla="*/ 250673 h 460935"/>
              <a:gd name="connsiteX2" fmla="*/ 235234 w 712205"/>
              <a:gd name="connsiteY2" fmla="*/ 459162 h 460935"/>
              <a:gd name="connsiteX3" fmla="*/ 282407 w 712205"/>
              <a:gd name="connsiteY3" fmla="*/ 112637 h 460935"/>
              <a:gd name="connsiteX4" fmla="*/ 396590 w 712205"/>
              <a:gd name="connsiteY4" fmla="*/ 362447 h 460935"/>
              <a:gd name="connsiteX5" fmla="*/ 466324 w 712205"/>
              <a:gd name="connsiteY5" fmla="*/ 112886 h 460935"/>
              <a:gd name="connsiteX6" fmla="*/ 593130 w 712205"/>
              <a:gd name="connsiteY6" fmla="*/ 69141 h 460935"/>
              <a:gd name="connsiteX7" fmla="*/ 712205 w 712205"/>
              <a:gd name="connsiteY7" fmla="*/ 0 h 4609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712205" h="460935">
                <a:moveTo>
                  <a:pt x="0" y="318190"/>
                </a:moveTo>
                <a:cubicBezTo>
                  <a:pt x="52057" y="320624"/>
                  <a:pt x="76390" y="227178"/>
                  <a:pt x="115595" y="250673"/>
                </a:cubicBezTo>
                <a:cubicBezTo>
                  <a:pt x="154800" y="274168"/>
                  <a:pt x="207432" y="482168"/>
                  <a:pt x="235234" y="459162"/>
                </a:cubicBezTo>
                <a:cubicBezTo>
                  <a:pt x="263036" y="436156"/>
                  <a:pt x="255514" y="128756"/>
                  <a:pt x="282407" y="112637"/>
                </a:cubicBezTo>
                <a:cubicBezTo>
                  <a:pt x="309300" y="96518"/>
                  <a:pt x="365937" y="362406"/>
                  <a:pt x="396590" y="362447"/>
                </a:cubicBezTo>
                <a:cubicBezTo>
                  <a:pt x="427243" y="362488"/>
                  <a:pt x="433567" y="161770"/>
                  <a:pt x="466324" y="112886"/>
                </a:cubicBezTo>
                <a:cubicBezTo>
                  <a:pt x="499081" y="64002"/>
                  <a:pt x="552150" y="87955"/>
                  <a:pt x="593130" y="69141"/>
                </a:cubicBezTo>
                <a:cubicBezTo>
                  <a:pt x="634110" y="50327"/>
                  <a:pt x="689240" y="37578"/>
                  <a:pt x="712205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3" name="Forma libre 262">
            <a:extLst>
              <a:ext uri="{FF2B5EF4-FFF2-40B4-BE49-F238E27FC236}">
                <a16:creationId xmlns:a16="http://schemas.microsoft.com/office/drawing/2014/main" id="{3F3479B3-FB83-614E-AA22-C6DE1FA3D7CC}"/>
              </a:ext>
            </a:extLst>
          </p:cNvPr>
          <p:cNvSpPr/>
          <p:nvPr/>
        </p:nvSpPr>
        <p:spPr>
          <a:xfrm rot="3896105">
            <a:off x="7261507" y="7265439"/>
            <a:ext cx="656708" cy="163570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  <a:gd name="connsiteX0" fmla="*/ -1 w 744493"/>
              <a:gd name="connsiteY0" fmla="*/ 391419 h 460845"/>
              <a:gd name="connsiteX1" fmla="*/ 147883 w 744493"/>
              <a:gd name="connsiteY1" fmla="*/ 250673 h 460845"/>
              <a:gd name="connsiteX2" fmla="*/ 267522 w 744493"/>
              <a:gd name="connsiteY2" fmla="*/ 459162 h 460845"/>
              <a:gd name="connsiteX3" fmla="*/ 314695 w 744493"/>
              <a:gd name="connsiteY3" fmla="*/ 112637 h 460845"/>
              <a:gd name="connsiteX4" fmla="*/ 428878 w 744493"/>
              <a:gd name="connsiteY4" fmla="*/ 362447 h 460845"/>
              <a:gd name="connsiteX5" fmla="*/ 498612 w 744493"/>
              <a:gd name="connsiteY5" fmla="*/ 112886 h 460845"/>
              <a:gd name="connsiteX6" fmla="*/ 625418 w 744493"/>
              <a:gd name="connsiteY6" fmla="*/ 69141 h 460845"/>
              <a:gd name="connsiteX7" fmla="*/ 744493 w 744493"/>
              <a:gd name="connsiteY7" fmla="*/ 0 h 460845"/>
              <a:gd name="connsiteX0" fmla="*/ 0 w 744494"/>
              <a:gd name="connsiteY0" fmla="*/ 391419 h 460845"/>
              <a:gd name="connsiteX1" fmla="*/ 147884 w 744494"/>
              <a:gd name="connsiteY1" fmla="*/ 250673 h 460845"/>
              <a:gd name="connsiteX2" fmla="*/ 267523 w 744494"/>
              <a:gd name="connsiteY2" fmla="*/ 459162 h 460845"/>
              <a:gd name="connsiteX3" fmla="*/ 314696 w 744494"/>
              <a:gd name="connsiteY3" fmla="*/ 112637 h 460845"/>
              <a:gd name="connsiteX4" fmla="*/ 428879 w 744494"/>
              <a:gd name="connsiteY4" fmla="*/ 362447 h 460845"/>
              <a:gd name="connsiteX5" fmla="*/ 498613 w 744494"/>
              <a:gd name="connsiteY5" fmla="*/ 112886 h 460845"/>
              <a:gd name="connsiteX6" fmla="*/ 625419 w 744494"/>
              <a:gd name="connsiteY6" fmla="*/ 69141 h 460845"/>
              <a:gd name="connsiteX7" fmla="*/ 744494 w 744494"/>
              <a:gd name="connsiteY7" fmla="*/ 0 h 460845"/>
              <a:gd name="connsiteX0" fmla="*/ 0 w 744494"/>
              <a:gd name="connsiteY0" fmla="*/ 391419 h 460845"/>
              <a:gd name="connsiteX1" fmla="*/ 147884 w 744494"/>
              <a:gd name="connsiteY1" fmla="*/ 250673 h 460845"/>
              <a:gd name="connsiteX2" fmla="*/ 267523 w 744494"/>
              <a:gd name="connsiteY2" fmla="*/ 459162 h 460845"/>
              <a:gd name="connsiteX3" fmla="*/ 314696 w 744494"/>
              <a:gd name="connsiteY3" fmla="*/ 112637 h 460845"/>
              <a:gd name="connsiteX4" fmla="*/ 428879 w 744494"/>
              <a:gd name="connsiteY4" fmla="*/ 362447 h 460845"/>
              <a:gd name="connsiteX5" fmla="*/ 498613 w 744494"/>
              <a:gd name="connsiteY5" fmla="*/ 112886 h 460845"/>
              <a:gd name="connsiteX6" fmla="*/ 625419 w 744494"/>
              <a:gd name="connsiteY6" fmla="*/ 69141 h 460845"/>
              <a:gd name="connsiteX7" fmla="*/ 744494 w 744494"/>
              <a:gd name="connsiteY7" fmla="*/ 0 h 4608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744494" h="460845">
                <a:moveTo>
                  <a:pt x="0" y="391419"/>
                </a:moveTo>
                <a:cubicBezTo>
                  <a:pt x="98500" y="515449"/>
                  <a:pt x="103297" y="239383"/>
                  <a:pt x="147884" y="250673"/>
                </a:cubicBezTo>
                <a:cubicBezTo>
                  <a:pt x="192471" y="261963"/>
                  <a:pt x="239721" y="482168"/>
                  <a:pt x="267523" y="459162"/>
                </a:cubicBezTo>
                <a:cubicBezTo>
                  <a:pt x="295325" y="436156"/>
                  <a:pt x="287803" y="128756"/>
                  <a:pt x="314696" y="112637"/>
                </a:cubicBezTo>
                <a:cubicBezTo>
                  <a:pt x="341589" y="96518"/>
                  <a:pt x="398226" y="362406"/>
                  <a:pt x="428879" y="362447"/>
                </a:cubicBezTo>
                <a:cubicBezTo>
                  <a:pt x="459532" y="362488"/>
                  <a:pt x="465856" y="161770"/>
                  <a:pt x="498613" y="112886"/>
                </a:cubicBezTo>
                <a:cubicBezTo>
                  <a:pt x="531370" y="64002"/>
                  <a:pt x="584439" y="87955"/>
                  <a:pt x="625419" y="69141"/>
                </a:cubicBezTo>
                <a:cubicBezTo>
                  <a:pt x="666399" y="50327"/>
                  <a:pt x="721529" y="37578"/>
                  <a:pt x="744494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64" name="Grupo 263">
            <a:extLst>
              <a:ext uri="{FF2B5EF4-FFF2-40B4-BE49-F238E27FC236}">
                <a16:creationId xmlns:a16="http://schemas.microsoft.com/office/drawing/2014/main" id="{3A54832D-7102-3741-A44C-8044FEF8331C}"/>
              </a:ext>
            </a:extLst>
          </p:cNvPr>
          <p:cNvGrpSpPr/>
          <p:nvPr/>
        </p:nvGrpSpPr>
        <p:grpSpPr>
          <a:xfrm>
            <a:off x="7539798" y="7392990"/>
            <a:ext cx="851617" cy="537609"/>
            <a:chOff x="10643552" y="1552846"/>
            <a:chExt cx="851617" cy="537609"/>
          </a:xfrm>
        </p:grpSpPr>
        <p:sp>
          <p:nvSpPr>
            <p:cNvPr id="265" name="CuadroTexto 264">
              <a:extLst>
                <a:ext uri="{FF2B5EF4-FFF2-40B4-BE49-F238E27FC236}">
                  <a16:creationId xmlns:a16="http://schemas.microsoft.com/office/drawing/2014/main" id="{46F0BCF3-2B0D-A344-AC13-465E749AABB0}"/>
                </a:ext>
              </a:extLst>
            </p:cNvPr>
            <p:cNvSpPr txBox="1"/>
            <p:nvPr/>
          </p:nvSpPr>
          <p:spPr>
            <a:xfrm>
              <a:off x="10643552" y="1721123"/>
              <a:ext cx="8516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IL-6</a:t>
              </a:r>
            </a:p>
          </p:txBody>
        </p:sp>
        <p:sp>
          <p:nvSpPr>
            <p:cNvPr id="266" name="Elipse 265">
              <a:extLst>
                <a:ext uri="{FF2B5EF4-FFF2-40B4-BE49-F238E27FC236}">
                  <a16:creationId xmlns:a16="http://schemas.microsoft.com/office/drawing/2014/main" id="{A0124822-6A8A-C240-8F3F-54D5069A339B}"/>
                </a:ext>
              </a:extLst>
            </p:cNvPr>
            <p:cNvSpPr>
              <a:spLocks/>
            </p:cNvSpPr>
            <p:nvPr/>
          </p:nvSpPr>
          <p:spPr>
            <a:xfrm>
              <a:off x="10969793" y="1552846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grpSp>
        <p:nvGrpSpPr>
          <p:cNvPr id="269" name="Grupo 268">
            <a:extLst>
              <a:ext uri="{FF2B5EF4-FFF2-40B4-BE49-F238E27FC236}">
                <a16:creationId xmlns:a16="http://schemas.microsoft.com/office/drawing/2014/main" id="{F48DF5F2-C4E8-7E4D-B379-3B56D932CB63}"/>
              </a:ext>
            </a:extLst>
          </p:cNvPr>
          <p:cNvGrpSpPr/>
          <p:nvPr/>
        </p:nvGrpSpPr>
        <p:grpSpPr>
          <a:xfrm>
            <a:off x="9043531" y="4226436"/>
            <a:ext cx="984308" cy="489194"/>
            <a:chOff x="8608829" y="2124312"/>
            <a:chExt cx="984308" cy="489194"/>
          </a:xfrm>
        </p:grpSpPr>
        <p:sp>
          <p:nvSpPr>
            <p:cNvPr id="270" name="CuadroTexto 269">
              <a:extLst>
                <a:ext uri="{FF2B5EF4-FFF2-40B4-BE49-F238E27FC236}">
                  <a16:creationId xmlns:a16="http://schemas.microsoft.com/office/drawing/2014/main" id="{473EF9BC-AC6D-5744-87AF-31792F4AAD98}"/>
                </a:ext>
              </a:extLst>
            </p:cNvPr>
            <p:cNvSpPr txBox="1"/>
            <p:nvPr/>
          </p:nvSpPr>
          <p:spPr>
            <a:xfrm>
              <a:off x="8608829" y="2244174"/>
              <a:ext cx="9843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MCP-1</a:t>
              </a:r>
            </a:p>
          </p:txBody>
        </p:sp>
        <p:sp>
          <p:nvSpPr>
            <p:cNvPr id="271" name="Elipse 270">
              <a:extLst>
                <a:ext uri="{FF2B5EF4-FFF2-40B4-BE49-F238E27FC236}">
                  <a16:creationId xmlns:a16="http://schemas.microsoft.com/office/drawing/2014/main" id="{8DBF4C81-586E-1D4D-A9DD-9D916659605A}"/>
                </a:ext>
              </a:extLst>
            </p:cNvPr>
            <p:cNvSpPr>
              <a:spLocks/>
            </p:cNvSpPr>
            <p:nvPr/>
          </p:nvSpPr>
          <p:spPr>
            <a:xfrm>
              <a:off x="9005963" y="2124312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sp>
        <p:nvSpPr>
          <p:cNvPr id="272" name="Forma libre 271">
            <a:extLst>
              <a:ext uri="{FF2B5EF4-FFF2-40B4-BE49-F238E27FC236}">
                <a16:creationId xmlns:a16="http://schemas.microsoft.com/office/drawing/2014/main" id="{3C57F16D-6D29-934E-A05C-663309F2B118}"/>
              </a:ext>
            </a:extLst>
          </p:cNvPr>
          <p:cNvSpPr/>
          <p:nvPr/>
        </p:nvSpPr>
        <p:spPr>
          <a:xfrm rot="2907753">
            <a:off x="9565489" y="3855144"/>
            <a:ext cx="193786" cy="355755"/>
          </a:xfrm>
          <a:custGeom>
            <a:avLst/>
            <a:gdLst>
              <a:gd name="connsiteX0" fmla="*/ 533017 w 1223750"/>
              <a:gd name="connsiteY0" fmla="*/ 0 h 1657761"/>
              <a:gd name="connsiteX1" fmla="*/ 118576 w 1223750"/>
              <a:gd name="connsiteY1" fmla="*/ 171039 h 1657761"/>
              <a:gd name="connsiteX2" fmla="*/ 165 w 1223750"/>
              <a:gd name="connsiteY2" fmla="*/ 276294 h 1657761"/>
              <a:gd name="connsiteX3" fmla="*/ 111998 w 1223750"/>
              <a:gd name="connsiteY3" fmla="*/ 605215 h 1657761"/>
              <a:gd name="connsiteX4" fmla="*/ 671163 w 1223750"/>
              <a:gd name="connsiteY4" fmla="*/ 934135 h 1657761"/>
              <a:gd name="connsiteX5" fmla="*/ 1223750 w 1223750"/>
              <a:gd name="connsiteY5" fmla="*/ 1657761 h 1657761"/>
              <a:gd name="connsiteX6" fmla="*/ 1223750 w 1223750"/>
              <a:gd name="connsiteY6" fmla="*/ 1657761 h 1657761"/>
              <a:gd name="connsiteX0" fmla="*/ 538385 w 1229118"/>
              <a:gd name="connsiteY0" fmla="*/ 0 h 1657761"/>
              <a:gd name="connsiteX1" fmla="*/ 123944 w 1229118"/>
              <a:gd name="connsiteY1" fmla="*/ 171039 h 1657761"/>
              <a:gd name="connsiteX2" fmla="*/ 5533 w 1229118"/>
              <a:gd name="connsiteY2" fmla="*/ 276294 h 1657761"/>
              <a:gd name="connsiteX3" fmla="*/ 117366 w 1229118"/>
              <a:gd name="connsiteY3" fmla="*/ 605215 h 1657761"/>
              <a:gd name="connsiteX4" fmla="*/ 923741 w 1229118"/>
              <a:gd name="connsiteY4" fmla="*/ 976955 h 1657761"/>
              <a:gd name="connsiteX5" fmla="*/ 1229118 w 1229118"/>
              <a:gd name="connsiteY5" fmla="*/ 1657761 h 1657761"/>
              <a:gd name="connsiteX6" fmla="*/ 1229118 w 1229118"/>
              <a:gd name="connsiteY6" fmla="*/ 1657761 h 1657761"/>
              <a:gd name="connsiteX0" fmla="*/ 552783 w 1243516"/>
              <a:gd name="connsiteY0" fmla="*/ 0 h 1657761"/>
              <a:gd name="connsiteX1" fmla="*/ 138342 w 1243516"/>
              <a:gd name="connsiteY1" fmla="*/ 171039 h 1657761"/>
              <a:gd name="connsiteX2" fmla="*/ 19931 w 1243516"/>
              <a:gd name="connsiteY2" fmla="*/ 276294 h 1657761"/>
              <a:gd name="connsiteX3" fmla="*/ 99866 w 1243516"/>
              <a:gd name="connsiteY3" fmla="*/ 807079 h 1657761"/>
              <a:gd name="connsiteX4" fmla="*/ 938139 w 1243516"/>
              <a:gd name="connsiteY4" fmla="*/ 976955 h 1657761"/>
              <a:gd name="connsiteX5" fmla="*/ 1243516 w 1243516"/>
              <a:gd name="connsiteY5" fmla="*/ 1657761 h 1657761"/>
              <a:gd name="connsiteX6" fmla="*/ 1243516 w 1243516"/>
              <a:gd name="connsiteY6" fmla="*/ 1657761 h 1657761"/>
              <a:gd name="connsiteX0" fmla="*/ 622102 w 1312835"/>
              <a:gd name="connsiteY0" fmla="*/ 0 h 1657761"/>
              <a:gd name="connsiteX1" fmla="*/ 207661 w 1312835"/>
              <a:gd name="connsiteY1" fmla="*/ 171039 h 1657761"/>
              <a:gd name="connsiteX2" fmla="*/ 1532 w 1312835"/>
              <a:gd name="connsiteY2" fmla="*/ 441455 h 1657761"/>
              <a:gd name="connsiteX3" fmla="*/ 169185 w 1312835"/>
              <a:gd name="connsiteY3" fmla="*/ 807079 h 1657761"/>
              <a:gd name="connsiteX4" fmla="*/ 1007458 w 1312835"/>
              <a:gd name="connsiteY4" fmla="*/ 976955 h 1657761"/>
              <a:gd name="connsiteX5" fmla="*/ 1312835 w 1312835"/>
              <a:gd name="connsiteY5" fmla="*/ 1657761 h 1657761"/>
              <a:gd name="connsiteX6" fmla="*/ 1312835 w 1312835"/>
              <a:gd name="connsiteY6" fmla="*/ 1657761 h 1657761"/>
              <a:gd name="connsiteX0" fmla="*/ 622102 w 1312835"/>
              <a:gd name="connsiteY0" fmla="*/ 0 h 1657761"/>
              <a:gd name="connsiteX1" fmla="*/ 207661 w 1312835"/>
              <a:gd name="connsiteY1" fmla="*/ 195508 h 1657761"/>
              <a:gd name="connsiteX2" fmla="*/ 1532 w 1312835"/>
              <a:gd name="connsiteY2" fmla="*/ 441455 h 1657761"/>
              <a:gd name="connsiteX3" fmla="*/ 169185 w 1312835"/>
              <a:gd name="connsiteY3" fmla="*/ 807079 h 1657761"/>
              <a:gd name="connsiteX4" fmla="*/ 1007458 w 1312835"/>
              <a:gd name="connsiteY4" fmla="*/ 976955 h 1657761"/>
              <a:gd name="connsiteX5" fmla="*/ 1312835 w 1312835"/>
              <a:gd name="connsiteY5" fmla="*/ 1657761 h 1657761"/>
              <a:gd name="connsiteX6" fmla="*/ 1312835 w 1312835"/>
              <a:gd name="connsiteY6" fmla="*/ 1657761 h 1657761"/>
              <a:gd name="connsiteX0" fmla="*/ 380269 w 1312835"/>
              <a:gd name="connsiteY0" fmla="*/ 3 h 2314549"/>
              <a:gd name="connsiteX1" fmla="*/ 207661 w 1312835"/>
              <a:gd name="connsiteY1" fmla="*/ 852296 h 2314549"/>
              <a:gd name="connsiteX2" fmla="*/ 1532 w 1312835"/>
              <a:gd name="connsiteY2" fmla="*/ 1098243 h 2314549"/>
              <a:gd name="connsiteX3" fmla="*/ 169185 w 1312835"/>
              <a:gd name="connsiteY3" fmla="*/ 1463867 h 2314549"/>
              <a:gd name="connsiteX4" fmla="*/ 1007458 w 1312835"/>
              <a:gd name="connsiteY4" fmla="*/ 1633743 h 2314549"/>
              <a:gd name="connsiteX5" fmla="*/ 1312835 w 1312835"/>
              <a:gd name="connsiteY5" fmla="*/ 2314549 h 2314549"/>
              <a:gd name="connsiteX6" fmla="*/ 1312835 w 1312835"/>
              <a:gd name="connsiteY6" fmla="*/ 2314549 h 2314549"/>
              <a:gd name="connsiteX0" fmla="*/ 380167 w 1312733"/>
              <a:gd name="connsiteY0" fmla="*/ 3 h 2314549"/>
              <a:gd name="connsiteX1" fmla="*/ 104813 w 1312733"/>
              <a:gd name="connsiteY1" fmla="*/ 590538 h 2314549"/>
              <a:gd name="connsiteX2" fmla="*/ 1430 w 1312733"/>
              <a:gd name="connsiteY2" fmla="*/ 1098243 h 2314549"/>
              <a:gd name="connsiteX3" fmla="*/ 169083 w 1312733"/>
              <a:gd name="connsiteY3" fmla="*/ 1463867 h 2314549"/>
              <a:gd name="connsiteX4" fmla="*/ 1007356 w 1312733"/>
              <a:gd name="connsiteY4" fmla="*/ 1633743 h 2314549"/>
              <a:gd name="connsiteX5" fmla="*/ 1312733 w 1312733"/>
              <a:gd name="connsiteY5" fmla="*/ 2314549 h 2314549"/>
              <a:gd name="connsiteX6" fmla="*/ 1312733 w 1312733"/>
              <a:gd name="connsiteY6" fmla="*/ 2314549 h 2314549"/>
              <a:gd name="connsiteX0" fmla="*/ 348444 w 1312625"/>
              <a:gd name="connsiteY0" fmla="*/ -2 h 2417670"/>
              <a:gd name="connsiteX1" fmla="*/ 104705 w 1312625"/>
              <a:gd name="connsiteY1" fmla="*/ 693659 h 2417670"/>
              <a:gd name="connsiteX2" fmla="*/ 1322 w 1312625"/>
              <a:gd name="connsiteY2" fmla="*/ 1201364 h 2417670"/>
              <a:gd name="connsiteX3" fmla="*/ 168975 w 1312625"/>
              <a:gd name="connsiteY3" fmla="*/ 1566988 h 2417670"/>
              <a:gd name="connsiteX4" fmla="*/ 1007248 w 1312625"/>
              <a:gd name="connsiteY4" fmla="*/ 1736864 h 2417670"/>
              <a:gd name="connsiteX5" fmla="*/ 1312625 w 1312625"/>
              <a:gd name="connsiteY5" fmla="*/ 2417670 h 2417670"/>
              <a:gd name="connsiteX6" fmla="*/ 1312625 w 1312625"/>
              <a:gd name="connsiteY6" fmla="*/ 2417670 h 2417670"/>
              <a:gd name="connsiteX0" fmla="*/ 348444 w 1312625"/>
              <a:gd name="connsiteY0" fmla="*/ -2 h 2417670"/>
              <a:gd name="connsiteX1" fmla="*/ 104705 w 1312625"/>
              <a:gd name="connsiteY1" fmla="*/ 693659 h 2417670"/>
              <a:gd name="connsiteX2" fmla="*/ 1322 w 1312625"/>
              <a:gd name="connsiteY2" fmla="*/ 1201364 h 2417670"/>
              <a:gd name="connsiteX3" fmla="*/ 168975 w 1312625"/>
              <a:gd name="connsiteY3" fmla="*/ 1566988 h 2417670"/>
              <a:gd name="connsiteX4" fmla="*/ 1007248 w 1312625"/>
              <a:gd name="connsiteY4" fmla="*/ 1736864 h 2417670"/>
              <a:gd name="connsiteX5" fmla="*/ 1312625 w 1312625"/>
              <a:gd name="connsiteY5" fmla="*/ 2417670 h 2417670"/>
              <a:gd name="connsiteX6" fmla="*/ 1312625 w 1312625"/>
              <a:gd name="connsiteY6" fmla="*/ 2417670 h 24176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312625" h="2417670">
                <a:moveTo>
                  <a:pt x="348444" y="-2"/>
                </a:moveTo>
                <a:cubicBezTo>
                  <a:pt x="270983" y="311560"/>
                  <a:pt x="162559" y="493431"/>
                  <a:pt x="104705" y="693659"/>
                </a:cubicBezTo>
                <a:cubicBezTo>
                  <a:pt x="46851" y="893887"/>
                  <a:pt x="-9390" y="1055809"/>
                  <a:pt x="1322" y="1201364"/>
                </a:cubicBezTo>
                <a:cubicBezTo>
                  <a:pt x="12034" y="1346919"/>
                  <a:pt x="1321" y="1477738"/>
                  <a:pt x="168975" y="1566988"/>
                </a:cubicBezTo>
                <a:cubicBezTo>
                  <a:pt x="336629" y="1656238"/>
                  <a:pt x="816640" y="1595084"/>
                  <a:pt x="1007248" y="1736864"/>
                </a:cubicBezTo>
                <a:cubicBezTo>
                  <a:pt x="1197856" y="1878644"/>
                  <a:pt x="1261729" y="2304202"/>
                  <a:pt x="1312625" y="2417670"/>
                </a:cubicBezTo>
                <a:lnTo>
                  <a:pt x="1312625" y="2417670"/>
                </a:lnTo>
              </a:path>
            </a:pathLst>
          </a:custGeom>
          <a:noFill/>
          <a:ln w="28575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276" name="Conector recto 275">
            <a:extLst>
              <a:ext uri="{FF2B5EF4-FFF2-40B4-BE49-F238E27FC236}">
                <a16:creationId xmlns:a16="http://schemas.microsoft.com/office/drawing/2014/main" id="{487093CE-207E-CB40-969F-93EAB6CA3CA9}"/>
              </a:ext>
            </a:extLst>
          </p:cNvPr>
          <p:cNvCxnSpPr>
            <a:cxnSpLocks/>
          </p:cNvCxnSpPr>
          <p:nvPr/>
        </p:nvCxnSpPr>
        <p:spPr>
          <a:xfrm flipH="1" flipV="1">
            <a:off x="8369207" y="6682793"/>
            <a:ext cx="285479" cy="248405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Nube 280">
            <a:extLst>
              <a:ext uri="{FF2B5EF4-FFF2-40B4-BE49-F238E27FC236}">
                <a16:creationId xmlns:a16="http://schemas.microsoft.com/office/drawing/2014/main" id="{31B34EFF-46D4-234C-917E-9EC4FCEDA5A7}"/>
              </a:ext>
            </a:extLst>
          </p:cNvPr>
          <p:cNvSpPr/>
          <p:nvPr/>
        </p:nvSpPr>
        <p:spPr>
          <a:xfrm>
            <a:off x="9948999" y="6744125"/>
            <a:ext cx="256478" cy="245327"/>
          </a:xfrm>
          <a:prstGeom prst="cloud">
            <a:avLst/>
          </a:prstGeom>
          <a:solidFill>
            <a:schemeClr val="accent2">
              <a:lumMod val="60000"/>
              <a:lumOff val="40000"/>
              <a:alpha val="65098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82" name="Conector recto 281">
            <a:extLst>
              <a:ext uri="{FF2B5EF4-FFF2-40B4-BE49-F238E27FC236}">
                <a16:creationId xmlns:a16="http://schemas.microsoft.com/office/drawing/2014/main" id="{33CF53A2-79AE-9D48-8EFB-D122836FE72A}"/>
              </a:ext>
            </a:extLst>
          </p:cNvPr>
          <p:cNvCxnSpPr>
            <a:cxnSpLocks/>
          </p:cNvCxnSpPr>
          <p:nvPr/>
        </p:nvCxnSpPr>
        <p:spPr>
          <a:xfrm>
            <a:off x="9537679" y="7322242"/>
            <a:ext cx="419077" cy="241783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4" name="Nube 283">
            <a:extLst>
              <a:ext uri="{FF2B5EF4-FFF2-40B4-BE49-F238E27FC236}">
                <a16:creationId xmlns:a16="http://schemas.microsoft.com/office/drawing/2014/main" id="{F6F34F7D-B13B-9045-9003-6F7DEFD98C12}"/>
              </a:ext>
            </a:extLst>
          </p:cNvPr>
          <p:cNvSpPr/>
          <p:nvPr/>
        </p:nvSpPr>
        <p:spPr>
          <a:xfrm>
            <a:off x="9930429" y="7006155"/>
            <a:ext cx="256478" cy="245327"/>
          </a:xfrm>
          <a:prstGeom prst="cloud">
            <a:avLst/>
          </a:prstGeom>
          <a:solidFill>
            <a:schemeClr val="accent2">
              <a:lumMod val="60000"/>
              <a:lumOff val="40000"/>
              <a:alpha val="65098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85" name="Imagen 284">
            <a:extLst>
              <a:ext uri="{FF2B5EF4-FFF2-40B4-BE49-F238E27FC236}">
                <a16:creationId xmlns:a16="http://schemas.microsoft.com/office/drawing/2014/main" id="{31E52177-12D2-3A4A-91D5-90B396BF1AF3}"/>
              </a:ext>
            </a:extLst>
          </p:cNvPr>
          <p:cNvPicPr>
            <a:picLocks noChangeAspect="1"/>
          </p:cNvPicPr>
          <p:nvPr/>
        </p:nvPicPr>
        <p:blipFill>
          <a:blip r:embed="rId1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 rot="20342056">
            <a:off x="10005335" y="7243829"/>
            <a:ext cx="540000" cy="510758"/>
          </a:xfrm>
          <a:prstGeom prst="rect">
            <a:avLst/>
          </a:prstGeom>
        </p:spPr>
      </p:pic>
      <p:cxnSp>
        <p:nvCxnSpPr>
          <p:cNvPr id="286" name="Conector recto 285">
            <a:extLst>
              <a:ext uri="{FF2B5EF4-FFF2-40B4-BE49-F238E27FC236}">
                <a16:creationId xmlns:a16="http://schemas.microsoft.com/office/drawing/2014/main" id="{43F636CC-3AD5-0A48-89B0-6BD9EEF7CDC7}"/>
              </a:ext>
            </a:extLst>
          </p:cNvPr>
          <p:cNvCxnSpPr>
            <a:cxnSpLocks/>
          </p:cNvCxnSpPr>
          <p:nvPr/>
        </p:nvCxnSpPr>
        <p:spPr>
          <a:xfrm flipV="1">
            <a:off x="9520077" y="6993871"/>
            <a:ext cx="373521" cy="163693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4" name="Grupo 293">
            <a:extLst>
              <a:ext uri="{FF2B5EF4-FFF2-40B4-BE49-F238E27FC236}">
                <a16:creationId xmlns:a16="http://schemas.microsoft.com/office/drawing/2014/main" id="{7A0627CD-C937-CD44-A0E8-1421609A99D9}"/>
              </a:ext>
            </a:extLst>
          </p:cNvPr>
          <p:cNvGrpSpPr/>
          <p:nvPr/>
        </p:nvGrpSpPr>
        <p:grpSpPr>
          <a:xfrm rot="21255999">
            <a:off x="7632830" y="3209348"/>
            <a:ext cx="222395" cy="1309567"/>
            <a:chOff x="12324113" y="1992529"/>
            <a:chExt cx="222395" cy="466053"/>
          </a:xfrm>
        </p:grpSpPr>
        <p:cxnSp>
          <p:nvCxnSpPr>
            <p:cNvPr id="295" name="Conector recto 294">
              <a:extLst>
                <a:ext uri="{FF2B5EF4-FFF2-40B4-BE49-F238E27FC236}">
                  <a16:creationId xmlns:a16="http://schemas.microsoft.com/office/drawing/2014/main" id="{648C80CD-8FAC-844E-B764-0682343D293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35310" y="1992983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Conector recto 295">
              <a:extLst>
                <a:ext uri="{FF2B5EF4-FFF2-40B4-BE49-F238E27FC236}">
                  <a16:creationId xmlns:a16="http://schemas.microsoft.com/office/drawing/2014/main" id="{D4A333A9-2F59-6D4D-A97A-A3514A81562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24113" y="1992529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04" name="Conector recto 303">
            <a:extLst>
              <a:ext uri="{FF2B5EF4-FFF2-40B4-BE49-F238E27FC236}">
                <a16:creationId xmlns:a16="http://schemas.microsoft.com/office/drawing/2014/main" id="{55C10BB6-79B2-B347-8567-8A1805FAC960}"/>
              </a:ext>
            </a:extLst>
          </p:cNvPr>
          <p:cNvCxnSpPr>
            <a:cxnSpLocks/>
          </p:cNvCxnSpPr>
          <p:nvPr/>
        </p:nvCxnSpPr>
        <p:spPr>
          <a:xfrm flipH="1">
            <a:off x="6292649" y="5991111"/>
            <a:ext cx="1755853" cy="1082722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Conector recto 306">
            <a:extLst>
              <a:ext uri="{FF2B5EF4-FFF2-40B4-BE49-F238E27FC236}">
                <a16:creationId xmlns:a16="http://schemas.microsoft.com/office/drawing/2014/main" id="{43432432-9B90-4345-85B8-40272ADBE0EF}"/>
              </a:ext>
            </a:extLst>
          </p:cNvPr>
          <p:cNvCxnSpPr>
            <a:cxnSpLocks/>
          </p:cNvCxnSpPr>
          <p:nvPr/>
        </p:nvCxnSpPr>
        <p:spPr>
          <a:xfrm flipH="1" flipV="1">
            <a:off x="6301845" y="7462392"/>
            <a:ext cx="340937" cy="286164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5" name="CuadroTexto 314">
            <a:extLst>
              <a:ext uri="{FF2B5EF4-FFF2-40B4-BE49-F238E27FC236}">
                <a16:creationId xmlns:a16="http://schemas.microsoft.com/office/drawing/2014/main" id="{6E85BDA9-14A5-124E-A346-634C7E13890F}"/>
              </a:ext>
            </a:extLst>
          </p:cNvPr>
          <p:cNvSpPr txBox="1"/>
          <p:nvPr/>
        </p:nvSpPr>
        <p:spPr>
          <a:xfrm>
            <a:off x="5097449" y="5697248"/>
            <a:ext cx="1125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800" b="1" dirty="0">
                <a:solidFill>
                  <a:schemeClr val="accent2"/>
                </a:solidFill>
              </a:rPr>
              <a:t>IL-1⍺/β</a:t>
            </a:r>
          </a:p>
        </p:txBody>
      </p:sp>
      <p:sp>
        <p:nvSpPr>
          <p:cNvPr id="316" name="CuadroTexto 315">
            <a:extLst>
              <a:ext uri="{FF2B5EF4-FFF2-40B4-BE49-F238E27FC236}">
                <a16:creationId xmlns:a16="http://schemas.microsoft.com/office/drawing/2014/main" id="{79D30096-F953-A04E-880D-CC9F8896FD1C}"/>
              </a:ext>
            </a:extLst>
          </p:cNvPr>
          <p:cNvSpPr txBox="1"/>
          <p:nvPr/>
        </p:nvSpPr>
        <p:spPr>
          <a:xfrm>
            <a:off x="5280273" y="5434596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TNF-⍺</a:t>
            </a:r>
          </a:p>
        </p:txBody>
      </p:sp>
      <p:pic>
        <p:nvPicPr>
          <p:cNvPr id="317" name="Imagen 316">
            <a:extLst>
              <a:ext uri="{FF2B5EF4-FFF2-40B4-BE49-F238E27FC236}">
                <a16:creationId xmlns:a16="http://schemas.microsoft.com/office/drawing/2014/main" id="{A0CE9BC8-DF79-F842-97D3-8D8591815178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schemeClr val="accent4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 rot="5400000">
            <a:off x="4897758" y="1030807"/>
            <a:ext cx="1525175" cy="1106178"/>
          </a:xfrm>
          <a:prstGeom prst="rect">
            <a:avLst/>
          </a:prstGeom>
        </p:spPr>
      </p:pic>
      <p:pic>
        <p:nvPicPr>
          <p:cNvPr id="319" name="Imagen 318">
            <a:extLst>
              <a:ext uri="{FF2B5EF4-FFF2-40B4-BE49-F238E27FC236}">
                <a16:creationId xmlns:a16="http://schemas.microsoft.com/office/drawing/2014/main" id="{7FABCA5A-C990-364C-85E3-1461647CB18A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schemeClr val="accent4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 rot="5400000">
            <a:off x="4897758" y="2546204"/>
            <a:ext cx="1525175" cy="1106178"/>
          </a:xfrm>
          <a:prstGeom prst="rect">
            <a:avLst/>
          </a:prstGeom>
        </p:spPr>
      </p:pic>
      <p:pic>
        <p:nvPicPr>
          <p:cNvPr id="320" name="Imagen 319">
            <a:extLst>
              <a:ext uri="{FF2B5EF4-FFF2-40B4-BE49-F238E27FC236}">
                <a16:creationId xmlns:a16="http://schemas.microsoft.com/office/drawing/2014/main" id="{55AD5282-CA97-EF41-A73B-753541EBEF94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schemeClr val="accent4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 rot="5400000">
            <a:off x="4897758" y="4067040"/>
            <a:ext cx="1525175" cy="1106178"/>
          </a:xfrm>
          <a:prstGeom prst="rect">
            <a:avLst/>
          </a:prstGeom>
        </p:spPr>
      </p:pic>
      <p:sp>
        <p:nvSpPr>
          <p:cNvPr id="324" name="CuadroTexto 323">
            <a:extLst>
              <a:ext uri="{FF2B5EF4-FFF2-40B4-BE49-F238E27FC236}">
                <a16:creationId xmlns:a16="http://schemas.microsoft.com/office/drawing/2014/main" id="{D37CAADA-3BB2-BE4C-A854-A10F6CAFFB5D}"/>
              </a:ext>
            </a:extLst>
          </p:cNvPr>
          <p:cNvSpPr txBox="1"/>
          <p:nvPr/>
        </p:nvSpPr>
        <p:spPr>
          <a:xfrm>
            <a:off x="5097449" y="7110873"/>
            <a:ext cx="11257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b="1" dirty="0">
                <a:solidFill>
                  <a:schemeClr val="accent2"/>
                </a:solidFill>
              </a:rPr>
              <a:t>IL-1⍺/β</a:t>
            </a:r>
          </a:p>
        </p:txBody>
      </p:sp>
      <p:sp>
        <p:nvSpPr>
          <p:cNvPr id="325" name="CuadroTexto 324">
            <a:extLst>
              <a:ext uri="{FF2B5EF4-FFF2-40B4-BE49-F238E27FC236}">
                <a16:creationId xmlns:a16="http://schemas.microsoft.com/office/drawing/2014/main" id="{B70FA258-7166-8C45-B19D-C54D41420590}"/>
              </a:ext>
            </a:extLst>
          </p:cNvPr>
          <p:cNvSpPr txBox="1"/>
          <p:nvPr/>
        </p:nvSpPr>
        <p:spPr>
          <a:xfrm>
            <a:off x="5280273" y="6909181"/>
            <a:ext cx="6960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chemeClr val="accent2"/>
                </a:solidFill>
              </a:rPr>
              <a:t>TNF-⍺</a:t>
            </a:r>
          </a:p>
        </p:txBody>
      </p:sp>
      <p:sp>
        <p:nvSpPr>
          <p:cNvPr id="326" name="CuadroTexto 325">
            <a:extLst>
              <a:ext uri="{FF2B5EF4-FFF2-40B4-BE49-F238E27FC236}">
                <a16:creationId xmlns:a16="http://schemas.microsoft.com/office/drawing/2014/main" id="{78999F82-594B-8A46-A103-C386E5828267}"/>
              </a:ext>
            </a:extLst>
          </p:cNvPr>
          <p:cNvSpPr txBox="1"/>
          <p:nvPr/>
        </p:nvSpPr>
        <p:spPr>
          <a:xfrm>
            <a:off x="5097449" y="9604924"/>
            <a:ext cx="11257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b="1" dirty="0">
                <a:solidFill>
                  <a:schemeClr val="accent2"/>
                </a:solidFill>
              </a:rPr>
              <a:t>IL-1⍺/β</a:t>
            </a:r>
          </a:p>
        </p:txBody>
      </p:sp>
      <p:sp>
        <p:nvSpPr>
          <p:cNvPr id="327" name="CuadroTexto 326">
            <a:extLst>
              <a:ext uri="{FF2B5EF4-FFF2-40B4-BE49-F238E27FC236}">
                <a16:creationId xmlns:a16="http://schemas.microsoft.com/office/drawing/2014/main" id="{0B7DB965-6E95-1F4D-8FC7-6F88532663DA}"/>
              </a:ext>
            </a:extLst>
          </p:cNvPr>
          <p:cNvSpPr txBox="1"/>
          <p:nvPr/>
        </p:nvSpPr>
        <p:spPr>
          <a:xfrm>
            <a:off x="5280273" y="9410993"/>
            <a:ext cx="6960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chemeClr val="accent2"/>
                </a:solidFill>
              </a:rPr>
              <a:t>TNF-⍺</a:t>
            </a:r>
          </a:p>
        </p:txBody>
      </p:sp>
      <p:pic>
        <p:nvPicPr>
          <p:cNvPr id="332" name="Imagen 331">
            <a:extLst>
              <a:ext uri="{FF2B5EF4-FFF2-40B4-BE49-F238E27FC236}">
                <a16:creationId xmlns:a16="http://schemas.microsoft.com/office/drawing/2014/main" id="{CD6A5E9C-6111-3B44-9B29-6E8114DDCA0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482166" y="5879715"/>
            <a:ext cx="468000" cy="433050"/>
          </a:xfrm>
          <a:prstGeom prst="rect">
            <a:avLst/>
          </a:prstGeom>
        </p:spPr>
      </p:pic>
      <p:cxnSp>
        <p:nvCxnSpPr>
          <p:cNvPr id="334" name="Conector recto 333">
            <a:extLst>
              <a:ext uri="{FF2B5EF4-FFF2-40B4-BE49-F238E27FC236}">
                <a16:creationId xmlns:a16="http://schemas.microsoft.com/office/drawing/2014/main" id="{588CFE60-E77E-9647-A5A2-951A43F7BCE4}"/>
              </a:ext>
            </a:extLst>
          </p:cNvPr>
          <p:cNvCxnSpPr>
            <a:cxnSpLocks/>
          </p:cNvCxnSpPr>
          <p:nvPr/>
        </p:nvCxnSpPr>
        <p:spPr>
          <a:xfrm flipH="1" flipV="1">
            <a:off x="7466560" y="6958185"/>
            <a:ext cx="292095" cy="35686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6" name="Imagen 335">
            <a:extLst>
              <a:ext uri="{FF2B5EF4-FFF2-40B4-BE49-F238E27FC236}">
                <a16:creationId xmlns:a16="http://schemas.microsoft.com/office/drawing/2014/main" id="{E295E422-E1D3-1349-A7AB-A69BA30C5CC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5400000">
            <a:off x="5814566" y="6477360"/>
            <a:ext cx="1149843" cy="338793"/>
          </a:xfrm>
          <a:prstGeom prst="rect">
            <a:avLst/>
          </a:prstGeom>
        </p:spPr>
      </p:pic>
      <p:pic>
        <p:nvPicPr>
          <p:cNvPr id="337" name="Imagen 336">
            <a:extLst>
              <a:ext uri="{FF2B5EF4-FFF2-40B4-BE49-F238E27FC236}">
                <a16:creationId xmlns:a16="http://schemas.microsoft.com/office/drawing/2014/main" id="{84B5652B-C71B-8041-B08B-E291D759C41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244637" y="6671234"/>
            <a:ext cx="324000" cy="299804"/>
          </a:xfrm>
          <a:prstGeom prst="rect">
            <a:avLst/>
          </a:prstGeom>
        </p:spPr>
      </p:pic>
      <p:pic>
        <p:nvPicPr>
          <p:cNvPr id="339" name="Imagen 338">
            <a:extLst>
              <a:ext uri="{FF2B5EF4-FFF2-40B4-BE49-F238E27FC236}">
                <a16:creationId xmlns:a16="http://schemas.microsoft.com/office/drawing/2014/main" id="{6E8BE695-B646-9D46-ACE9-F8A8CF38DBA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rot="18102229">
            <a:off x="6232445" y="7817139"/>
            <a:ext cx="324000" cy="299804"/>
          </a:xfrm>
          <a:prstGeom prst="rect">
            <a:avLst/>
          </a:prstGeom>
        </p:spPr>
      </p:pic>
      <p:pic>
        <p:nvPicPr>
          <p:cNvPr id="341" name="Imagen 340">
            <a:extLst>
              <a:ext uri="{FF2B5EF4-FFF2-40B4-BE49-F238E27FC236}">
                <a16:creationId xmlns:a16="http://schemas.microsoft.com/office/drawing/2014/main" id="{EA4AE74F-275C-E74E-8BFD-0A7E0013845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rot="12559692">
            <a:off x="6289557" y="8901150"/>
            <a:ext cx="324000" cy="299804"/>
          </a:xfrm>
          <a:prstGeom prst="rect">
            <a:avLst/>
          </a:prstGeom>
        </p:spPr>
      </p:pic>
      <p:pic>
        <p:nvPicPr>
          <p:cNvPr id="343" name="Imagen 342">
            <a:extLst>
              <a:ext uri="{FF2B5EF4-FFF2-40B4-BE49-F238E27FC236}">
                <a16:creationId xmlns:a16="http://schemas.microsoft.com/office/drawing/2014/main" id="{A0E66EB4-A2F9-3744-9856-358FAD9DCFE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523066" y="9184282"/>
            <a:ext cx="468000" cy="433050"/>
          </a:xfrm>
          <a:prstGeom prst="rect">
            <a:avLst/>
          </a:prstGeom>
        </p:spPr>
      </p:pic>
      <p:cxnSp>
        <p:nvCxnSpPr>
          <p:cNvPr id="344" name="Conector recto 343">
            <a:extLst>
              <a:ext uri="{FF2B5EF4-FFF2-40B4-BE49-F238E27FC236}">
                <a16:creationId xmlns:a16="http://schemas.microsoft.com/office/drawing/2014/main" id="{CBB1CA74-AA59-9247-AF1F-764D7EC074B3}"/>
              </a:ext>
            </a:extLst>
          </p:cNvPr>
          <p:cNvCxnSpPr>
            <a:cxnSpLocks/>
          </p:cNvCxnSpPr>
          <p:nvPr/>
        </p:nvCxnSpPr>
        <p:spPr>
          <a:xfrm flipV="1">
            <a:off x="5808255" y="7924547"/>
            <a:ext cx="373521" cy="163693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6" name="Imagen 345">
            <a:extLst>
              <a:ext uri="{FF2B5EF4-FFF2-40B4-BE49-F238E27FC236}">
                <a16:creationId xmlns:a16="http://schemas.microsoft.com/office/drawing/2014/main" id="{27A6955D-B59B-B84E-872A-067A187B85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12220341" y="5545960"/>
            <a:ext cx="1522115" cy="1126343"/>
          </a:xfrm>
          <a:prstGeom prst="rect">
            <a:avLst/>
          </a:prstGeom>
        </p:spPr>
      </p:pic>
      <p:pic>
        <p:nvPicPr>
          <p:cNvPr id="347" name="Imagen 346">
            <a:extLst>
              <a:ext uri="{FF2B5EF4-FFF2-40B4-BE49-F238E27FC236}">
                <a16:creationId xmlns:a16="http://schemas.microsoft.com/office/drawing/2014/main" id="{287ACD75-1741-374D-B2E8-6A944F9CE7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12220341" y="7066796"/>
            <a:ext cx="1522115" cy="1126343"/>
          </a:xfrm>
          <a:prstGeom prst="rect">
            <a:avLst/>
          </a:prstGeom>
        </p:spPr>
      </p:pic>
      <p:pic>
        <p:nvPicPr>
          <p:cNvPr id="348" name="Imagen 347">
            <a:extLst>
              <a:ext uri="{FF2B5EF4-FFF2-40B4-BE49-F238E27FC236}">
                <a16:creationId xmlns:a16="http://schemas.microsoft.com/office/drawing/2014/main" id="{C505EECF-1811-F341-8177-263D792FFC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12220341" y="8573611"/>
            <a:ext cx="1522115" cy="1126343"/>
          </a:xfrm>
          <a:prstGeom prst="rect">
            <a:avLst/>
          </a:prstGeom>
        </p:spPr>
      </p:pic>
      <p:sp>
        <p:nvSpPr>
          <p:cNvPr id="352" name="Elipse 351">
            <a:extLst>
              <a:ext uri="{FF2B5EF4-FFF2-40B4-BE49-F238E27FC236}">
                <a16:creationId xmlns:a16="http://schemas.microsoft.com/office/drawing/2014/main" id="{07283F49-40D6-7C4E-AB12-867D5D2D76A6}"/>
              </a:ext>
            </a:extLst>
          </p:cNvPr>
          <p:cNvSpPr>
            <a:spLocks/>
          </p:cNvSpPr>
          <p:nvPr/>
        </p:nvSpPr>
        <p:spPr>
          <a:xfrm rot="16200000">
            <a:off x="12279181" y="6825885"/>
            <a:ext cx="180000" cy="72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5" name="CuadroTexto 344">
            <a:extLst>
              <a:ext uri="{FF2B5EF4-FFF2-40B4-BE49-F238E27FC236}">
                <a16:creationId xmlns:a16="http://schemas.microsoft.com/office/drawing/2014/main" id="{65A2B866-BFEA-474E-93BE-D84860F65242}"/>
              </a:ext>
            </a:extLst>
          </p:cNvPr>
          <p:cNvSpPr txBox="1"/>
          <p:nvPr/>
        </p:nvSpPr>
        <p:spPr>
          <a:xfrm>
            <a:off x="12489479" y="6909683"/>
            <a:ext cx="867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rgbClr val="945200"/>
                </a:solidFill>
              </a:rPr>
              <a:t>￪ p-SEL</a:t>
            </a:r>
          </a:p>
        </p:txBody>
      </p:sp>
      <p:cxnSp>
        <p:nvCxnSpPr>
          <p:cNvPr id="353" name="Conector recto 352">
            <a:extLst>
              <a:ext uri="{FF2B5EF4-FFF2-40B4-BE49-F238E27FC236}">
                <a16:creationId xmlns:a16="http://schemas.microsoft.com/office/drawing/2014/main" id="{ABBE237A-7956-FE4F-A3C7-46D9BC9EE730}"/>
              </a:ext>
            </a:extLst>
          </p:cNvPr>
          <p:cNvCxnSpPr>
            <a:cxnSpLocks/>
          </p:cNvCxnSpPr>
          <p:nvPr/>
        </p:nvCxnSpPr>
        <p:spPr>
          <a:xfrm>
            <a:off x="10248306" y="7001414"/>
            <a:ext cx="1800394" cy="407421"/>
          </a:xfrm>
          <a:prstGeom prst="line">
            <a:avLst/>
          </a:prstGeom>
          <a:ln w="28575">
            <a:solidFill>
              <a:srgbClr val="C00000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6" name="Nube 355">
            <a:extLst>
              <a:ext uri="{FF2B5EF4-FFF2-40B4-BE49-F238E27FC236}">
                <a16:creationId xmlns:a16="http://schemas.microsoft.com/office/drawing/2014/main" id="{7FDCD064-31D1-284A-8820-54D32D5D5011}"/>
              </a:ext>
            </a:extLst>
          </p:cNvPr>
          <p:cNvSpPr/>
          <p:nvPr/>
        </p:nvSpPr>
        <p:spPr>
          <a:xfrm>
            <a:off x="10403728" y="6996225"/>
            <a:ext cx="256478" cy="245327"/>
          </a:xfrm>
          <a:prstGeom prst="cloud">
            <a:avLst/>
          </a:prstGeom>
          <a:solidFill>
            <a:schemeClr val="accent2">
              <a:lumMod val="60000"/>
              <a:lumOff val="40000"/>
              <a:alpha val="65098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7" name="Nube 356">
            <a:extLst>
              <a:ext uri="{FF2B5EF4-FFF2-40B4-BE49-F238E27FC236}">
                <a16:creationId xmlns:a16="http://schemas.microsoft.com/office/drawing/2014/main" id="{0A356227-00D5-914B-BCFD-E09FF51C607E}"/>
              </a:ext>
            </a:extLst>
          </p:cNvPr>
          <p:cNvSpPr/>
          <p:nvPr/>
        </p:nvSpPr>
        <p:spPr>
          <a:xfrm>
            <a:off x="10890322" y="7198302"/>
            <a:ext cx="256478" cy="245327"/>
          </a:xfrm>
          <a:prstGeom prst="cloud">
            <a:avLst/>
          </a:prstGeom>
          <a:solidFill>
            <a:schemeClr val="accent2">
              <a:lumMod val="60000"/>
              <a:lumOff val="40000"/>
              <a:alpha val="65098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8" name="Nube 357">
            <a:extLst>
              <a:ext uri="{FF2B5EF4-FFF2-40B4-BE49-F238E27FC236}">
                <a16:creationId xmlns:a16="http://schemas.microsoft.com/office/drawing/2014/main" id="{8F9C046D-37B1-784F-B474-5C6DDA8F08EE}"/>
              </a:ext>
            </a:extLst>
          </p:cNvPr>
          <p:cNvSpPr/>
          <p:nvPr/>
        </p:nvSpPr>
        <p:spPr>
          <a:xfrm>
            <a:off x="12068712" y="7240348"/>
            <a:ext cx="256478" cy="245327"/>
          </a:xfrm>
          <a:prstGeom prst="cloud">
            <a:avLst/>
          </a:prstGeom>
          <a:solidFill>
            <a:schemeClr val="accent2">
              <a:lumMod val="60000"/>
              <a:lumOff val="40000"/>
              <a:alpha val="65098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9" name="Nube 358">
            <a:extLst>
              <a:ext uri="{FF2B5EF4-FFF2-40B4-BE49-F238E27FC236}">
                <a16:creationId xmlns:a16="http://schemas.microsoft.com/office/drawing/2014/main" id="{28F4613F-DAF9-9348-A7DD-A679C34414A2}"/>
              </a:ext>
            </a:extLst>
          </p:cNvPr>
          <p:cNvSpPr/>
          <p:nvPr/>
        </p:nvSpPr>
        <p:spPr>
          <a:xfrm>
            <a:off x="11368404" y="7102351"/>
            <a:ext cx="256478" cy="245327"/>
          </a:xfrm>
          <a:prstGeom prst="cloud">
            <a:avLst/>
          </a:prstGeom>
          <a:solidFill>
            <a:schemeClr val="accent2">
              <a:lumMod val="60000"/>
              <a:lumOff val="40000"/>
              <a:alpha val="65098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0" name="Nube 359">
            <a:extLst>
              <a:ext uri="{FF2B5EF4-FFF2-40B4-BE49-F238E27FC236}">
                <a16:creationId xmlns:a16="http://schemas.microsoft.com/office/drawing/2014/main" id="{FD5F1035-2074-1445-BA64-65F78D99FA01}"/>
              </a:ext>
            </a:extLst>
          </p:cNvPr>
          <p:cNvSpPr/>
          <p:nvPr/>
        </p:nvSpPr>
        <p:spPr>
          <a:xfrm>
            <a:off x="12048700" y="7457094"/>
            <a:ext cx="256478" cy="245327"/>
          </a:xfrm>
          <a:prstGeom prst="cloud">
            <a:avLst/>
          </a:prstGeom>
          <a:solidFill>
            <a:schemeClr val="accent2">
              <a:lumMod val="60000"/>
              <a:lumOff val="40000"/>
              <a:alpha val="65098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1" name="Nube 360">
            <a:extLst>
              <a:ext uri="{FF2B5EF4-FFF2-40B4-BE49-F238E27FC236}">
                <a16:creationId xmlns:a16="http://schemas.microsoft.com/office/drawing/2014/main" id="{FFA7B24B-E178-9142-899C-D1526DF93B08}"/>
              </a:ext>
            </a:extLst>
          </p:cNvPr>
          <p:cNvSpPr/>
          <p:nvPr/>
        </p:nvSpPr>
        <p:spPr>
          <a:xfrm>
            <a:off x="12256482" y="7342707"/>
            <a:ext cx="256478" cy="245327"/>
          </a:xfrm>
          <a:prstGeom prst="cloud">
            <a:avLst/>
          </a:prstGeom>
          <a:solidFill>
            <a:schemeClr val="accent2">
              <a:lumMod val="60000"/>
              <a:lumOff val="40000"/>
              <a:alpha val="65098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4" name="CuadroTexto 353">
            <a:extLst>
              <a:ext uri="{FF2B5EF4-FFF2-40B4-BE49-F238E27FC236}">
                <a16:creationId xmlns:a16="http://schemas.microsoft.com/office/drawing/2014/main" id="{A271FBBD-E6CA-DE4B-B740-FB1ABE7F7255}"/>
              </a:ext>
            </a:extLst>
          </p:cNvPr>
          <p:cNvSpPr txBox="1"/>
          <p:nvPr/>
        </p:nvSpPr>
        <p:spPr>
          <a:xfrm>
            <a:off x="10589776" y="6906762"/>
            <a:ext cx="10086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migration</a:t>
            </a:r>
            <a:endParaRPr lang="es-ES" sz="1600" b="1" dirty="0"/>
          </a:p>
        </p:txBody>
      </p:sp>
      <p:sp>
        <p:nvSpPr>
          <p:cNvPr id="370" name="Elipse 369">
            <a:extLst>
              <a:ext uri="{FF2B5EF4-FFF2-40B4-BE49-F238E27FC236}">
                <a16:creationId xmlns:a16="http://schemas.microsoft.com/office/drawing/2014/main" id="{54535CD3-AB01-F240-B9E8-D9EB472D1AB8}"/>
              </a:ext>
            </a:extLst>
          </p:cNvPr>
          <p:cNvSpPr>
            <a:spLocks/>
          </p:cNvSpPr>
          <p:nvPr/>
        </p:nvSpPr>
        <p:spPr>
          <a:xfrm rot="5400000" flipV="1">
            <a:off x="6136815" y="7870594"/>
            <a:ext cx="180000" cy="720000"/>
          </a:xfrm>
          <a:prstGeom prst="ellipse">
            <a:avLst/>
          </a:prstGeom>
          <a:solidFill>
            <a:srgbClr val="FFFF00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1" name="CuadroTexto 310">
            <a:extLst>
              <a:ext uri="{FF2B5EF4-FFF2-40B4-BE49-F238E27FC236}">
                <a16:creationId xmlns:a16="http://schemas.microsoft.com/office/drawing/2014/main" id="{7842CE06-9298-BD4D-97C2-95FB1494E4CB}"/>
              </a:ext>
            </a:extLst>
          </p:cNvPr>
          <p:cNvSpPr txBox="1"/>
          <p:nvPr/>
        </p:nvSpPr>
        <p:spPr>
          <a:xfrm>
            <a:off x="5198519" y="8006393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rgbClr val="945200"/>
                </a:solidFill>
              </a:rPr>
              <a:t>￪ e-SEL</a:t>
            </a:r>
          </a:p>
        </p:txBody>
      </p:sp>
      <p:pic>
        <p:nvPicPr>
          <p:cNvPr id="338" name="Imagen 337">
            <a:extLst>
              <a:ext uri="{FF2B5EF4-FFF2-40B4-BE49-F238E27FC236}">
                <a16:creationId xmlns:a16="http://schemas.microsoft.com/office/drawing/2014/main" id="{FBDE3446-A403-F84E-B42B-51525644AB0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5400000">
            <a:off x="5814566" y="7574497"/>
            <a:ext cx="1149843" cy="338793"/>
          </a:xfrm>
          <a:prstGeom prst="rect">
            <a:avLst/>
          </a:prstGeom>
        </p:spPr>
      </p:pic>
      <p:pic>
        <p:nvPicPr>
          <p:cNvPr id="340" name="Imagen 339">
            <a:extLst>
              <a:ext uri="{FF2B5EF4-FFF2-40B4-BE49-F238E27FC236}">
                <a16:creationId xmlns:a16="http://schemas.microsoft.com/office/drawing/2014/main" id="{FA4EB89E-A8B1-7F48-8616-BACF508C68F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5400000">
            <a:off x="5820061" y="8671618"/>
            <a:ext cx="1149843" cy="338793"/>
          </a:xfrm>
          <a:prstGeom prst="rect">
            <a:avLst/>
          </a:prstGeom>
        </p:spPr>
      </p:pic>
      <p:sp>
        <p:nvSpPr>
          <p:cNvPr id="371" name="Elipse 370">
            <a:extLst>
              <a:ext uri="{FF2B5EF4-FFF2-40B4-BE49-F238E27FC236}">
                <a16:creationId xmlns:a16="http://schemas.microsoft.com/office/drawing/2014/main" id="{E00658F2-082A-FD4F-B428-FE2E7DFFA2AC}"/>
              </a:ext>
            </a:extLst>
          </p:cNvPr>
          <p:cNvSpPr>
            <a:spLocks/>
          </p:cNvSpPr>
          <p:nvPr/>
        </p:nvSpPr>
        <p:spPr>
          <a:xfrm rot="5400000" flipV="1">
            <a:off x="12456237" y="4994529"/>
            <a:ext cx="180000" cy="720000"/>
          </a:xfrm>
          <a:prstGeom prst="ellipse">
            <a:avLst/>
          </a:prstGeom>
          <a:solidFill>
            <a:srgbClr val="FFFF00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2" name="Elipse 371">
            <a:extLst>
              <a:ext uri="{FF2B5EF4-FFF2-40B4-BE49-F238E27FC236}">
                <a16:creationId xmlns:a16="http://schemas.microsoft.com/office/drawing/2014/main" id="{41E4D69D-71E0-5E4E-8F19-C56B7DD2B62A}"/>
              </a:ext>
            </a:extLst>
          </p:cNvPr>
          <p:cNvSpPr>
            <a:spLocks/>
          </p:cNvSpPr>
          <p:nvPr/>
        </p:nvSpPr>
        <p:spPr>
          <a:xfrm rot="16200000">
            <a:off x="12482390" y="5148923"/>
            <a:ext cx="180000" cy="72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3" name="Elipse 372">
            <a:extLst>
              <a:ext uri="{FF2B5EF4-FFF2-40B4-BE49-F238E27FC236}">
                <a16:creationId xmlns:a16="http://schemas.microsoft.com/office/drawing/2014/main" id="{21DC367A-DA3E-5946-BA1F-80EFC32B7CAE}"/>
              </a:ext>
            </a:extLst>
          </p:cNvPr>
          <p:cNvSpPr>
            <a:spLocks/>
          </p:cNvSpPr>
          <p:nvPr/>
        </p:nvSpPr>
        <p:spPr>
          <a:xfrm rot="5400000" flipV="1">
            <a:off x="12417531" y="5797710"/>
            <a:ext cx="180000" cy="720000"/>
          </a:xfrm>
          <a:prstGeom prst="ellipse">
            <a:avLst/>
          </a:prstGeom>
          <a:solidFill>
            <a:srgbClr val="FFFF00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4" name="Elipse 373">
            <a:extLst>
              <a:ext uri="{FF2B5EF4-FFF2-40B4-BE49-F238E27FC236}">
                <a16:creationId xmlns:a16="http://schemas.microsoft.com/office/drawing/2014/main" id="{E24188BB-FED5-6543-8720-A53AC38F2D03}"/>
              </a:ext>
            </a:extLst>
          </p:cNvPr>
          <p:cNvSpPr>
            <a:spLocks/>
          </p:cNvSpPr>
          <p:nvPr/>
        </p:nvSpPr>
        <p:spPr>
          <a:xfrm rot="16200000">
            <a:off x="12443684" y="5952104"/>
            <a:ext cx="180000" cy="72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367" name="Imagen 366">
            <a:extLst>
              <a:ext uri="{FF2B5EF4-FFF2-40B4-BE49-F238E27FC236}">
                <a16:creationId xmlns:a16="http://schemas.microsoft.com/office/drawing/2014/main" id="{3FD88CFD-645B-1242-AD92-D423530F4DB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152929" y="5478185"/>
            <a:ext cx="252000" cy="252000"/>
          </a:xfrm>
          <a:prstGeom prst="rect">
            <a:avLst/>
          </a:prstGeom>
        </p:spPr>
      </p:pic>
      <p:pic>
        <p:nvPicPr>
          <p:cNvPr id="368" name="Imagen 367">
            <a:extLst>
              <a:ext uri="{FF2B5EF4-FFF2-40B4-BE49-F238E27FC236}">
                <a16:creationId xmlns:a16="http://schemas.microsoft.com/office/drawing/2014/main" id="{53C190C4-FF1C-8F4C-9B18-B8CCAD7C28B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114342" y="5190554"/>
            <a:ext cx="252000" cy="252000"/>
          </a:xfrm>
          <a:prstGeom prst="rect">
            <a:avLst/>
          </a:prstGeom>
        </p:spPr>
      </p:pic>
      <p:pic>
        <p:nvPicPr>
          <p:cNvPr id="375" name="Imagen 374">
            <a:extLst>
              <a:ext uri="{FF2B5EF4-FFF2-40B4-BE49-F238E27FC236}">
                <a16:creationId xmlns:a16="http://schemas.microsoft.com/office/drawing/2014/main" id="{8F4288CC-DBD6-544F-B1B8-564A1BC2E75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5400000" flipV="1">
            <a:off x="11718608" y="5739464"/>
            <a:ext cx="1149843" cy="338793"/>
          </a:xfrm>
          <a:prstGeom prst="rect">
            <a:avLst/>
          </a:prstGeom>
        </p:spPr>
      </p:pic>
      <p:pic>
        <p:nvPicPr>
          <p:cNvPr id="376" name="Imagen 375">
            <a:extLst>
              <a:ext uri="{FF2B5EF4-FFF2-40B4-BE49-F238E27FC236}">
                <a16:creationId xmlns:a16="http://schemas.microsoft.com/office/drawing/2014/main" id="{B0FA8030-40AD-D244-803F-AE9004172C4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5400000" flipV="1">
            <a:off x="11718608" y="6648979"/>
            <a:ext cx="1149843" cy="338793"/>
          </a:xfrm>
          <a:prstGeom prst="rect">
            <a:avLst/>
          </a:prstGeom>
        </p:spPr>
      </p:pic>
      <p:pic>
        <p:nvPicPr>
          <p:cNvPr id="377" name="Imagen 376">
            <a:extLst>
              <a:ext uri="{FF2B5EF4-FFF2-40B4-BE49-F238E27FC236}">
                <a16:creationId xmlns:a16="http://schemas.microsoft.com/office/drawing/2014/main" id="{07BB0616-3B85-F840-B59B-517553760B6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5400000" flipV="1">
            <a:off x="11718608" y="7526800"/>
            <a:ext cx="1149843" cy="338793"/>
          </a:xfrm>
          <a:prstGeom prst="rect">
            <a:avLst/>
          </a:prstGeom>
        </p:spPr>
      </p:pic>
      <p:pic>
        <p:nvPicPr>
          <p:cNvPr id="381" name="Imagen 380">
            <a:extLst>
              <a:ext uri="{FF2B5EF4-FFF2-40B4-BE49-F238E27FC236}">
                <a16:creationId xmlns:a16="http://schemas.microsoft.com/office/drawing/2014/main" id="{8949115E-3582-0541-B43A-2DB9C28FD6C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163365" y="6443630"/>
            <a:ext cx="252000" cy="252000"/>
          </a:xfrm>
          <a:prstGeom prst="rect">
            <a:avLst/>
          </a:prstGeom>
        </p:spPr>
      </p:pic>
      <p:pic>
        <p:nvPicPr>
          <p:cNvPr id="382" name="Imagen 381">
            <a:extLst>
              <a:ext uri="{FF2B5EF4-FFF2-40B4-BE49-F238E27FC236}">
                <a16:creationId xmlns:a16="http://schemas.microsoft.com/office/drawing/2014/main" id="{08CA622C-7A8B-A947-B5A8-475287A2052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009181" y="6113602"/>
            <a:ext cx="252000" cy="252000"/>
          </a:xfrm>
          <a:prstGeom prst="rect">
            <a:avLst/>
          </a:prstGeom>
        </p:spPr>
      </p:pic>
      <p:pic>
        <p:nvPicPr>
          <p:cNvPr id="383" name="Imagen 382">
            <a:extLst>
              <a:ext uri="{FF2B5EF4-FFF2-40B4-BE49-F238E27FC236}">
                <a16:creationId xmlns:a16="http://schemas.microsoft.com/office/drawing/2014/main" id="{1DB0751E-8AA7-654A-9AC7-E158D3DBA50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032942" y="7965947"/>
            <a:ext cx="252000" cy="252000"/>
          </a:xfrm>
          <a:prstGeom prst="rect">
            <a:avLst/>
          </a:prstGeom>
        </p:spPr>
      </p:pic>
      <p:pic>
        <p:nvPicPr>
          <p:cNvPr id="384" name="Imagen 383">
            <a:extLst>
              <a:ext uri="{FF2B5EF4-FFF2-40B4-BE49-F238E27FC236}">
                <a16:creationId xmlns:a16="http://schemas.microsoft.com/office/drawing/2014/main" id="{8D27A4BD-AC76-4247-9ECF-F18E5294844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196951" y="8229837"/>
            <a:ext cx="252000" cy="252000"/>
          </a:xfrm>
          <a:prstGeom prst="rect">
            <a:avLst/>
          </a:prstGeom>
        </p:spPr>
      </p:pic>
      <p:pic>
        <p:nvPicPr>
          <p:cNvPr id="388" name="Imagen 387">
            <a:extLst>
              <a:ext uri="{FF2B5EF4-FFF2-40B4-BE49-F238E27FC236}">
                <a16:creationId xmlns:a16="http://schemas.microsoft.com/office/drawing/2014/main" id="{833F9441-0E7C-8C4F-8179-2CAF870043F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855861" y="7605474"/>
            <a:ext cx="252000" cy="252000"/>
          </a:xfrm>
          <a:prstGeom prst="rect">
            <a:avLst/>
          </a:prstGeom>
        </p:spPr>
      </p:pic>
      <p:pic>
        <p:nvPicPr>
          <p:cNvPr id="389" name="Imagen 388">
            <a:extLst>
              <a:ext uri="{FF2B5EF4-FFF2-40B4-BE49-F238E27FC236}">
                <a16:creationId xmlns:a16="http://schemas.microsoft.com/office/drawing/2014/main" id="{C24DA169-7836-4A4B-ACBD-BBCF0FD6157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018523" y="6800746"/>
            <a:ext cx="252000" cy="252000"/>
          </a:xfrm>
          <a:prstGeom prst="rect">
            <a:avLst/>
          </a:prstGeom>
        </p:spPr>
      </p:pic>
      <p:cxnSp>
        <p:nvCxnSpPr>
          <p:cNvPr id="392" name="Conector recto 391">
            <a:extLst>
              <a:ext uri="{FF2B5EF4-FFF2-40B4-BE49-F238E27FC236}">
                <a16:creationId xmlns:a16="http://schemas.microsoft.com/office/drawing/2014/main" id="{1CD3BA9C-3240-514E-8B72-8D2A4C6E1B1C}"/>
              </a:ext>
            </a:extLst>
          </p:cNvPr>
          <p:cNvCxnSpPr>
            <a:cxnSpLocks/>
          </p:cNvCxnSpPr>
          <p:nvPr/>
        </p:nvCxnSpPr>
        <p:spPr>
          <a:xfrm flipH="1">
            <a:off x="8748983" y="1512233"/>
            <a:ext cx="410671" cy="225678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6" name="Elipse 395">
            <a:extLst>
              <a:ext uri="{FF2B5EF4-FFF2-40B4-BE49-F238E27FC236}">
                <a16:creationId xmlns:a16="http://schemas.microsoft.com/office/drawing/2014/main" id="{B3055203-09B3-D348-8A59-14E9EEF38643}"/>
              </a:ext>
            </a:extLst>
          </p:cNvPr>
          <p:cNvSpPr>
            <a:spLocks/>
          </p:cNvSpPr>
          <p:nvPr/>
        </p:nvSpPr>
        <p:spPr>
          <a:xfrm>
            <a:off x="9459397" y="1100914"/>
            <a:ext cx="180000" cy="180000"/>
          </a:xfrm>
          <a:prstGeom prst="ellipse">
            <a:avLst/>
          </a:prstGeom>
          <a:solidFill>
            <a:schemeClr val="accent4"/>
          </a:solidFill>
          <a:ln>
            <a:solidFill>
              <a:schemeClr val="accent4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solidFill>
                <a:schemeClr val="accent4"/>
              </a:solidFill>
            </a:endParaRPr>
          </a:p>
        </p:txBody>
      </p:sp>
      <p:grpSp>
        <p:nvGrpSpPr>
          <p:cNvPr id="397" name="Grupo 396">
            <a:extLst>
              <a:ext uri="{FF2B5EF4-FFF2-40B4-BE49-F238E27FC236}">
                <a16:creationId xmlns:a16="http://schemas.microsoft.com/office/drawing/2014/main" id="{2E92CB95-749D-DE46-AF2D-2BCE653B3934}"/>
              </a:ext>
            </a:extLst>
          </p:cNvPr>
          <p:cNvGrpSpPr/>
          <p:nvPr/>
        </p:nvGrpSpPr>
        <p:grpSpPr>
          <a:xfrm rot="3223950">
            <a:off x="9697880" y="933660"/>
            <a:ext cx="197703" cy="318192"/>
            <a:chOff x="12324113" y="1992529"/>
            <a:chExt cx="222395" cy="466053"/>
          </a:xfrm>
        </p:grpSpPr>
        <p:cxnSp>
          <p:nvCxnSpPr>
            <p:cNvPr id="398" name="Conector recto 397">
              <a:extLst>
                <a:ext uri="{FF2B5EF4-FFF2-40B4-BE49-F238E27FC236}">
                  <a16:creationId xmlns:a16="http://schemas.microsoft.com/office/drawing/2014/main" id="{FCCEA24E-01C2-1940-AC97-A43060CABD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35310" y="1992983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9" name="Conector recto 398">
              <a:extLst>
                <a:ext uri="{FF2B5EF4-FFF2-40B4-BE49-F238E27FC236}">
                  <a16:creationId xmlns:a16="http://schemas.microsoft.com/office/drawing/2014/main" id="{484238C3-C3C8-E347-BDE6-C56E605AD3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24113" y="1992529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00" name="CuadroTexto 399">
            <a:extLst>
              <a:ext uri="{FF2B5EF4-FFF2-40B4-BE49-F238E27FC236}">
                <a16:creationId xmlns:a16="http://schemas.microsoft.com/office/drawing/2014/main" id="{A989D320-61F7-844B-B992-230CF1EBD02B}"/>
              </a:ext>
            </a:extLst>
          </p:cNvPr>
          <p:cNvSpPr txBox="1"/>
          <p:nvPr/>
        </p:nvSpPr>
        <p:spPr>
          <a:xfrm>
            <a:off x="9878531" y="685631"/>
            <a:ext cx="8354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solidFill>
                  <a:srgbClr val="0070C0"/>
                </a:solidFill>
              </a:rPr>
              <a:t>L</a:t>
            </a:r>
            <a:r>
              <a:rPr lang="es-ES" sz="1800" b="1" dirty="0">
                <a:solidFill>
                  <a:srgbClr val="0070C0"/>
                </a:solidFill>
              </a:rPr>
              <a:t>Th-17</a:t>
            </a:r>
          </a:p>
        </p:txBody>
      </p:sp>
      <p:cxnSp>
        <p:nvCxnSpPr>
          <p:cNvPr id="402" name="Conector recto 401">
            <a:extLst>
              <a:ext uri="{FF2B5EF4-FFF2-40B4-BE49-F238E27FC236}">
                <a16:creationId xmlns:a16="http://schemas.microsoft.com/office/drawing/2014/main" id="{E774505A-0F17-C747-BF42-D4CEF9DB23CA}"/>
              </a:ext>
            </a:extLst>
          </p:cNvPr>
          <p:cNvCxnSpPr>
            <a:cxnSpLocks/>
          </p:cNvCxnSpPr>
          <p:nvPr/>
        </p:nvCxnSpPr>
        <p:spPr>
          <a:xfrm>
            <a:off x="9910096" y="1436084"/>
            <a:ext cx="1087059" cy="177456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4" name="Grupo 423">
            <a:extLst>
              <a:ext uri="{FF2B5EF4-FFF2-40B4-BE49-F238E27FC236}">
                <a16:creationId xmlns:a16="http://schemas.microsoft.com/office/drawing/2014/main" id="{3DB0622B-7096-DD42-84FB-D502A1B3FC30}"/>
              </a:ext>
            </a:extLst>
          </p:cNvPr>
          <p:cNvGrpSpPr/>
          <p:nvPr/>
        </p:nvGrpSpPr>
        <p:grpSpPr>
          <a:xfrm rot="12937147">
            <a:off x="8588815" y="5135454"/>
            <a:ext cx="222395" cy="385631"/>
            <a:chOff x="12362213" y="2324548"/>
            <a:chExt cx="222395" cy="466053"/>
          </a:xfrm>
        </p:grpSpPr>
        <p:cxnSp>
          <p:nvCxnSpPr>
            <p:cNvPr id="425" name="Conector recto 424">
              <a:extLst>
                <a:ext uri="{FF2B5EF4-FFF2-40B4-BE49-F238E27FC236}">
                  <a16:creationId xmlns:a16="http://schemas.microsoft.com/office/drawing/2014/main" id="{BA593943-EECA-724A-8006-7CC7B5C8DA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6" name="Conector recto 425">
              <a:extLst>
                <a:ext uri="{FF2B5EF4-FFF2-40B4-BE49-F238E27FC236}">
                  <a16:creationId xmlns:a16="http://schemas.microsoft.com/office/drawing/2014/main" id="{8A26A166-A0F6-1D47-B7E0-E95ABFFAFE0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62213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8" name="Grupo 427">
            <a:extLst>
              <a:ext uri="{FF2B5EF4-FFF2-40B4-BE49-F238E27FC236}">
                <a16:creationId xmlns:a16="http://schemas.microsoft.com/office/drawing/2014/main" id="{CA8B2CD2-4C35-9A4A-A028-2ED1F5C9D79D}"/>
              </a:ext>
            </a:extLst>
          </p:cNvPr>
          <p:cNvGrpSpPr/>
          <p:nvPr/>
        </p:nvGrpSpPr>
        <p:grpSpPr>
          <a:xfrm>
            <a:off x="8377690" y="4703227"/>
            <a:ext cx="748923" cy="483985"/>
            <a:chOff x="8998798" y="4858706"/>
            <a:chExt cx="748923" cy="483985"/>
          </a:xfrm>
        </p:grpSpPr>
        <p:sp>
          <p:nvSpPr>
            <p:cNvPr id="405" name="CuadroTexto 404">
              <a:extLst>
                <a:ext uri="{FF2B5EF4-FFF2-40B4-BE49-F238E27FC236}">
                  <a16:creationId xmlns:a16="http://schemas.microsoft.com/office/drawing/2014/main" id="{BF91A463-CE9E-2F44-B659-57D22F4651BB}"/>
                </a:ext>
              </a:extLst>
            </p:cNvPr>
            <p:cNvSpPr txBox="1"/>
            <p:nvPr/>
          </p:nvSpPr>
          <p:spPr>
            <a:xfrm>
              <a:off x="8998798" y="4973359"/>
              <a:ext cx="7489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rgbClr val="00B050"/>
                  </a:solidFill>
                </a:rPr>
                <a:t>∼ IL-4</a:t>
              </a:r>
            </a:p>
          </p:txBody>
        </p:sp>
        <p:sp>
          <p:nvSpPr>
            <p:cNvPr id="427" name="Elipse 426">
              <a:extLst>
                <a:ext uri="{FF2B5EF4-FFF2-40B4-BE49-F238E27FC236}">
                  <a16:creationId xmlns:a16="http://schemas.microsoft.com/office/drawing/2014/main" id="{51A90775-DB84-874C-8C8F-D5A96EC4592E}"/>
                </a:ext>
              </a:extLst>
            </p:cNvPr>
            <p:cNvSpPr>
              <a:spLocks/>
            </p:cNvSpPr>
            <p:nvPr/>
          </p:nvSpPr>
          <p:spPr>
            <a:xfrm>
              <a:off x="9399051" y="4858706"/>
              <a:ext cx="180000" cy="180000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grpSp>
        <p:nvGrpSpPr>
          <p:cNvPr id="429" name="Grupo 428">
            <a:extLst>
              <a:ext uri="{FF2B5EF4-FFF2-40B4-BE49-F238E27FC236}">
                <a16:creationId xmlns:a16="http://schemas.microsoft.com/office/drawing/2014/main" id="{7A7E906E-7357-7343-82C2-C00FBFF289BC}"/>
              </a:ext>
            </a:extLst>
          </p:cNvPr>
          <p:cNvGrpSpPr/>
          <p:nvPr/>
        </p:nvGrpSpPr>
        <p:grpSpPr>
          <a:xfrm>
            <a:off x="8306746" y="7993126"/>
            <a:ext cx="748923" cy="483985"/>
            <a:chOff x="8998798" y="4858706"/>
            <a:chExt cx="748923" cy="483985"/>
          </a:xfrm>
        </p:grpSpPr>
        <p:sp>
          <p:nvSpPr>
            <p:cNvPr id="430" name="CuadroTexto 429">
              <a:extLst>
                <a:ext uri="{FF2B5EF4-FFF2-40B4-BE49-F238E27FC236}">
                  <a16:creationId xmlns:a16="http://schemas.microsoft.com/office/drawing/2014/main" id="{B7F10D61-4CB6-F446-A31D-DE111A6EB7A2}"/>
                </a:ext>
              </a:extLst>
            </p:cNvPr>
            <p:cNvSpPr txBox="1"/>
            <p:nvPr/>
          </p:nvSpPr>
          <p:spPr>
            <a:xfrm>
              <a:off x="8998798" y="4973359"/>
              <a:ext cx="7489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rgbClr val="00B050"/>
                  </a:solidFill>
                </a:rPr>
                <a:t>∼ IL-4</a:t>
              </a:r>
            </a:p>
          </p:txBody>
        </p:sp>
        <p:sp>
          <p:nvSpPr>
            <p:cNvPr id="431" name="Elipse 430">
              <a:extLst>
                <a:ext uri="{FF2B5EF4-FFF2-40B4-BE49-F238E27FC236}">
                  <a16:creationId xmlns:a16="http://schemas.microsoft.com/office/drawing/2014/main" id="{ABC0BA0E-A5C5-CF42-9CD8-F1D8129BB846}"/>
                </a:ext>
              </a:extLst>
            </p:cNvPr>
            <p:cNvSpPr>
              <a:spLocks/>
            </p:cNvSpPr>
            <p:nvPr/>
          </p:nvSpPr>
          <p:spPr>
            <a:xfrm>
              <a:off x="9399051" y="4858706"/>
              <a:ext cx="180000" cy="180000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grpSp>
        <p:nvGrpSpPr>
          <p:cNvPr id="433" name="Grupo 432">
            <a:extLst>
              <a:ext uri="{FF2B5EF4-FFF2-40B4-BE49-F238E27FC236}">
                <a16:creationId xmlns:a16="http://schemas.microsoft.com/office/drawing/2014/main" id="{3ED8E02A-C14D-524B-9BA9-080BD454341D}"/>
              </a:ext>
            </a:extLst>
          </p:cNvPr>
          <p:cNvGrpSpPr/>
          <p:nvPr/>
        </p:nvGrpSpPr>
        <p:grpSpPr>
          <a:xfrm>
            <a:off x="9090742" y="1285520"/>
            <a:ext cx="865943" cy="369332"/>
            <a:chOff x="9711850" y="1440999"/>
            <a:chExt cx="865943" cy="369332"/>
          </a:xfrm>
        </p:grpSpPr>
        <p:sp>
          <p:nvSpPr>
            <p:cNvPr id="432" name="CuadroTexto 431">
              <a:extLst>
                <a:ext uri="{FF2B5EF4-FFF2-40B4-BE49-F238E27FC236}">
                  <a16:creationId xmlns:a16="http://schemas.microsoft.com/office/drawing/2014/main" id="{7FA82F06-9280-8F4D-AEB9-5185151F7F6B}"/>
                </a:ext>
              </a:extLst>
            </p:cNvPr>
            <p:cNvSpPr txBox="1"/>
            <p:nvPr/>
          </p:nvSpPr>
          <p:spPr>
            <a:xfrm>
              <a:off x="9787032" y="1453655"/>
              <a:ext cx="756000" cy="324000"/>
            </a:xfrm>
            <a:prstGeom prst="roundRect">
              <a:avLst/>
            </a:prstGeom>
            <a:solidFill>
              <a:srgbClr val="FFFFFF">
                <a:alpha val="40000"/>
              </a:srgbClr>
            </a:solidFill>
          </p:spPr>
          <p:txBody>
            <a:bodyPr wrap="square" rtlCol="0">
              <a:spAutoFit/>
            </a:bodyPr>
            <a:lstStyle/>
            <a:p>
              <a:endParaRPr lang="es-ES" sz="1800" b="1" dirty="0">
                <a:solidFill>
                  <a:schemeClr val="accent4"/>
                </a:solidFill>
              </a:endParaRPr>
            </a:p>
          </p:txBody>
        </p:sp>
        <p:sp>
          <p:nvSpPr>
            <p:cNvPr id="395" name="CuadroTexto 394">
              <a:extLst>
                <a:ext uri="{FF2B5EF4-FFF2-40B4-BE49-F238E27FC236}">
                  <a16:creationId xmlns:a16="http://schemas.microsoft.com/office/drawing/2014/main" id="{546585B5-D6F2-EA41-9B3C-1AA8011C3DAB}"/>
                </a:ext>
              </a:extLst>
            </p:cNvPr>
            <p:cNvSpPr txBox="1"/>
            <p:nvPr/>
          </p:nvSpPr>
          <p:spPr>
            <a:xfrm>
              <a:off x="9711850" y="1440999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4"/>
                  </a:solidFill>
                </a:rPr>
                <a:t>∼ IL-27</a:t>
              </a:r>
            </a:p>
          </p:txBody>
        </p:sp>
      </p:grpSp>
      <p:pic>
        <p:nvPicPr>
          <p:cNvPr id="434" name="Imagen 433">
            <a:extLst>
              <a:ext uri="{FF2B5EF4-FFF2-40B4-BE49-F238E27FC236}">
                <a16:creationId xmlns:a16="http://schemas.microsoft.com/office/drawing/2014/main" id="{4FC690CE-E7CD-C44D-8584-8FB86FC3D58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rot="1375716">
            <a:off x="8471607" y="537545"/>
            <a:ext cx="720830" cy="615600"/>
          </a:xfrm>
          <a:prstGeom prst="rect">
            <a:avLst/>
          </a:prstGeom>
        </p:spPr>
      </p:pic>
      <p:cxnSp>
        <p:nvCxnSpPr>
          <p:cNvPr id="435" name="Conector recto 434">
            <a:extLst>
              <a:ext uri="{FF2B5EF4-FFF2-40B4-BE49-F238E27FC236}">
                <a16:creationId xmlns:a16="http://schemas.microsoft.com/office/drawing/2014/main" id="{A40FF1B4-EF9F-BC44-8A33-631E637A9F46}"/>
              </a:ext>
            </a:extLst>
          </p:cNvPr>
          <p:cNvCxnSpPr>
            <a:cxnSpLocks/>
          </p:cNvCxnSpPr>
          <p:nvPr/>
        </p:nvCxnSpPr>
        <p:spPr>
          <a:xfrm>
            <a:off x="9138765" y="993676"/>
            <a:ext cx="226623" cy="183498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7" name="CuadroTexto 436">
            <a:extLst>
              <a:ext uri="{FF2B5EF4-FFF2-40B4-BE49-F238E27FC236}">
                <a16:creationId xmlns:a16="http://schemas.microsoft.com/office/drawing/2014/main" id="{7A5FD383-D9AD-C543-941A-CA75A069A4FC}"/>
              </a:ext>
            </a:extLst>
          </p:cNvPr>
          <p:cNvSpPr txBox="1"/>
          <p:nvPr/>
        </p:nvSpPr>
        <p:spPr>
          <a:xfrm>
            <a:off x="10234470" y="1020189"/>
            <a:ext cx="4074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solidFill>
                  <a:srgbClr val="0070C0"/>
                </a:solidFill>
              </a:rPr>
              <a:t>L</a:t>
            </a:r>
            <a:r>
              <a:rPr lang="es-ES" sz="1800" b="1" dirty="0">
                <a:solidFill>
                  <a:srgbClr val="0070C0"/>
                </a:solidFill>
              </a:rPr>
              <a:t>T</a:t>
            </a:r>
          </a:p>
        </p:txBody>
      </p:sp>
      <p:cxnSp>
        <p:nvCxnSpPr>
          <p:cNvPr id="438" name="Conector recto 437">
            <a:extLst>
              <a:ext uri="{FF2B5EF4-FFF2-40B4-BE49-F238E27FC236}">
                <a16:creationId xmlns:a16="http://schemas.microsoft.com/office/drawing/2014/main" id="{C326CCC6-249B-DF4C-85CC-4E653C0B344B}"/>
              </a:ext>
            </a:extLst>
          </p:cNvPr>
          <p:cNvCxnSpPr>
            <a:cxnSpLocks/>
          </p:cNvCxnSpPr>
          <p:nvPr/>
        </p:nvCxnSpPr>
        <p:spPr>
          <a:xfrm flipV="1">
            <a:off x="9916580" y="1232615"/>
            <a:ext cx="376129" cy="0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40" name="Grupo 439">
            <a:extLst>
              <a:ext uri="{FF2B5EF4-FFF2-40B4-BE49-F238E27FC236}">
                <a16:creationId xmlns:a16="http://schemas.microsoft.com/office/drawing/2014/main" id="{404ED36F-5701-9D46-B70F-4F0D89DCD0DB}"/>
              </a:ext>
            </a:extLst>
          </p:cNvPr>
          <p:cNvGrpSpPr/>
          <p:nvPr/>
        </p:nvGrpSpPr>
        <p:grpSpPr>
          <a:xfrm rot="18449637">
            <a:off x="8298124" y="7657152"/>
            <a:ext cx="222395" cy="385631"/>
            <a:chOff x="12362213" y="2324548"/>
            <a:chExt cx="222395" cy="466053"/>
          </a:xfrm>
        </p:grpSpPr>
        <p:cxnSp>
          <p:nvCxnSpPr>
            <p:cNvPr id="441" name="Conector recto 440">
              <a:extLst>
                <a:ext uri="{FF2B5EF4-FFF2-40B4-BE49-F238E27FC236}">
                  <a16:creationId xmlns:a16="http://schemas.microsoft.com/office/drawing/2014/main" id="{8DB43DF7-F7F1-5B41-AC95-882A51E2917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2" name="Conector recto 441">
              <a:extLst>
                <a:ext uri="{FF2B5EF4-FFF2-40B4-BE49-F238E27FC236}">
                  <a16:creationId xmlns:a16="http://schemas.microsoft.com/office/drawing/2014/main" id="{406DD671-09B9-D043-BF0B-BCE577E5536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62213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3" name="Grupo 442">
            <a:extLst>
              <a:ext uri="{FF2B5EF4-FFF2-40B4-BE49-F238E27FC236}">
                <a16:creationId xmlns:a16="http://schemas.microsoft.com/office/drawing/2014/main" id="{ED196469-D04A-2A45-B6F1-63BADA837D8A}"/>
              </a:ext>
            </a:extLst>
          </p:cNvPr>
          <p:cNvGrpSpPr/>
          <p:nvPr/>
        </p:nvGrpSpPr>
        <p:grpSpPr>
          <a:xfrm>
            <a:off x="8669170" y="7505844"/>
            <a:ext cx="222395" cy="385631"/>
            <a:chOff x="12373099" y="2324548"/>
            <a:chExt cx="222395" cy="466053"/>
          </a:xfrm>
        </p:grpSpPr>
        <p:cxnSp>
          <p:nvCxnSpPr>
            <p:cNvPr id="444" name="Conector recto 443">
              <a:extLst>
                <a:ext uri="{FF2B5EF4-FFF2-40B4-BE49-F238E27FC236}">
                  <a16:creationId xmlns:a16="http://schemas.microsoft.com/office/drawing/2014/main" id="{96F7E5CD-3D24-CB44-ACC3-7E801839D8D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5" name="Conector recto 444">
              <a:extLst>
                <a:ext uri="{FF2B5EF4-FFF2-40B4-BE49-F238E27FC236}">
                  <a16:creationId xmlns:a16="http://schemas.microsoft.com/office/drawing/2014/main" id="{E94EFB5D-4F96-C74B-AE77-B637D39BA22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73099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6" name="Grupo 445">
            <a:extLst>
              <a:ext uri="{FF2B5EF4-FFF2-40B4-BE49-F238E27FC236}">
                <a16:creationId xmlns:a16="http://schemas.microsoft.com/office/drawing/2014/main" id="{C1808A18-1C90-D041-AADB-44B66BEFD37C}"/>
              </a:ext>
            </a:extLst>
          </p:cNvPr>
          <p:cNvGrpSpPr/>
          <p:nvPr/>
        </p:nvGrpSpPr>
        <p:grpSpPr>
          <a:xfrm rot="16956315">
            <a:off x="7723573" y="7524101"/>
            <a:ext cx="222395" cy="1080132"/>
            <a:chOff x="12362213" y="2324548"/>
            <a:chExt cx="222395" cy="466053"/>
          </a:xfrm>
        </p:grpSpPr>
        <p:cxnSp>
          <p:nvCxnSpPr>
            <p:cNvPr id="447" name="Conector recto 446">
              <a:extLst>
                <a:ext uri="{FF2B5EF4-FFF2-40B4-BE49-F238E27FC236}">
                  <a16:creationId xmlns:a16="http://schemas.microsoft.com/office/drawing/2014/main" id="{3E5B7BA8-ED48-0240-AB3D-861D68E1A16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8" name="Conector recto 447">
              <a:extLst>
                <a:ext uri="{FF2B5EF4-FFF2-40B4-BE49-F238E27FC236}">
                  <a16:creationId xmlns:a16="http://schemas.microsoft.com/office/drawing/2014/main" id="{05937467-2B75-C244-8849-8D91808A2E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62213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9" name="CuadroTexto 448">
            <a:extLst>
              <a:ext uri="{FF2B5EF4-FFF2-40B4-BE49-F238E27FC236}">
                <a16:creationId xmlns:a16="http://schemas.microsoft.com/office/drawing/2014/main" id="{B1C60313-DE33-0046-A75A-99D70CF04F3D}"/>
              </a:ext>
            </a:extLst>
          </p:cNvPr>
          <p:cNvSpPr txBox="1"/>
          <p:nvPr/>
        </p:nvSpPr>
        <p:spPr>
          <a:xfrm>
            <a:off x="6719772" y="8583645"/>
            <a:ext cx="4074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solidFill>
                  <a:srgbClr val="0070C0"/>
                </a:solidFill>
              </a:rPr>
              <a:t>L</a:t>
            </a:r>
            <a:r>
              <a:rPr lang="es-ES" sz="1800" b="1" dirty="0">
                <a:solidFill>
                  <a:srgbClr val="0070C0"/>
                </a:solidFill>
              </a:rPr>
              <a:t>T</a:t>
            </a:r>
          </a:p>
        </p:txBody>
      </p:sp>
      <p:sp>
        <p:nvSpPr>
          <p:cNvPr id="450" name="CuadroTexto 449">
            <a:extLst>
              <a:ext uri="{FF2B5EF4-FFF2-40B4-BE49-F238E27FC236}">
                <a16:creationId xmlns:a16="http://schemas.microsoft.com/office/drawing/2014/main" id="{5418DAD9-5D4D-6E42-B35B-9354EF65311E}"/>
              </a:ext>
            </a:extLst>
          </p:cNvPr>
          <p:cNvSpPr txBox="1"/>
          <p:nvPr/>
        </p:nvSpPr>
        <p:spPr>
          <a:xfrm>
            <a:off x="7401618" y="8386279"/>
            <a:ext cx="6479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solidFill>
                  <a:srgbClr val="0070C0"/>
                </a:solidFill>
              </a:rPr>
              <a:t>L</a:t>
            </a:r>
            <a:r>
              <a:rPr lang="es-ES" sz="1800" b="1" dirty="0">
                <a:solidFill>
                  <a:srgbClr val="0070C0"/>
                </a:solidFill>
              </a:rPr>
              <a:t>Th2</a:t>
            </a:r>
          </a:p>
        </p:txBody>
      </p:sp>
      <p:cxnSp>
        <p:nvCxnSpPr>
          <p:cNvPr id="451" name="Conector recto 450">
            <a:extLst>
              <a:ext uri="{FF2B5EF4-FFF2-40B4-BE49-F238E27FC236}">
                <a16:creationId xmlns:a16="http://schemas.microsoft.com/office/drawing/2014/main" id="{B9DCC45E-0A66-204C-9F6C-A84DA390BA60}"/>
              </a:ext>
            </a:extLst>
          </p:cNvPr>
          <p:cNvCxnSpPr>
            <a:cxnSpLocks/>
          </p:cNvCxnSpPr>
          <p:nvPr/>
        </p:nvCxnSpPr>
        <p:spPr>
          <a:xfrm flipV="1">
            <a:off x="7079148" y="8607104"/>
            <a:ext cx="373521" cy="163693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2" name="CuadroTexto 451">
            <a:extLst>
              <a:ext uri="{FF2B5EF4-FFF2-40B4-BE49-F238E27FC236}">
                <a16:creationId xmlns:a16="http://schemas.microsoft.com/office/drawing/2014/main" id="{A4A064CB-3051-2E41-A768-AB331EB10B57}"/>
              </a:ext>
            </a:extLst>
          </p:cNvPr>
          <p:cNvSpPr txBox="1"/>
          <p:nvPr/>
        </p:nvSpPr>
        <p:spPr>
          <a:xfrm>
            <a:off x="7029682" y="8591467"/>
            <a:ext cx="5389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solidFill>
                  <a:srgbClr val="00B050"/>
                </a:solidFill>
              </a:rPr>
              <a:t> IL-4</a:t>
            </a:r>
          </a:p>
        </p:txBody>
      </p:sp>
      <p:sp>
        <p:nvSpPr>
          <p:cNvPr id="453" name="Forma libre 452">
            <a:extLst>
              <a:ext uri="{FF2B5EF4-FFF2-40B4-BE49-F238E27FC236}">
                <a16:creationId xmlns:a16="http://schemas.microsoft.com/office/drawing/2014/main" id="{10EBCDA5-9110-7648-8538-F9DD0ACBF8DA}"/>
              </a:ext>
            </a:extLst>
          </p:cNvPr>
          <p:cNvSpPr/>
          <p:nvPr/>
        </p:nvSpPr>
        <p:spPr>
          <a:xfrm rot="20652215">
            <a:off x="7956255" y="8406962"/>
            <a:ext cx="481891" cy="108499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55" name="Forma libre 454">
            <a:extLst>
              <a:ext uri="{FF2B5EF4-FFF2-40B4-BE49-F238E27FC236}">
                <a16:creationId xmlns:a16="http://schemas.microsoft.com/office/drawing/2014/main" id="{3DC36A99-A0F3-804F-A5FD-DC3432A4C2AD}"/>
              </a:ext>
            </a:extLst>
          </p:cNvPr>
          <p:cNvSpPr/>
          <p:nvPr/>
        </p:nvSpPr>
        <p:spPr>
          <a:xfrm rot="2847153">
            <a:off x="7900809" y="8753931"/>
            <a:ext cx="502923" cy="123976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  <a:gd name="connsiteX0" fmla="*/ -1 w 744493"/>
              <a:gd name="connsiteY0" fmla="*/ 391419 h 460845"/>
              <a:gd name="connsiteX1" fmla="*/ 147883 w 744493"/>
              <a:gd name="connsiteY1" fmla="*/ 250673 h 460845"/>
              <a:gd name="connsiteX2" fmla="*/ 267522 w 744493"/>
              <a:gd name="connsiteY2" fmla="*/ 459162 h 460845"/>
              <a:gd name="connsiteX3" fmla="*/ 314695 w 744493"/>
              <a:gd name="connsiteY3" fmla="*/ 112637 h 460845"/>
              <a:gd name="connsiteX4" fmla="*/ 428878 w 744493"/>
              <a:gd name="connsiteY4" fmla="*/ 362447 h 460845"/>
              <a:gd name="connsiteX5" fmla="*/ 498612 w 744493"/>
              <a:gd name="connsiteY5" fmla="*/ 112886 h 460845"/>
              <a:gd name="connsiteX6" fmla="*/ 625418 w 744493"/>
              <a:gd name="connsiteY6" fmla="*/ 69141 h 460845"/>
              <a:gd name="connsiteX7" fmla="*/ 744493 w 744493"/>
              <a:gd name="connsiteY7" fmla="*/ 0 h 460845"/>
              <a:gd name="connsiteX0" fmla="*/ 0 w 744494"/>
              <a:gd name="connsiteY0" fmla="*/ 391419 h 460845"/>
              <a:gd name="connsiteX1" fmla="*/ 147884 w 744494"/>
              <a:gd name="connsiteY1" fmla="*/ 250673 h 460845"/>
              <a:gd name="connsiteX2" fmla="*/ 267523 w 744494"/>
              <a:gd name="connsiteY2" fmla="*/ 459162 h 460845"/>
              <a:gd name="connsiteX3" fmla="*/ 314696 w 744494"/>
              <a:gd name="connsiteY3" fmla="*/ 112637 h 460845"/>
              <a:gd name="connsiteX4" fmla="*/ 428879 w 744494"/>
              <a:gd name="connsiteY4" fmla="*/ 362447 h 460845"/>
              <a:gd name="connsiteX5" fmla="*/ 498613 w 744494"/>
              <a:gd name="connsiteY5" fmla="*/ 112886 h 460845"/>
              <a:gd name="connsiteX6" fmla="*/ 625419 w 744494"/>
              <a:gd name="connsiteY6" fmla="*/ 69141 h 460845"/>
              <a:gd name="connsiteX7" fmla="*/ 744494 w 744494"/>
              <a:gd name="connsiteY7" fmla="*/ 0 h 460845"/>
              <a:gd name="connsiteX0" fmla="*/ 0 w 744494"/>
              <a:gd name="connsiteY0" fmla="*/ 391419 h 460845"/>
              <a:gd name="connsiteX1" fmla="*/ 147884 w 744494"/>
              <a:gd name="connsiteY1" fmla="*/ 250673 h 460845"/>
              <a:gd name="connsiteX2" fmla="*/ 267523 w 744494"/>
              <a:gd name="connsiteY2" fmla="*/ 459162 h 460845"/>
              <a:gd name="connsiteX3" fmla="*/ 314696 w 744494"/>
              <a:gd name="connsiteY3" fmla="*/ 112637 h 460845"/>
              <a:gd name="connsiteX4" fmla="*/ 428879 w 744494"/>
              <a:gd name="connsiteY4" fmla="*/ 362447 h 460845"/>
              <a:gd name="connsiteX5" fmla="*/ 498613 w 744494"/>
              <a:gd name="connsiteY5" fmla="*/ 112886 h 460845"/>
              <a:gd name="connsiteX6" fmla="*/ 625419 w 744494"/>
              <a:gd name="connsiteY6" fmla="*/ 69141 h 460845"/>
              <a:gd name="connsiteX7" fmla="*/ 744494 w 744494"/>
              <a:gd name="connsiteY7" fmla="*/ 0 h 4608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744494" h="460845">
                <a:moveTo>
                  <a:pt x="0" y="391419"/>
                </a:moveTo>
                <a:cubicBezTo>
                  <a:pt x="98500" y="515449"/>
                  <a:pt x="103297" y="239383"/>
                  <a:pt x="147884" y="250673"/>
                </a:cubicBezTo>
                <a:cubicBezTo>
                  <a:pt x="192471" y="261963"/>
                  <a:pt x="239721" y="482168"/>
                  <a:pt x="267523" y="459162"/>
                </a:cubicBezTo>
                <a:cubicBezTo>
                  <a:pt x="295325" y="436156"/>
                  <a:pt x="287803" y="128756"/>
                  <a:pt x="314696" y="112637"/>
                </a:cubicBezTo>
                <a:cubicBezTo>
                  <a:pt x="341589" y="96518"/>
                  <a:pt x="398226" y="362406"/>
                  <a:pt x="428879" y="362447"/>
                </a:cubicBezTo>
                <a:cubicBezTo>
                  <a:pt x="459532" y="362488"/>
                  <a:pt x="465856" y="161770"/>
                  <a:pt x="498613" y="112886"/>
                </a:cubicBezTo>
                <a:cubicBezTo>
                  <a:pt x="531370" y="64002"/>
                  <a:pt x="584439" y="87955"/>
                  <a:pt x="625419" y="69141"/>
                </a:cubicBezTo>
                <a:cubicBezTo>
                  <a:pt x="666399" y="50327"/>
                  <a:pt x="721529" y="37578"/>
                  <a:pt x="744494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457" name="Grupo 456">
            <a:extLst>
              <a:ext uri="{FF2B5EF4-FFF2-40B4-BE49-F238E27FC236}">
                <a16:creationId xmlns:a16="http://schemas.microsoft.com/office/drawing/2014/main" id="{9FFB271A-3EB1-C54B-A410-E2FB829D6B1B}"/>
              </a:ext>
            </a:extLst>
          </p:cNvPr>
          <p:cNvGrpSpPr/>
          <p:nvPr/>
        </p:nvGrpSpPr>
        <p:grpSpPr>
          <a:xfrm>
            <a:off x="8033612" y="8880149"/>
            <a:ext cx="865943" cy="483985"/>
            <a:chOff x="8998798" y="4858706"/>
            <a:chExt cx="865943" cy="483985"/>
          </a:xfrm>
        </p:grpSpPr>
        <p:sp>
          <p:nvSpPr>
            <p:cNvPr id="458" name="CuadroTexto 457">
              <a:extLst>
                <a:ext uri="{FF2B5EF4-FFF2-40B4-BE49-F238E27FC236}">
                  <a16:creationId xmlns:a16="http://schemas.microsoft.com/office/drawing/2014/main" id="{291A6185-9D61-6D4A-B26D-7DD363D27152}"/>
                </a:ext>
              </a:extLst>
            </p:cNvPr>
            <p:cNvSpPr txBox="1"/>
            <p:nvPr/>
          </p:nvSpPr>
          <p:spPr>
            <a:xfrm>
              <a:off x="8998798" y="4973359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rgbClr val="00B050"/>
                  </a:solidFill>
                </a:rPr>
                <a:t>∼ IL-13</a:t>
              </a:r>
            </a:p>
          </p:txBody>
        </p:sp>
        <p:sp>
          <p:nvSpPr>
            <p:cNvPr id="459" name="Elipse 458">
              <a:extLst>
                <a:ext uri="{FF2B5EF4-FFF2-40B4-BE49-F238E27FC236}">
                  <a16:creationId xmlns:a16="http://schemas.microsoft.com/office/drawing/2014/main" id="{57E99AB4-534D-BB4B-ACE6-D2757D73B92C}"/>
                </a:ext>
              </a:extLst>
            </p:cNvPr>
            <p:cNvSpPr>
              <a:spLocks/>
            </p:cNvSpPr>
            <p:nvPr/>
          </p:nvSpPr>
          <p:spPr>
            <a:xfrm>
              <a:off x="9399051" y="4858706"/>
              <a:ext cx="180000" cy="180000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pic>
        <p:nvPicPr>
          <p:cNvPr id="462" name="Imagen 461">
            <a:extLst>
              <a:ext uri="{FF2B5EF4-FFF2-40B4-BE49-F238E27FC236}">
                <a16:creationId xmlns:a16="http://schemas.microsoft.com/office/drawing/2014/main" id="{64F7322A-81F2-E14B-9E21-44FC549115E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873470">
            <a:off x="9175306" y="7552875"/>
            <a:ext cx="763002" cy="355793"/>
          </a:xfrm>
          <a:prstGeom prst="rect">
            <a:avLst/>
          </a:prstGeom>
        </p:spPr>
      </p:pic>
      <p:sp>
        <p:nvSpPr>
          <p:cNvPr id="463" name="Forma libre 462">
            <a:extLst>
              <a:ext uri="{FF2B5EF4-FFF2-40B4-BE49-F238E27FC236}">
                <a16:creationId xmlns:a16="http://schemas.microsoft.com/office/drawing/2014/main" id="{DBF0CDAB-8D7C-A94D-A06F-96AC9D00B4C9}"/>
              </a:ext>
            </a:extLst>
          </p:cNvPr>
          <p:cNvSpPr/>
          <p:nvPr/>
        </p:nvSpPr>
        <p:spPr>
          <a:xfrm rot="10555375">
            <a:off x="8967931" y="7992347"/>
            <a:ext cx="649901" cy="199581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64" name="CuadroTexto 463">
            <a:extLst>
              <a:ext uri="{FF2B5EF4-FFF2-40B4-BE49-F238E27FC236}">
                <a16:creationId xmlns:a16="http://schemas.microsoft.com/office/drawing/2014/main" id="{CFF3738C-47E6-B94F-9937-8E49A7BFA311}"/>
              </a:ext>
            </a:extLst>
          </p:cNvPr>
          <p:cNvSpPr txBox="1"/>
          <p:nvPr/>
        </p:nvSpPr>
        <p:spPr>
          <a:xfrm>
            <a:off x="7856006" y="1016863"/>
            <a:ext cx="6479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solidFill>
                  <a:srgbClr val="0070C0"/>
                </a:solidFill>
              </a:rPr>
              <a:t>L</a:t>
            </a:r>
            <a:r>
              <a:rPr lang="es-ES" sz="1800" b="1" dirty="0">
                <a:solidFill>
                  <a:srgbClr val="0070C0"/>
                </a:solidFill>
              </a:rPr>
              <a:t>Th1</a:t>
            </a:r>
          </a:p>
        </p:txBody>
      </p:sp>
      <p:cxnSp>
        <p:nvCxnSpPr>
          <p:cNvPr id="465" name="Conector recto 464">
            <a:extLst>
              <a:ext uri="{FF2B5EF4-FFF2-40B4-BE49-F238E27FC236}">
                <a16:creationId xmlns:a16="http://schemas.microsoft.com/office/drawing/2014/main" id="{67490DC0-DA57-DE4B-855D-346088855908}"/>
              </a:ext>
            </a:extLst>
          </p:cNvPr>
          <p:cNvCxnSpPr>
            <a:cxnSpLocks/>
          </p:cNvCxnSpPr>
          <p:nvPr/>
        </p:nvCxnSpPr>
        <p:spPr>
          <a:xfrm flipH="1" flipV="1">
            <a:off x="8472738" y="1256959"/>
            <a:ext cx="620119" cy="60674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9" name="CuadroTexto 468">
            <a:extLst>
              <a:ext uri="{FF2B5EF4-FFF2-40B4-BE49-F238E27FC236}">
                <a16:creationId xmlns:a16="http://schemas.microsoft.com/office/drawing/2014/main" id="{38D865DE-080A-A44C-BB85-30D470C8C75C}"/>
              </a:ext>
            </a:extLst>
          </p:cNvPr>
          <p:cNvSpPr txBox="1"/>
          <p:nvPr/>
        </p:nvSpPr>
        <p:spPr>
          <a:xfrm>
            <a:off x="7336201" y="9118381"/>
            <a:ext cx="6479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solidFill>
                  <a:srgbClr val="0070C0"/>
                </a:solidFill>
              </a:rPr>
              <a:t>L</a:t>
            </a:r>
            <a:r>
              <a:rPr lang="es-ES" sz="1800" b="1" dirty="0">
                <a:solidFill>
                  <a:srgbClr val="0070C0"/>
                </a:solidFill>
              </a:rPr>
              <a:t>Th1</a:t>
            </a:r>
          </a:p>
        </p:txBody>
      </p:sp>
      <p:grpSp>
        <p:nvGrpSpPr>
          <p:cNvPr id="470" name="Grupo 469">
            <a:extLst>
              <a:ext uri="{FF2B5EF4-FFF2-40B4-BE49-F238E27FC236}">
                <a16:creationId xmlns:a16="http://schemas.microsoft.com/office/drawing/2014/main" id="{E6B1D393-8FCC-EB41-A54C-248F7ECC61C8}"/>
              </a:ext>
            </a:extLst>
          </p:cNvPr>
          <p:cNvGrpSpPr/>
          <p:nvPr/>
        </p:nvGrpSpPr>
        <p:grpSpPr>
          <a:xfrm rot="14574445">
            <a:off x="7969751" y="8974182"/>
            <a:ext cx="222395" cy="385631"/>
            <a:chOff x="12362213" y="2324548"/>
            <a:chExt cx="222395" cy="466053"/>
          </a:xfrm>
        </p:grpSpPr>
        <p:cxnSp>
          <p:nvCxnSpPr>
            <p:cNvPr id="471" name="Conector recto 470">
              <a:extLst>
                <a:ext uri="{FF2B5EF4-FFF2-40B4-BE49-F238E27FC236}">
                  <a16:creationId xmlns:a16="http://schemas.microsoft.com/office/drawing/2014/main" id="{22B22653-A72E-BF4E-8EA3-441ED39E81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473410" y="2325002"/>
              <a:ext cx="0" cy="465599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2" name="Conector recto 471">
              <a:extLst>
                <a:ext uri="{FF2B5EF4-FFF2-40B4-BE49-F238E27FC236}">
                  <a16:creationId xmlns:a16="http://schemas.microsoft.com/office/drawing/2014/main" id="{03FB6F2D-E1C0-A54E-990F-98BC361A624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62213" y="2324548"/>
              <a:ext cx="222395" cy="1"/>
            </a:xfrm>
            <a:prstGeom prst="line">
              <a:avLst/>
            </a:prstGeom>
            <a:ln w="28575">
              <a:solidFill>
                <a:srgbClr val="C00000"/>
              </a:solidFill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89" name="Imagen 488">
            <a:extLst>
              <a:ext uri="{FF2B5EF4-FFF2-40B4-BE49-F238E27FC236}">
                <a16:creationId xmlns:a16="http://schemas.microsoft.com/office/drawing/2014/main" id="{3F3E4CA6-7B48-9A42-9E9E-4D5FA5F787B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17474" y="8447564"/>
            <a:ext cx="360000" cy="360000"/>
          </a:xfrm>
          <a:prstGeom prst="rect">
            <a:avLst/>
          </a:prstGeom>
        </p:spPr>
      </p:pic>
      <p:cxnSp>
        <p:nvCxnSpPr>
          <p:cNvPr id="503" name="Conector recto 502">
            <a:extLst>
              <a:ext uri="{FF2B5EF4-FFF2-40B4-BE49-F238E27FC236}">
                <a16:creationId xmlns:a16="http://schemas.microsoft.com/office/drawing/2014/main" id="{1CA49672-2146-FA4F-978D-D9C86C91C046}"/>
              </a:ext>
            </a:extLst>
          </p:cNvPr>
          <p:cNvCxnSpPr>
            <a:cxnSpLocks/>
          </p:cNvCxnSpPr>
          <p:nvPr/>
        </p:nvCxnSpPr>
        <p:spPr>
          <a:xfrm flipV="1">
            <a:off x="8654559" y="8754681"/>
            <a:ext cx="373521" cy="163693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4" name="Imagen 503">
            <a:extLst>
              <a:ext uri="{FF2B5EF4-FFF2-40B4-BE49-F238E27FC236}">
                <a16:creationId xmlns:a16="http://schemas.microsoft.com/office/drawing/2014/main" id="{606DEF08-1B2E-3541-9BA5-454C7FDD78B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167654" y="9112537"/>
            <a:ext cx="360000" cy="342525"/>
          </a:xfrm>
          <a:prstGeom prst="rect">
            <a:avLst/>
          </a:prstGeom>
        </p:spPr>
      </p:pic>
      <p:pic>
        <p:nvPicPr>
          <p:cNvPr id="505" name="Imagen 504">
            <a:extLst>
              <a:ext uri="{FF2B5EF4-FFF2-40B4-BE49-F238E27FC236}">
                <a16:creationId xmlns:a16="http://schemas.microsoft.com/office/drawing/2014/main" id="{959FF349-E68D-A84F-BE40-809B5C7CF7B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316725" y="8791989"/>
            <a:ext cx="360000" cy="342525"/>
          </a:xfrm>
          <a:prstGeom prst="rect">
            <a:avLst/>
          </a:prstGeom>
        </p:spPr>
      </p:pic>
      <p:sp>
        <p:nvSpPr>
          <p:cNvPr id="507" name="Forma libre 506">
            <a:extLst>
              <a:ext uri="{FF2B5EF4-FFF2-40B4-BE49-F238E27FC236}">
                <a16:creationId xmlns:a16="http://schemas.microsoft.com/office/drawing/2014/main" id="{58EA7165-E4E2-074F-8F9F-17B255DB6141}"/>
              </a:ext>
            </a:extLst>
          </p:cNvPr>
          <p:cNvSpPr/>
          <p:nvPr/>
        </p:nvSpPr>
        <p:spPr>
          <a:xfrm rot="2027250">
            <a:off x="9561206" y="9221407"/>
            <a:ext cx="536801" cy="201807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508" name="Grupo 507">
            <a:extLst>
              <a:ext uri="{FF2B5EF4-FFF2-40B4-BE49-F238E27FC236}">
                <a16:creationId xmlns:a16="http://schemas.microsoft.com/office/drawing/2014/main" id="{BD94E366-2259-2544-B739-57B3C220087A}"/>
              </a:ext>
            </a:extLst>
          </p:cNvPr>
          <p:cNvGrpSpPr>
            <a:grpSpLocks noChangeAspect="1"/>
          </p:cNvGrpSpPr>
          <p:nvPr/>
        </p:nvGrpSpPr>
        <p:grpSpPr>
          <a:xfrm rot="4072961">
            <a:off x="10182283" y="9157976"/>
            <a:ext cx="720000" cy="575110"/>
            <a:chOff x="13182994" y="1880366"/>
            <a:chExt cx="1104511" cy="882244"/>
          </a:xfrm>
        </p:grpSpPr>
        <p:grpSp>
          <p:nvGrpSpPr>
            <p:cNvPr id="509" name="Grupo 508">
              <a:extLst>
                <a:ext uri="{FF2B5EF4-FFF2-40B4-BE49-F238E27FC236}">
                  <a16:creationId xmlns:a16="http://schemas.microsoft.com/office/drawing/2014/main" id="{776FB599-7A81-784E-A90E-DC89B74E0FB0}"/>
                </a:ext>
              </a:extLst>
            </p:cNvPr>
            <p:cNvGrpSpPr>
              <a:grpSpLocks noChangeAspect="1"/>
            </p:cNvGrpSpPr>
            <p:nvPr/>
          </p:nvGrpSpPr>
          <p:grpSpPr>
            <a:xfrm rot="19797694">
              <a:off x="13182994" y="2000886"/>
              <a:ext cx="167764" cy="288000"/>
              <a:chOff x="12293211" y="8469082"/>
              <a:chExt cx="435722" cy="707576"/>
            </a:xfrm>
          </p:grpSpPr>
          <p:sp>
            <p:nvSpPr>
              <p:cNvPr id="531" name="Forma libre 530">
                <a:extLst>
                  <a:ext uri="{FF2B5EF4-FFF2-40B4-BE49-F238E27FC236}">
                    <a16:creationId xmlns:a16="http://schemas.microsoft.com/office/drawing/2014/main" id="{61041463-6AAB-034E-B3DC-E18CBDA007EB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32" name="Forma libre 531">
                <a:extLst>
                  <a:ext uri="{FF2B5EF4-FFF2-40B4-BE49-F238E27FC236}">
                    <a16:creationId xmlns:a16="http://schemas.microsoft.com/office/drawing/2014/main" id="{EBF40630-4609-1847-9113-64ADFCCE5731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510" name="Grupo 509">
              <a:extLst>
                <a:ext uri="{FF2B5EF4-FFF2-40B4-BE49-F238E27FC236}">
                  <a16:creationId xmlns:a16="http://schemas.microsoft.com/office/drawing/2014/main" id="{542556B2-A2EF-A84C-9B20-13F3424DED3C}"/>
                </a:ext>
              </a:extLst>
            </p:cNvPr>
            <p:cNvGrpSpPr>
              <a:grpSpLocks noChangeAspect="1"/>
            </p:cNvGrpSpPr>
            <p:nvPr/>
          </p:nvGrpSpPr>
          <p:grpSpPr>
            <a:xfrm rot="20087550">
              <a:off x="13717324" y="1883934"/>
              <a:ext cx="167764" cy="288000"/>
              <a:chOff x="12293211" y="8469082"/>
              <a:chExt cx="435722" cy="707576"/>
            </a:xfrm>
          </p:grpSpPr>
          <p:sp>
            <p:nvSpPr>
              <p:cNvPr id="529" name="Forma libre 528">
                <a:extLst>
                  <a:ext uri="{FF2B5EF4-FFF2-40B4-BE49-F238E27FC236}">
                    <a16:creationId xmlns:a16="http://schemas.microsoft.com/office/drawing/2014/main" id="{BFA9212E-6245-4D47-8C59-E0093BA4B906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30" name="Forma libre 529">
                <a:extLst>
                  <a:ext uri="{FF2B5EF4-FFF2-40B4-BE49-F238E27FC236}">
                    <a16:creationId xmlns:a16="http://schemas.microsoft.com/office/drawing/2014/main" id="{B5460AF7-F837-414E-95B9-9F7E77E48D94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511" name="Grupo 510">
              <a:extLst>
                <a:ext uri="{FF2B5EF4-FFF2-40B4-BE49-F238E27FC236}">
                  <a16:creationId xmlns:a16="http://schemas.microsoft.com/office/drawing/2014/main" id="{DC50C85F-A2FF-8D4B-8B29-2D01204B12A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4119741" y="1880366"/>
              <a:ext cx="167764" cy="288000"/>
              <a:chOff x="12293211" y="8469082"/>
              <a:chExt cx="435722" cy="707576"/>
            </a:xfrm>
          </p:grpSpPr>
          <p:sp>
            <p:nvSpPr>
              <p:cNvPr id="527" name="Forma libre 526">
                <a:extLst>
                  <a:ext uri="{FF2B5EF4-FFF2-40B4-BE49-F238E27FC236}">
                    <a16:creationId xmlns:a16="http://schemas.microsoft.com/office/drawing/2014/main" id="{474A020A-123E-4842-AA8E-6FAD1964E374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28" name="Forma libre 527">
                <a:extLst>
                  <a:ext uri="{FF2B5EF4-FFF2-40B4-BE49-F238E27FC236}">
                    <a16:creationId xmlns:a16="http://schemas.microsoft.com/office/drawing/2014/main" id="{AD5FE183-6917-F343-8630-193CD5EC4DB5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512" name="Grupo 511">
              <a:extLst>
                <a:ext uri="{FF2B5EF4-FFF2-40B4-BE49-F238E27FC236}">
                  <a16:creationId xmlns:a16="http://schemas.microsoft.com/office/drawing/2014/main" id="{30A091F8-10F7-0D4E-A86F-81FDE13CBBA6}"/>
                </a:ext>
              </a:extLst>
            </p:cNvPr>
            <p:cNvGrpSpPr>
              <a:grpSpLocks noChangeAspect="1"/>
            </p:cNvGrpSpPr>
            <p:nvPr/>
          </p:nvGrpSpPr>
          <p:grpSpPr>
            <a:xfrm rot="12837040">
              <a:off x="13195292" y="2433104"/>
              <a:ext cx="167764" cy="288000"/>
              <a:chOff x="12293211" y="8469082"/>
              <a:chExt cx="435722" cy="707576"/>
            </a:xfrm>
          </p:grpSpPr>
          <p:sp>
            <p:nvSpPr>
              <p:cNvPr id="525" name="Forma libre 524">
                <a:extLst>
                  <a:ext uri="{FF2B5EF4-FFF2-40B4-BE49-F238E27FC236}">
                    <a16:creationId xmlns:a16="http://schemas.microsoft.com/office/drawing/2014/main" id="{FC716123-4A5A-D146-AD09-260D7210AB5B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26" name="Forma libre 525">
                <a:extLst>
                  <a:ext uri="{FF2B5EF4-FFF2-40B4-BE49-F238E27FC236}">
                    <a16:creationId xmlns:a16="http://schemas.microsoft.com/office/drawing/2014/main" id="{0367238E-A804-3D4F-ACF7-7650CE07B421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513" name="Grupo 512">
              <a:extLst>
                <a:ext uri="{FF2B5EF4-FFF2-40B4-BE49-F238E27FC236}">
                  <a16:creationId xmlns:a16="http://schemas.microsoft.com/office/drawing/2014/main" id="{AA50DD23-5555-C24A-8B6C-36F48A27B17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829375" y="2463051"/>
              <a:ext cx="167764" cy="288000"/>
              <a:chOff x="12293211" y="8469082"/>
              <a:chExt cx="435722" cy="707576"/>
            </a:xfrm>
          </p:grpSpPr>
          <p:sp>
            <p:nvSpPr>
              <p:cNvPr id="523" name="Forma libre 522">
                <a:extLst>
                  <a:ext uri="{FF2B5EF4-FFF2-40B4-BE49-F238E27FC236}">
                    <a16:creationId xmlns:a16="http://schemas.microsoft.com/office/drawing/2014/main" id="{D70B47EF-0358-9C46-913D-D7AADCFA1C78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24" name="Forma libre 523">
                <a:extLst>
                  <a:ext uri="{FF2B5EF4-FFF2-40B4-BE49-F238E27FC236}">
                    <a16:creationId xmlns:a16="http://schemas.microsoft.com/office/drawing/2014/main" id="{2C742C95-F444-3041-AAB5-DB9434FA40CA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514" name="Grupo 513">
              <a:extLst>
                <a:ext uri="{FF2B5EF4-FFF2-40B4-BE49-F238E27FC236}">
                  <a16:creationId xmlns:a16="http://schemas.microsoft.com/office/drawing/2014/main" id="{19AEF071-5836-864E-B76E-0E3935DFDFB0}"/>
                </a:ext>
              </a:extLst>
            </p:cNvPr>
            <p:cNvGrpSpPr>
              <a:grpSpLocks noChangeAspect="1"/>
            </p:cNvGrpSpPr>
            <p:nvPr/>
          </p:nvGrpSpPr>
          <p:grpSpPr>
            <a:xfrm rot="4254917">
              <a:off x="13505771" y="2534728"/>
              <a:ext cx="167764" cy="288000"/>
              <a:chOff x="12293211" y="8469082"/>
              <a:chExt cx="435722" cy="707576"/>
            </a:xfrm>
          </p:grpSpPr>
          <p:sp>
            <p:nvSpPr>
              <p:cNvPr id="521" name="Forma libre 520">
                <a:extLst>
                  <a:ext uri="{FF2B5EF4-FFF2-40B4-BE49-F238E27FC236}">
                    <a16:creationId xmlns:a16="http://schemas.microsoft.com/office/drawing/2014/main" id="{6504A6EF-06E2-E74F-9CA4-6AF0C958C515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22" name="Forma libre 521">
                <a:extLst>
                  <a:ext uri="{FF2B5EF4-FFF2-40B4-BE49-F238E27FC236}">
                    <a16:creationId xmlns:a16="http://schemas.microsoft.com/office/drawing/2014/main" id="{73B116FB-351D-4146-860F-6BE2791087EC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515" name="Grupo 514">
              <a:extLst>
                <a:ext uri="{FF2B5EF4-FFF2-40B4-BE49-F238E27FC236}">
                  <a16:creationId xmlns:a16="http://schemas.microsoft.com/office/drawing/2014/main" id="{78FC1575-AE42-C24E-8DF4-DFF5DFFF1AD7}"/>
                </a:ext>
              </a:extLst>
            </p:cNvPr>
            <p:cNvGrpSpPr>
              <a:grpSpLocks noChangeAspect="1"/>
            </p:cNvGrpSpPr>
            <p:nvPr/>
          </p:nvGrpSpPr>
          <p:grpSpPr>
            <a:xfrm rot="3206025">
              <a:off x="13932061" y="2131458"/>
              <a:ext cx="167764" cy="288000"/>
              <a:chOff x="12293211" y="8469082"/>
              <a:chExt cx="435722" cy="707576"/>
            </a:xfrm>
          </p:grpSpPr>
          <p:sp>
            <p:nvSpPr>
              <p:cNvPr id="519" name="Forma libre 518">
                <a:extLst>
                  <a:ext uri="{FF2B5EF4-FFF2-40B4-BE49-F238E27FC236}">
                    <a16:creationId xmlns:a16="http://schemas.microsoft.com/office/drawing/2014/main" id="{9FA8839C-2E6D-0946-9EFD-9BA7A8D42F95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20" name="Forma libre 519">
                <a:extLst>
                  <a:ext uri="{FF2B5EF4-FFF2-40B4-BE49-F238E27FC236}">
                    <a16:creationId xmlns:a16="http://schemas.microsoft.com/office/drawing/2014/main" id="{97853EF9-F685-3143-A513-94360724FD14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516" name="Grupo 515">
              <a:extLst>
                <a:ext uri="{FF2B5EF4-FFF2-40B4-BE49-F238E27FC236}">
                  <a16:creationId xmlns:a16="http://schemas.microsoft.com/office/drawing/2014/main" id="{51AEE31D-4AB9-EE43-AE45-7886FBE90D5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454428" y="2112572"/>
              <a:ext cx="167764" cy="288000"/>
              <a:chOff x="12293211" y="8469082"/>
              <a:chExt cx="435722" cy="707576"/>
            </a:xfrm>
          </p:grpSpPr>
          <p:sp>
            <p:nvSpPr>
              <p:cNvPr id="517" name="Forma libre 516">
                <a:extLst>
                  <a:ext uri="{FF2B5EF4-FFF2-40B4-BE49-F238E27FC236}">
                    <a16:creationId xmlns:a16="http://schemas.microsoft.com/office/drawing/2014/main" id="{C554353D-C5EA-2843-BAC0-2980CE657E11}"/>
                  </a:ext>
                </a:extLst>
              </p:cNvPr>
              <p:cNvSpPr/>
              <p:nvPr/>
            </p:nvSpPr>
            <p:spPr>
              <a:xfrm>
                <a:off x="12293211" y="8474530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18" name="Forma libre 517">
                <a:extLst>
                  <a:ext uri="{FF2B5EF4-FFF2-40B4-BE49-F238E27FC236}">
                    <a16:creationId xmlns:a16="http://schemas.microsoft.com/office/drawing/2014/main" id="{98E84023-EE69-A840-B75D-0015826E4061}"/>
                  </a:ext>
                </a:extLst>
              </p:cNvPr>
              <p:cNvSpPr/>
              <p:nvPr/>
            </p:nvSpPr>
            <p:spPr>
              <a:xfrm flipH="1">
                <a:off x="12559910" y="8469082"/>
                <a:ext cx="169023" cy="702128"/>
              </a:xfrm>
              <a:custGeom>
                <a:avLst/>
                <a:gdLst>
                  <a:gd name="connsiteX0" fmla="*/ 13093 w 169023"/>
                  <a:gd name="connsiteY0" fmla="*/ 0 h 702128"/>
                  <a:gd name="connsiteX1" fmla="*/ 13093 w 169023"/>
                  <a:gd name="connsiteY1" fmla="*/ 201385 h 702128"/>
                  <a:gd name="connsiteX2" fmla="*/ 149164 w 169023"/>
                  <a:gd name="connsiteY2" fmla="*/ 283028 h 702128"/>
                  <a:gd name="connsiteX3" fmla="*/ 165493 w 169023"/>
                  <a:gd name="connsiteY3" fmla="*/ 702128 h 7021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023" h="702128">
                    <a:moveTo>
                      <a:pt x="13093" y="0"/>
                    </a:moveTo>
                    <a:cubicBezTo>
                      <a:pt x="1753" y="77107"/>
                      <a:pt x="-9586" y="154214"/>
                      <a:pt x="13093" y="201385"/>
                    </a:cubicBezTo>
                    <a:cubicBezTo>
                      <a:pt x="35772" y="248556"/>
                      <a:pt x="123764" y="199571"/>
                      <a:pt x="149164" y="283028"/>
                    </a:cubicBezTo>
                    <a:cubicBezTo>
                      <a:pt x="174564" y="366485"/>
                      <a:pt x="170028" y="534306"/>
                      <a:pt x="165493" y="702128"/>
                    </a:cubicBezTo>
                  </a:path>
                </a:pathLst>
              </a:custGeom>
              <a:noFill/>
              <a:ln w="38100">
                <a:solidFill>
                  <a:srgbClr val="55BDE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</p:grpSp>
      <p:sp>
        <p:nvSpPr>
          <p:cNvPr id="534" name="Forma libre 533">
            <a:extLst>
              <a:ext uri="{FF2B5EF4-FFF2-40B4-BE49-F238E27FC236}">
                <a16:creationId xmlns:a16="http://schemas.microsoft.com/office/drawing/2014/main" id="{088E2C00-F248-DE40-A470-42BCDFB8FFB7}"/>
              </a:ext>
            </a:extLst>
          </p:cNvPr>
          <p:cNvSpPr/>
          <p:nvPr/>
        </p:nvSpPr>
        <p:spPr>
          <a:xfrm>
            <a:off x="9371138" y="8326165"/>
            <a:ext cx="481891" cy="108499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535" name="Conector recto 534">
            <a:extLst>
              <a:ext uri="{FF2B5EF4-FFF2-40B4-BE49-F238E27FC236}">
                <a16:creationId xmlns:a16="http://schemas.microsoft.com/office/drawing/2014/main" id="{99A5EF39-B265-414B-BF7B-3252F56F987F}"/>
              </a:ext>
            </a:extLst>
          </p:cNvPr>
          <p:cNvCxnSpPr>
            <a:cxnSpLocks/>
          </p:cNvCxnSpPr>
          <p:nvPr/>
        </p:nvCxnSpPr>
        <p:spPr>
          <a:xfrm flipH="1">
            <a:off x="9406446" y="8430057"/>
            <a:ext cx="453332" cy="137852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38" name="Grupo 537">
            <a:extLst>
              <a:ext uri="{FF2B5EF4-FFF2-40B4-BE49-F238E27FC236}">
                <a16:creationId xmlns:a16="http://schemas.microsoft.com/office/drawing/2014/main" id="{E122C851-286D-F54F-8629-C2E8342E202C}"/>
              </a:ext>
            </a:extLst>
          </p:cNvPr>
          <p:cNvGrpSpPr/>
          <p:nvPr/>
        </p:nvGrpSpPr>
        <p:grpSpPr>
          <a:xfrm>
            <a:off x="9745993" y="8114021"/>
            <a:ext cx="838435" cy="509451"/>
            <a:chOff x="8159044" y="4657924"/>
            <a:chExt cx="838435" cy="509451"/>
          </a:xfrm>
        </p:grpSpPr>
        <p:sp>
          <p:nvSpPr>
            <p:cNvPr id="539" name="CuadroTexto 538">
              <a:extLst>
                <a:ext uri="{FF2B5EF4-FFF2-40B4-BE49-F238E27FC236}">
                  <a16:creationId xmlns:a16="http://schemas.microsoft.com/office/drawing/2014/main" id="{96A2E6A4-73D7-C149-B4DB-999DADA6FA93}"/>
                </a:ext>
              </a:extLst>
            </p:cNvPr>
            <p:cNvSpPr txBox="1"/>
            <p:nvPr/>
          </p:nvSpPr>
          <p:spPr>
            <a:xfrm>
              <a:off x="8159044" y="4657924"/>
              <a:ext cx="8384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rgbClr val="00B050"/>
                  </a:solidFill>
                </a:rPr>
                <a:t>￪ IP-10</a:t>
              </a:r>
            </a:p>
          </p:txBody>
        </p:sp>
        <p:sp>
          <p:nvSpPr>
            <p:cNvPr id="540" name="Elipse 539">
              <a:extLst>
                <a:ext uri="{FF2B5EF4-FFF2-40B4-BE49-F238E27FC236}">
                  <a16:creationId xmlns:a16="http://schemas.microsoft.com/office/drawing/2014/main" id="{4078392A-75B4-F746-ABE0-0812F8066568}"/>
                </a:ext>
              </a:extLst>
            </p:cNvPr>
            <p:cNvSpPr>
              <a:spLocks/>
            </p:cNvSpPr>
            <p:nvPr/>
          </p:nvSpPr>
          <p:spPr>
            <a:xfrm>
              <a:off x="8502016" y="4987375"/>
              <a:ext cx="180000" cy="180000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cxnSp>
        <p:nvCxnSpPr>
          <p:cNvPr id="541" name="Conector recto 540">
            <a:extLst>
              <a:ext uri="{FF2B5EF4-FFF2-40B4-BE49-F238E27FC236}">
                <a16:creationId xmlns:a16="http://schemas.microsoft.com/office/drawing/2014/main" id="{51074C9A-5AB1-C044-8416-2B7EB31FBF08}"/>
              </a:ext>
            </a:extLst>
          </p:cNvPr>
          <p:cNvCxnSpPr>
            <a:cxnSpLocks/>
          </p:cNvCxnSpPr>
          <p:nvPr/>
        </p:nvCxnSpPr>
        <p:spPr>
          <a:xfrm flipV="1">
            <a:off x="10055329" y="7780284"/>
            <a:ext cx="124849" cy="360310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45" name="Imagen 544">
            <a:extLst>
              <a:ext uri="{FF2B5EF4-FFF2-40B4-BE49-F238E27FC236}">
                <a16:creationId xmlns:a16="http://schemas.microsoft.com/office/drawing/2014/main" id="{0598CFBC-D5F7-0C40-8F52-36253F1694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86915" y="7579757"/>
            <a:ext cx="360000" cy="341651"/>
          </a:xfrm>
          <a:prstGeom prst="rect">
            <a:avLst/>
          </a:prstGeom>
        </p:spPr>
      </p:pic>
      <p:pic>
        <p:nvPicPr>
          <p:cNvPr id="546" name="Imagen 545">
            <a:extLst>
              <a:ext uri="{FF2B5EF4-FFF2-40B4-BE49-F238E27FC236}">
                <a16:creationId xmlns:a16="http://schemas.microsoft.com/office/drawing/2014/main" id="{00A4E7A1-B083-DA47-8C7D-30BBED5756F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831729">
            <a:off x="10817154" y="8075122"/>
            <a:ext cx="360000" cy="310945"/>
          </a:xfrm>
          <a:prstGeom prst="rect">
            <a:avLst/>
          </a:prstGeom>
        </p:spPr>
      </p:pic>
      <p:cxnSp>
        <p:nvCxnSpPr>
          <p:cNvPr id="547" name="Conector recto 546">
            <a:extLst>
              <a:ext uri="{FF2B5EF4-FFF2-40B4-BE49-F238E27FC236}">
                <a16:creationId xmlns:a16="http://schemas.microsoft.com/office/drawing/2014/main" id="{1AF6BC43-D8FB-2E43-BF11-4C09E79CE006}"/>
              </a:ext>
            </a:extLst>
          </p:cNvPr>
          <p:cNvCxnSpPr>
            <a:cxnSpLocks/>
          </p:cNvCxnSpPr>
          <p:nvPr/>
        </p:nvCxnSpPr>
        <p:spPr>
          <a:xfrm flipV="1">
            <a:off x="10478294" y="7911747"/>
            <a:ext cx="241458" cy="273832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9" name="Conector recto 548">
            <a:extLst>
              <a:ext uri="{FF2B5EF4-FFF2-40B4-BE49-F238E27FC236}">
                <a16:creationId xmlns:a16="http://schemas.microsoft.com/office/drawing/2014/main" id="{A62D5EE2-905A-104A-B5A3-6F4AE0D0B2F5}"/>
              </a:ext>
            </a:extLst>
          </p:cNvPr>
          <p:cNvCxnSpPr>
            <a:cxnSpLocks/>
          </p:cNvCxnSpPr>
          <p:nvPr/>
        </p:nvCxnSpPr>
        <p:spPr>
          <a:xfrm rot="10800000" flipH="1" flipV="1">
            <a:off x="10454508" y="8420664"/>
            <a:ext cx="241458" cy="273832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0" name="Conector recto 549">
            <a:extLst>
              <a:ext uri="{FF2B5EF4-FFF2-40B4-BE49-F238E27FC236}">
                <a16:creationId xmlns:a16="http://schemas.microsoft.com/office/drawing/2014/main" id="{7D677BD3-A5D7-AB45-BBF0-E4BF904F071E}"/>
              </a:ext>
            </a:extLst>
          </p:cNvPr>
          <p:cNvCxnSpPr>
            <a:cxnSpLocks/>
          </p:cNvCxnSpPr>
          <p:nvPr/>
        </p:nvCxnSpPr>
        <p:spPr>
          <a:xfrm flipV="1">
            <a:off x="10509587" y="8275534"/>
            <a:ext cx="360000" cy="0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2" name="CuadroTexto 551">
            <a:extLst>
              <a:ext uri="{FF2B5EF4-FFF2-40B4-BE49-F238E27FC236}">
                <a16:creationId xmlns:a16="http://schemas.microsoft.com/office/drawing/2014/main" id="{EF7C7E74-FFEB-6C46-885D-5C5A4B3942FB}"/>
              </a:ext>
            </a:extLst>
          </p:cNvPr>
          <p:cNvSpPr txBox="1"/>
          <p:nvPr/>
        </p:nvSpPr>
        <p:spPr>
          <a:xfrm>
            <a:off x="10618837" y="8507616"/>
            <a:ext cx="4074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solidFill>
                  <a:srgbClr val="0070C0"/>
                </a:solidFill>
              </a:rPr>
              <a:t>L</a:t>
            </a:r>
            <a:r>
              <a:rPr lang="es-ES" sz="1800" b="1" dirty="0">
                <a:solidFill>
                  <a:srgbClr val="0070C0"/>
                </a:solidFill>
              </a:rPr>
              <a:t>T</a:t>
            </a:r>
          </a:p>
        </p:txBody>
      </p:sp>
      <p:sp>
        <p:nvSpPr>
          <p:cNvPr id="553" name="Forma libre 552">
            <a:extLst>
              <a:ext uri="{FF2B5EF4-FFF2-40B4-BE49-F238E27FC236}">
                <a16:creationId xmlns:a16="http://schemas.microsoft.com/office/drawing/2014/main" id="{1859BF75-44B9-B14B-9119-DE4C8163A0B3}"/>
              </a:ext>
            </a:extLst>
          </p:cNvPr>
          <p:cNvSpPr/>
          <p:nvPr/>
        </p:nvSpPr>
        <p:spPr>
          <a:xfrm>
            <a:off x="10658833" y="834332"/>
            <a:ext cx="481891" cy="108499"/>
          </a:xfrm>
          <a:custGeom>
            <a:avLst/>
            <a:gdLst>
              <a:gd name="connsiteX0" fmla="*/ 13702 w 627477"/>
              <a:gd name="connsiteY0" fmla="*/ 366224 h 366224"/>
              <a:gd name="connsiteX1" fmla="*/ 26228 w 627477"/>
              <a:gd name="connsiteY1" fmla="*/ 140756 h 366224"/>
              <a:gd name="connsiteX2" fmla="*/ 251696 w 627477"/>
              <a:gd name="connsiteY2" fmla="*/ 291068 h 366224"/>
              <a:gd name="connsiteX3" fmla="*/ 226644 w 627477"/>
              <a:gd name="connsiteY3" fmla="*/ 65600 h 366224"/>
              <a:gd name="connsiteX4" fmla="*/ 452113 w 627477"/>
              <a:gd name="connsiteY4" fmla="*/ 203386 h 366224"/>
              <a:gd name="connsiteX5" fmla="*/ 376957 w 627477"/>
              <a:gd name="connsiteY5" fmla="*/ 2969 h 366224"/>
              <a:gd name="connsiteX6" fmla="*/ 539795 w 627477"/>
              <a:gd name="connsiteY6" fmla="*/ 78126 h 366224"/>
              <a:gd name="connsiteX7" fmla="*/ 627477 w 627477"/>
              <a:gd name="connsiteY7" fmla="*/ 2969 h 366224"/>
              <a:gd name="connsiteX0" fmla="*/ 13702 w 627477"/>
              <a:gd name="connsiteY0" fmla="*/ 378823 h 378823"/>
              <a:gd name="connsiteX1" fmla="*/ 26228 w 627477"/>
              <a:gd name="connsiteY1" fmla="*/ 153355 h 378823"/>
              <a:gd name="connsiteX2" fmla="*/ 251696 w 627477"/>
              <a:gd name="connsiteY2" fmla="*/ 303667 h 378823"/>
              <a:gd name="connsiteX3" fmla="*/ 226644 w 627477"/>
              <a:gd name="connsiteY3" fmla="*/ 78199 h 378823"/>
              <a:gd name="connsiteX4" fmla="*/ 452113 w 627477"/>
              <a:gd name="connsiteY4" fmla="*/ 215985 h 378823"/>
              <a:gd name="connsiteX5" fmla="*/ 376957 w 627477"/>
              <a:gd name="connsiteY5" fmla="*/ 15568 h 378823"/>
              <a:gd name="connsiteX6" fmla="*/ 526239 w 627477"/>
              <a:gd name="connsiteY6" fmla="*/ 13463 h 378823"/>
              <a:gd name="connsiteX7" fmla="*/ 627477 w 627477"/>
              <a:gd name="connsiteY7" fmla="*/ 15568 h 378823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26239 w 622838"/>
              <a:gd name="connsiteY6" fmla="*/ 110781 h 476141"/>
              <a:gd name="connsiteX7" fmla="*/ 622838 w 622838"/>
              <a:gd name="connsiteY7" fmla="*/ 0 h 476141"/>
              <a:gd name="connsiteX0" fmla="*/ 13702 w 622838"/>
              <a:gd name="connsiteY0" fmla="*/ 476141 h 476141"/>
              <a:gd name="connsiteX1" fmla="*/ 26228 w 622838"/>
              <a:gd name="connsiteY1" fmla="*/ 250673 h 476141"/>
              <a:gd name="connsiteX2" fmla="*/ 251696 w 622838"/>
              <a:gd name="connsiteY2" fmla="*/ 400985 h 476141"/>
              <a:gd name="connsiteX3" fmla="*/ 226644 w 622838"/>
              <a:gd name="connsiteY3" fmla="*/ 175517 h 476141"/>
              <a:gd name="connsiteX4" fmla="*/ 452113 w 622838"/>
              <a:gd name="connsiteY4" fmla="*/ 313303 h 476141"/>
              <a:gd name="connsiteX5" fmla="*/ 376957 w 622838"/>
              <a:gd name="connsiteY5" fmla="*/ 112886 h 476141"/>
              <a:gd name="connsiteX6" fmla="*/ 503763 w 622838"/>
              <a:gd name="connsiteY6" fmla="*/ 69141 h 476141"/>
              <a:gd name="connsiteX7" fmla="*/ 622838 w 62283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220754 w 616948"/>
              <a:gd name="connsiteY3" fmla="*/ 17551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446223 w 616948"/>
              <a:gd name="connsiteY4" fmla="*/ 313303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7812 w 616948"/>
              <a:gd name="connsiteY0" fmla="*/ 476141 h 476141"/>
              <a:gd name="connsiteX1" fmla="*/ 20338 w 616948"/>
              <a:gd name="connsiteY1" fmla="*/ 250673 h 476141"/>
              <a:gd name="connsiteX2" fmla="*/ 139977 w 616948"/>
              <a:gd name="connsiteY2" fmla="*/ 459162 h 476141"/>
              <a:gd name="connsiteX3" fmla="*/ 187150 w 616948"/>
              <a:gd name="connsiteY3" fmla="*/ 112637 h 476141"/>
              <a:gd name="connsiteX4" fmla="*/ 301333 w 616948"/>
              <a:gd name="connsiteY4" fmla="*/ 362447 h 476141"/>
              <a:gd name="connsiteX5" fmla="*/ 371067 w 616948"/>
              <a:gd name="connsiteY5" fmla="*/ 112886 h 476141"/>
              <a:gd name="connsiteX6" fmla="*/ 497873 w 616948"/>
              <a:gd name="connsiteY6" fmla="*/ 69141 h 476141"/>
              <a:gd name="connsiteX7" fmla="*/ 616948 w 616948"/>
              <a:gd name="connsiteY7" fmla="*/ 0 h 476141"/>
              <a:gd name="connsiteX0" fmla="*/ 1623 w 695805"/>
              <a:gd name="connsiteY0" fmla="*/ 477131 h 477132"/>
              <a:gd name="connsiteX1" fmla="*/ 99195 w 695805"/>
              <a:gd name="connsiteY1" fmla="*/ 250673 h 477132"/>
              <a:gd name="connsiteX2" fmla="*/ 218834 w 695805"/>
              <a:gd name="connsiteY2" fmla="*/ 459162 h 477132"/>
              <a:gd name="connsiteX3" fmla="*/ 266007 w 695805"/>
              <a:gd name="connsiteY3" fmla="*/ 112637 h 477132"/>
              <a:gd name="connsiteX4" fmla="*/ 380190 w 695805"/>
              <a:gd name="connsiteY4" fmla="*/ 362447 h 477132"/>
              <a:gd name="connsiteX5" fmla="*/ 449924 w 695805"/>
              <a:gd name="connsiteY5" fmla="*/ 112886 h 477132"/>
              <a:gd name="connsiteX6" fmla="*/ 576730 w 695805"/>
              <a:gd name="connsiteY6" fmla="*/ 69141 h 477132"/>
              <a:gd name="connsiteX7" fmla="*/ 695805 w 695805"/>
              <a:gd name="connsiteY7" fmla="*/ 0 h 477132"/>
              <a:gd name="connsiteX0" fmla="*/ 0 w 694182"/>
              <a:gd name="connsiteY0" fmla="*/ 477131 h 477132"/>
              <a:gd name="connsiteX1" fmla="*/ 97572 w 694182"/>
              <a:gd name="connsiteY1" fmla="*/ 250673 h 477132"/>
              <a:gd name="connsiteX2" fmla="*/ 217211 w 694182"/>
              <a:gd name="connsiteY2" fmla="*/ 459162 h 477132"/>
              <a:gd name="connsiteX3" fmla="*/ 264384 w 694182"/>
              <a:gd name="connsiteY3" fmla="*/ 112637 h 477132"/>
              <a:gd name="connsiteX4" fmla="*/ 378567 w 694182"/>
              <a:gd name="connsiteY4" fmla="*/ 362447 h 477132"/>
              <a:gd name="connsiteX5" fmla="*/ 448301 w 694182"/>
              <a:gd name="connsiteY5" fmla="*/ 112886 h 477132"/>
              <a:gd name="connsiteX6" fmla="*/ 575107 w 694182"/>
              <a:gd name="connsiteY6" fmla="*/ 69141 h 477132"/>
              <a:gd name="connsiteX7" fmla="*/ 694182 w 694182"/>
              <a:gd name="connsiteY7" fmla="*/ 0 h 4771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94182" h="477132">
                <a:moveTo>
                  <a:pt x="0" y="477131"/>
                </a:moveTo>
                <a:cubicBezTo>
                  <a:pt x="24755" y="362305"/>
                  <a:pt x="61370" y="253668"/>
                  <a:pt x="97572" y="250673"/>
                </a:cubicBezTo>
                <a:cubicBezTo>
                  <a:pt x="133774" y="247678"/>
                  <a:pt x="189409" y="482168"/>
                  <a:pt x="217211" y="459162"/>
                </a:cubicBezTo>
                <a:cubicBezTo>
                  <a:pt x="245013" y="436156"/>
                  <a:pt x="237491" y="128756"/>
                  <a:pt x="264384" y="112637"/>
                </a:cubicBezTo>
                <a:cubicBezTo>
                  <a:pt x="291277" y="96518"/>
                  <a:pt x="347914" y="362406"/>
                  <a:pt x="378567" y="362447"/>
                </a:cubicBezTo>
                <a:cubicBezTo>
                  <a:pt x="409220" y="362488"/>
                  <a:pt x="415544" y="161770"/>
                  <a:pt x="448301" y="112886"/>
                </a:cubicBezTo>
                <a:cubicBezTo>
                  <a:pt x="481058" y="64002"/>
                  <a:pt x="534127" y="87955"/>
                  <a:pt x="575107" y="69141"/>
                </a:cubicBezTo>
                <a:cubicBezTo>
                  <a:pt x="616087" y="50327"/>
                  <a:pt x="671217" y="37578"/>
                  <a:pt x="694182" y="0"/>
                </a:cubicBezTo>
              </a:path>
            </a:pathLst>
          </a:custGeom>
          <a:noFill/>
          <a:ln w="28575">
            <a:solidFill>
              <a:schemeClr val="tx1"/>
            </a:solidFill>
            <a:tailEnd type="triangle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555" name="Grupo 554">
            <a:extLst>
              <a:ext uri="{FF2B5EF4-FFF2-40B4-BE49-F238E27FC236}">
                <a16:creationId xmlns:a16="http://schemas.microsoft.com/office/drawing/2014/main" id="{D989B973-22C5-2E4E-96FD-9E86DEB7E982}"/>
              </a:ext>
            </a:extLst>
          </p:cNvPr>
          <p:cNvGrpSpPr/>
          <p:nvPr/>
        </p:nvGrpSpPr>
        <p:grpSpPr>
          <a:xfrm>
            <a:off x="10975790" y="726230"/>
            <a:ext cx="817853" cy="507668"/>
            <a:chOff x="9775668" y="2748849"/>
            <a:chExt cx="817853" cy="507668"/>
          </a:xfrm>
        </p:grpSpPr>
        <p:sp>
          <p:nvSpPr>
            <p:cNvPr id="556" name="CuadroTexto 555">
              <a:extLst>
                <a:ext uri="{FF2B5EF4-FFF2-40B4-BE49-F238E27FC236}">
                  <a16:creationId xmlns:a16="http://schemas.microsoft.com/office/drawing/2014/main" id="{18859D41-BF6F-3449-9242-897DD87306B5}"/>
                </a:ext>
              </a:extLst>
            </p:cNvPr>
            <p:cNvSpPr txBox="1"/>
            <p:nvPr/>
          </p:nvSpPr>
          <p:spPr>
            <a:xfrm>
              <a:off x="9775668" y="2887185"/>
              <a:ext cx="8178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IL-17</a:t>
              </a:r>
            </a:p>
          </p:txBody>
        </p:sp>
        <p:sp>
          <p:nvSpPr>
            <p:cNvPr id="557" name="Elipse 556">
              <a:extLst>
                <a:ext uri="{FF2B5EF4-FFF2-40B4-BE49-F238E27FC236}">
                  <a16:creationId xmlns:a16="http://schemas.microsoft.com/office/drawing/2014/main" id="{A5914EAA-4268-BA45-86B9-528D1E16B3CF}"/>
                </a:ext>
              </a:extLst>
            </p:cNvPr>
            <p:cNvSpPr>
              <a:spLocks/>
            </p:cNvSpPr>
            <p:nvPr/>
          </p:nvSpPr>
          <p:spPr>
            <a:xfrm>
              <a:off x="10100319" y="2748849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grpSp>
        <p:nvGrpSpPr>
          <p:cNvPr id="558" name="Grupo 557">
            <a:extLst>
              <a:ext uri="{FF2B5EF4-FFF2-40B4-BE49-F238E27FC236}">
                <a16:creationId xmlns:a16="http://schemas.microsoft.com/office/drawing/2014/main" id="{5DBDE9FA-5414-124A-B22E-2C8D45436D9C}"/>
              </a:ext>
            </a:extLst>
          </p:cNvPr>
          <p:cNvGrpSpPr/>
          <p:nvPr/>
        </p:nvGrpSpPr>
        <p:grpSpPr>
          <a:xfrm>
            <a:off x="11290433" y="8691317"/>
            <a:ext cx="1112026" cy="1061666"/>
            <a:chOff x="9639802" y="2748849"/>
            <a:chExt cx="1112026" cy="1061666"/>
          </a:xfrm>
        </p:grpSpPr>
        <p:sp>
          <p:nvSpPr>
            <p:cNvPr id="559" name="CuadroTexto 558">
              <a:extLst>
                <a:ext uri="{FF2B5EF4-FFF2-40B4-BE49-F238E27FC236}">
                  <a16:creationId xmlns:a16="http://schemas.microsoft.com/office/drawing/2014/main" id="{ED03D360-B1BE-6A44-B1F2-4C401C47CAAC}"/>
                </a:ext>
              </a:extLst>
            </p:cNvPr>
            <p:cNvSpPr txBox="1"/>
            <p:nvPr/>
          </p:nvSpPr>
          <p:spPr>
            <a:xfrm>
              <a:off x="9639802" y="2887185"/>
              <a:ext cx="1112026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0" b="1" dirty="0">
                  <a:solidFill>
                    <a:schemeClr val="accent2"/>
                  </a:solidFill>
                </a:rPr>
                <a:t>￪ IL-17</a:t>
              </a:r>
            </a:p>
            <a:p>
              <a:r>
                <a:rPr lang="es-ES" sz="1800" b="1" dirty="0">
                  <a:solidFill>
                    <a:schemeClr val="accent2"/>
                  </a:solidFill>
                </a:rPr>
                <a:t>￪ S100A8</a:t>
              </a:r>
            </a:p>
            <a:p>
              <a:r>
                <a:rPr lang="es-ES" sz="1800" b="1" dirty="0">
                  <a:solidFill>
                    <a:schemeClr val="accent2"/>
                  </a:solidFill>
                </a:rPr>
                <a:t>￪ S100A9</a:t>
              </a:r>
            </a:p>
          </p:txBody>
        </p:sp>
        <p:sp>
          <p:nvSpPr>
            <p:cNvPr id="560" name="Elipse 559">
              <a:extLst>
                <a:ext uri="{FF2B5EF4-FFF2-40B4-BE49-F238E27FC236}">
                  <a16:creationId xmlns:a16="http://schemas.microsoft.com/office/drawing/2014/main" id="{ACF75B56-FCA2-CD46-A026-B86F1E215C06}"/>
                </a:ext>
              </a:extLst>
            </p:cNvPr>
            <p:cNvSpPr>
              <a:spLocks/>
            </p:cNvSpPr>
            <p:nvPr/>
          </p:nvSpPr>
          <p:spPr>
            <a:xfrm>
              <a:off x="10100319" y="2748849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sp>
        <p:nvSpPr>
          <p:cNvPr id="563" name="CuadroTexto 562">
            <a:extLst>
              <a:ext uri="{FF2B5EF4-FFF2-40B4-BE49-F238E27FC236}">
                <a16:creationId xmlns:a16="http://schemas.microsoft.com/office/drawing/2014/main" id="{A8F0E9CC-03F7-C049-8A65-D106D6175111}"/>
              </a:ext>
            </a:extLst>
          </p:cNvPr>
          <p:cNvSpPr txBox="1"/>
          <p:nvPr/>
        </p:nvSpPr>
        <p:spPr>
          <a:xfrm>
            <a:off x="10693174" y="5989132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 TNF-⍺</a:t>
            </a:r>
          </a:p>
        </p:txBody>
      </p:sp>
      <p:sp>
        <p:nvSpPr>
          <p:cNvPr id="564" name="Elipse 563">
            <a:extLst>
              <a:ext uri="{FF2B5EF4-FFF2-40B4-BE49-F238E27FC236}">
                <a16:creationId xmlns:a16="http://schemas.microsoft.com/office/drawing/2014/main" id="{BF0FD194-1039-FB41-B674-96D45C7E7AA1}"/>
              </a:ext>
            </a:extLst>
          </p:cNvPr>
          <p:cNvSpPr>
            <a:spLocks/>
          </p:cNvSpPr>
          <p:nvPr/>
        </p:nvSpPr>
        <p:spPr>
          <a:xfrm>
            <a:off x="11099022" y="5869311"/>
            <a:ext cx="180000" cy="180000"/>
          </a:xfrm>
          <a:prstGeom prst="ellipse">
            <a:avLst/>
          </a:prstGeom>
          <a:solidFill>
            <a:srgbClr val="FF7E79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65" name="CuadroTexto 564">
            <a:extLst>
              <a:ext uri="{FF2B5EF4-FFF2-40B4-BE49-F238E27FC236}">
                <a16:creationId xmlns:a16="http://schemas.microsoft.com/office/drawing/2014/main" id="{FC67DFC0-7C01-C543-868D-0FC3B8CAF4F9}"/>
              </a:ext>
            </a:extLst>
          </p:cNvPr>
          <p:cNvSpPr txBox="1"/>
          <p:nvPr/>
        </p:nvSpPr>
        <p:spPr>
          <a:xfrm>
            <a:off x="11216630" y="6227380"/>
            <a:ext cx="6147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IL-6</a:t>
            </a:r>
          </a:p>
        </p:txBody>
      </p:sp>
      <p:sp>
        <p:nvSpPr>
          <p:cNvPr id="566" name="Elipse 565">
            <a:extLst>
              <a:ext uri="{FF2B5EF4-FFF2-40B4-BE49-F238E27FC236}">
                <a16:creationId xmlns:a16="http://schemas.microsoft.com/office/drawing/2014/main" id="{A0E4DF68-BDEA-AA46-A3FA-4DA4A784C02A}"/>
              </a:ext>
            </a:extLst>
          </p:cNvPr>
          <p:cNvSpPr>
            <a:spLocks/>
          </p:cNvSpPr>
          <p:nvPr/>
        </p:nvSpPr>
        <p:spPr>
          <a:xfrm>
            <a:off x="11506252" y="6051691"/>
            <a:ext cx="180000" cy="180000"/>
          </a:xfrm>
          <a:prstGeom prst="ellipse">
            <a:avLst/>
          </a:prstGeom>
          <a:solidFill>
            <a:srgbClr val="FF7E79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67" name="CuadroTexto 566">
            <a:extLst>
              <a:ext uri="{FF2B5EF4-FFF2-40B4-BE49-F238E27FC236}">
                <a16:creationId xmlns:a16="http://schemas.microsoft.com/office/drawing/2014/main" id="{7D0C0D72-9633-B540-A64F-3CC976B2663F}"/>
              </a:ext>
            </a:extLst>
          </p:cNvPr>
          <p:cNvSpPr txBox="1"/>
          <p:nvPr/>
        </p:nvSpPr>
        <p:spPr>
          <a:xfrm>
            <a:off x="10420910" y="6202034"/>
            <a:ext cx="801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 TGF-β</a:t>
            </a:r>
          </a:p>
        </p:txBody>
      </p:sp>
      <p:sp>
        <p:nvSpPr>
          <p:cNvPr id="568" name="Rectángulo 567">
            <a:extLst>
              <a:ext uri="{FF2B5EF4-FFF2-40B4-BE49-F238E27FC236}">
                <a16:creationId xmlns:a16="http://schemas.microsoft.com/office/drawing/2014/main" id="{76D5174C-CFE2-644F-801A-77EE4C336D68}"/>
              </a:ext>
            </a:extLst>
          </p:cNvPr>
          <p:cNvSpPr/>
          <p:nvPr/>
        </p:nvSpPr>
        <p:spPr>
          <a:xfrm>
            <a:off x="10933514" y="6438986"/>
            <a:ext cx="6575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800" b="1" dirty="0">
                <a:solidFill>
                  <a:schemeClr val="accent2"/>
                </a:solidFill>
              </a:rPr>
              <a:t>IL-1β</a:t>
            </a:r>
            <a:endParaRPr lang="es-ES" sz="1800" dirty="0"/>
          </a:p>
        </p:txBody>
      </p:sp>
      <p:sp>
        <p:nvSpPr>
          <p:cNvPr id="569" name="Elipse 568">
            <a:extLst>
              <a:ext uri="{FF2B5EF4-FFF2-40B4-BE49-F238E27FC236}">
                <a16:creationId xmlns:a16="http://schemas.microsoft.com/office/drawing/2014/main" id="{F2A42EB9-996F-2142-AAD2-0FE6C9898D87}"/>
              </a:ext>
            </a:extLst>
          </p:cNvPr>
          <p:cNvSpPr>
            <a:spLocks/>
          </p:cNvSpPr>
          <p:nvPr/>
        </p:nvSpPr>
        <p:spPr>
          <a:xfrm>
            <a:off x="10413020" y="6099154"/>
            <a:ext cx="180000" cy="180000"/>
          </a:xfrm>
          <a:prstGeom prst="ellipse">
            <a:avLst/>
          </a:prstGeom>
          <a:solidFill>
            <a:srgbClr val="FF7E79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70" name="Elipse 569">
            <a:extLst>
              <a:ext uri="{FF2B5EF4-FFF2-40B4-BE49-F238E27FC236}">
                <a16:creationId xmlns:a16="http://schemas.microsoft.com/office/drawing/2014/main" id="{BAC57CE0-0A63-CC4B-9A17-F2A1EFE45D5D}"/>
              </a:ext>
            </a:extLst>
          </p:cNvPr>
          <p:cNvSpPr>
            <a:spLocks/>
          </p:cNvSpPr>
          <p:nvPr/>
        </p:nvSpPr>
        <p:spPr>
          <a:xfrm>
            <a:off x="10613193" y="6581234"/>
            <a:ext cx="180000" cy="180000"/>
          </a:xfrm>
          <a:prstGeom prst="ellipse">
            <a:avLst/>
          </a:prstGeom>
          <a:solidFill>
            <a:srgbClr val="FF7E79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71" name="Elipse 570">
            <a:extLst>
              <a:ext uri="{FF2B5EF4-FFF2-40B4-BE49-F238E27FC236}">
                <a16:creationId xmlns:a16="http://schemas.microsoft.com/office/drawing/2014/main" id="{234EE423-621A-8848-909D-BAB0AA55841D}"/>
              </a:ext>
            </a:extLst>
          </p:cNvPr>
          <p:cNvSpPr>
            <a:spLocks/>
          </p:cNvSpPr>
          <p:nvPr/>
        </p:nvSpPr>
        <p:spPr>
          <a:xfrm>
            <a:off x="11586543" y="6584418"/>
            <a:ext cx="180000" cy="180000"/>
          </a:xfrm>
          <a:prstGeom prst="ellipse">
            <a:avLst/>
          </a:prstGeom>
          <a:solidFill>
            <a:srgbClr val="FF7E79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cxnSp>
        <p:nvCxnSpPr>
          <p:cNvPr id="403" name="Conector recto 402">
            <a:extLst>
              <a:ext uri="{FF2B5EF4-FFF2-40B4-BE49-F238E27FC236}">
                <a16:creationId xmlns:a16="http://schemas.microsoft.com/office/drawing/2014/main" id="{14EC7068-BF1F-E84A-B38F-4540C7321FB4}"/>
              </a:ext>
            </a:extLst>
          </p:cNvPr>
          <p:cNvCxnSpPr>
            <a:cxnSpLocks/>
          </p:cNvCxnSpPr>
          <p:nvPr/>
        </p:nvCxnSpPr>
        <p:spPr>
          <a:xfrm flipV="1">
            <a:off x="12009181" y="8234219"/>
            <a:ext cx="104279" cy="432773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4" name="Conector recto 403">
            <a:extLst>
              <a:ext uri="{FF2B5EF4-FFF2-40B4-BE49-F238E27FC236}">
                <a16:creationId xmlns:a16="http://schemas.microsoft.com/office/drawing/2014/main" id="{91D5877C-3221-634B-8EFF-33B281624C96}"/>
              </a:ext>
            </a:extLst>
          </p:cNvPr>
          <p:cNvCxnSpPr>
            <a:cxnSpLocks/>
          </p:cNvCxnSpPr>
          <p:nvPr/>
        </p:nvCxnSpPr>
        <p:spPr>
          <a:xfrm>
            <a:off x="8731730" y="8977542"/>
            <a:ext cx="394140" cy="137728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11" name="Grupo 410">
            <a:extLst>
              <a:ext uri="{FF2B5EF4-FFF2-40B4-BE49-F238E27FC236}">
                <a16:creationId xmlns:a16="http://schemas.microsoft.com/office/drawing/2014/main" id="{082368C1-69A6-1545-8413-151B3038CC2C}"/>
              </a:ext>
            </a:extLst>
          </p:cNvPr>
          <p:cNvGrpSpPr/>
          <p:nvPr/>
        </p:nvGrpSpPr>
        <p:grpSpPr>
          <a:xfrm>
            <a:off x="854687" y="1602372"/>
            <a:ext cx="3660101" cy="7595019"/>
            <a:chOff x="854687" y="2022313"/>
            <a:chExt cx="3660101" cy="7595019"/>
          </a:xfrm>
        </p:grpSpPr>
        <p:grpSp>
          <p:nvGrpSpPr>
            <p:cNvPr id="412" name="Grupo 411">
              <a:extLst>
                <a:ext uri="{FF2B5EF4-FFF2-40B4-BE49-F238E27FC236}">
                  <a16:creationId xmlns:a16="http://schemas.microsoft.com/office/drawing/2014/main" id="{66E422BD-B3A6-9046-93A0-B80C330C4C4A}"/>
                </a:ext>
              </a:extLst>
            </p:cNvPr>
            <p:cNvGrpSpPr/>
            <p:nvPr/>
          </p:nvGrpSpPr>
          <p:grpSpPr>
            <a:xfrm>
              <a:off x="1653528" y="2022313"/>
              <a:ext cx="2062419" cy="1868549"/>
              <a:chOff x="180038" y="1132911"/>
              <a:chExt cx="2062419" cy="1868549"/>
            </a:xfrm>
          </p:grpSpPr>
          <p:sp>
            <p:nvSpPr>
              <p:cNvPr id="537" name="Rectángulo redondeado 536">
                <a:extLst>
                  <a:ext uri="{FF2B5EF4-FFF2-40B4-BE49-F238E27FC236}">
                    <a16:creationId xmlns:a16="http://schemas.microsoft.com/office/drawing/2014/main" id="{C8B32567-1E34-A744-82E3-EB0A9648F640}"/>
                  </a:ext>
                </a:extLst>
              </p:cNvPr>
              <p:cNvSpPr/>
              <p:nvPr/>
            </p:nvSpPr>
            <p:spPr>
              <a:xfrm>
                <a:off x="180038" y="1132911"/>
                <a:ext cx="2062419" cy="1868549"/>
              </a:xfrm>
              <a:prstGeom prst="round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42" name="CuadroTexto 541">
                <a:extLst>
                  <a:ext uri="{FF2B5EF4-FFF2-40B4-BE49-F238E27FC236}">
                    <a16:creationId xmlns:a16="http://schemas.microsoft.com/office/drawing/2014/main" id="{05F4CA63-9F69-FD46-8617-CF2E8771A0FA}"/>
                  </a:ext>
                </a:extLst>
              </p:cNvPr>
              <p:cNvSpPr txBox="1"/>
              <p:nvPr/>
            </p:nvSpPr>
            <p:spPr>
              <a:xfrm>
                <a:off x="286115" y="1132911"/>
                <a:ext cx="185026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2000" b="1" dirty="0" err="1"/>
                  <a:t>Arrow</a:t>
                </a:r>
                <a:r>
                  <a:rPr lang="es-ES" sz="2000" b="1" dirty="0"/>
                  <a:t> </a:t>
                </a:r>
                <a:r>
                  <a:rPr lang="es-ES" sz="2000" b="1" dirty="0" err="1"/>
                  <a:t>Legend</a:t>
                </a:r>
                <a:endParaRPr lang="es-ES" sz="2000" b="1" dirty="0"/>
              </a:p>
            </p:txBody>
          </p:sp>
          <p:cxnSp>
            <p:nvCxnSpPr>
              <p:cNvPr id="543" name="Conector recto 542">
                <a:extLst>
                  <a:ext uri="{FF2B5EF4-FFF2-40B4-BE49-F238E27FC236}">
                    <a16:creationId xmlns:a16="http://schemas.microsoft.com/office/drawing/2014/main" id="{617EF490-AE7B-8A4D-9CCA-553ECD5427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7586" y="1683538"/>
                <a:ext cx="468000" cy="0"/>
              </a:xfrm>
              <a:prstGeom prst="line">
                <a:avLst/>
              </a:prstGeom>
              <a:ln w="28575">
                <a:solidFill>
                  <a:srgbClr val="C00000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4" name="CuadroTexto 543">
                <a:extLst>
                  <a:ext uri="{FF2B5EF4-FFF2-40B4-BE49-F238E27FC236}">
                    <a16:creationId xmlns:a16="http://schemas.microsoft.com/office/drawing/2014/main" id="{5E19B79C-E57F-E94D-97BA-17AD71444B7C}"/>
                  </a:ext>
                </a:extLst>
              </p:cNvPr>
              <p:cNvSpPr txBox="1"/>
              <p:nvPr/>
            </p:nvSpPr>
            <p:spPr>
              <a:xfrm>
                <a:off x="1049846" y="1514261"/>
                <a:ext cx="102290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 err="1"/>
                  <a:t>Activation</a:t>
                </a:r>
                <a:endParaRPr lang="es-ES" sz="1600" dirty="0"/>
              </a:p>
            </p:txBody>
          </p:sp>
          <p:grpSp>
            <p:nvGrpSpPr>
              <p:cNvPr id="548" name="Grupo 547">
                <a:extLst>
                  <a:ext uri="{FF2B5EF4-FFF2-40B4-BE49-F238E27FC236}">
                    <a16:creationId xmlns:a16="http://schemas.microsoft.com/office/drawing/2014/main" id="{4401F869-38F4-F245-96A4-5A8FA8650799}"/>
                  </a:ext>
                </a:extLst>
              </p:cNvPr>
              <p:cNvGrpSpPr/>
              <p:nvPr/>
            </p:nvGrpSpPr>
            <p:grpSpPr>
              <a:xfrm rot="5400000">
                <a:off x="359204" y="1734822"/>
                <a:ext cx="222395" cy="385631"/>
                <a:chOff x="12373099" y="2324548"/>
                <a:chExt cx="222395" cy="466053"/>
              </a:xfrm>
            </p:grpSpPr>
            <p:cxnSp>
              <p:nvCxnSpPr>
                <p:cNvPr id="608" name="Conector recto 607">
                  <a:extLst>
                    <a:ext uri="{FF2B5EF4-FFF2-40B4-BE49-F238E27FC236}">
                      <a16:creationId xmlns:a16="http://schemas.microsoft.com/office/drawing/2014/main" id="{D9E3FB38-8402-5E45-8C9E-6ED0B7126BB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2484297" y="2325002"/>
                  <a:ext cx="0" cy="465599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tailEnd type="non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9" name="Conector recto 608">
                  <a:extLst>
                    <a:ext uri="{FF2B5EF4-FFF2-40B4-BE49-F238E27FC236}">
                      <a16:creationId xmlns:a16="http://schemas.microsoft.com/office/drawing/2014/main" id="{9F0CE556-9E79-9F47-AB28-24F4C552DF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373099" y="2324548"/>
                  <a:ext cx="222395" cy="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tailEnd type="non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51" name="CuadroTexto 550">
                <a:extLst>
                  <a:ext uri="{FF2B5EF4-FFF2-40B4-BE49-F238E27FC236}">
                    <a16:creationId xmlns:a16="http://schemas.microsoft.com/office/drawing/2014/main" id="{A03C4E9C-EFD2-9B42-A5A9-162A6AEA18E3}"/>
                  </a:ext>
                </a:extLst>
              </p:cNvPr>
              <p:cNvSpPr txBox="1"/>
              <p:nvPr/>
            </p:nvSpPr>
            <p:spPr>
              <a:xfrm>
                <a:off x="1069820" y="1758360"/>
                <a:ext cx="9829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 err="1"/>
                  <a:t>Inhibition</a:t>
                </a:r>
                <a:endParaRPr lang="es-ES" sz="1600" dirty="0"/>
              </a:p>
            </p:txBody>
          </p:sp>
          <p:sp>
            <p:nvSpPr>
              <p:cNvPr id="554" name="Forma libre 553">
                <a:extLst>
                  <a:ext uri="{FF2B5EF4-FFF2-40B4-BE49-F238E27FC236}">
                    <a16:creationId xmlns:a16="http://schemas.microsoft.com/office/drawing/2014/main" id="{C7C4B15B-F488-F04C-9D54-432178A241D8}"/>
                  </a:ext>
                </a:extLst>
              </p:cNvPr>
              <p:cNvSpPr/>
              <p:nvPr/>
            </p:nvSpPr>
            <p:spPr>
              <a:xfrm rot="762118">
                <a:off x="283788" y="2136462"/>
                <a:ext cx="468000" cy="108499"/>
              </a:xfrm>
              <a:custGeom>
                <a:avLst/>
                <a:gdLst>
                  <a:gd name="connsiteX0" fmla="*/ 13702 w 627477"/>
                  <a:gd name="connsiteY0" fmla="*/ 366224 h 366224"/>
                  <a:gd name="connsiteX1" fmla="*/ 26228 w 627477"/>
                  <a:gd name="connsiteY1" fmla="*/ 140756 h 366224"/>
                  <a:gd name="connsiteX2" fmla="*/ 251696 w 627477"/>
                  <a:gd name="connsiteY2" fmla="*/ 291068 h 366224"/>
                  <a:gd name="connsiteX3" fmla="*/ 226644 w 627477"/>
                  <a:gd name="connsiteY3" fmla="*/ 65600 h 366224"/>
                  <a:gd name="connsiteX4" fmla="*/ 452113 w 627477"/>
                  <a:gd name="connsiteY4" fmla="*/ 203386 h 366224"/>
                  <a:gd name="connsiteX5" fmla="*/ 376957 w 627477"/>
                  <a:gd name="connsiteY5" fmla="*/ 2969 h 366224"/>
                  <a:gd name="connsiteX6" fmla="*/ 539795 w 627477"/>
                  <a:gd name="connsiteY6" fmla="*/ 78126 h 366224"/>
                  <a:gd name="connsiteX7" fmla="*/ 627477 w 627477"/>
                  <a:gd name="connsiteY7" fmla="*/ 2969 h 366224"/>
                  <a:gd name="connsiteX0" fmla="*/ 13702 w 627477"/>
                  <a:gd name="connsiteY0" fmla="*/ 378823 h 378823"/>
                  <a:gd name="connsiteX1" fmla="*/ 26228 w 627477"/>
                  <a:gd name="connsiteY1" fmla="*/ 153355 h 378823"/>
                  <a:gd name="connsiteX2" fmla="*/ 251696 w 627477"/>
                  <a:gd name="connsiteY2" fmla="*/ 303667 h 378823"/>
                  <a:gd name="connsiteX3" fmla="*/ 226644 w 627477"/>
                  <a:gd name="connsiteY3" fmla="*/ 78199 h 378823"/>
                  <a:gd name="connsiteX4" fmla="*/ 452113 w 627477"/>
                  <a:gd name="connsiteY4" fmla="*/ 215985 h 378823"/>
                  <a:gd name="connsiteX5" fmla="*/ 376957 w 627477"/>
                  <a:gd name="connsiteY5" fmla="*/ 15568 h 378823"/>
                  <a:gd name="connsiteX6" fmla="*/ 526239 w 627477"/>
                  <a:gd name="connsiteY6" fmla="*/ 13463 h 378823"/>
                  <a:gd name="connsiteX7" fmla="*/ 627477 w 627477"/>
                  <a:gd name="connsiteY7" fmla="*/ 15568 h 378823"/>
                  <a:gd name="connsiteX0" fmla="*/ 13702 w 622838"/>
                  <a:gd name="connsiteY0" fmla="*/ 476141 h 476141"/>
                  <a:gd name="connsiteX1" fmla="*/ 26228 w 622838"/>
                  <a:gd name="connsiteY1" fmla="*/ 250673 h 476141"/>
                  <a:gd name="connsiteX2" fmla="*/ 251696 w 622838"/>
                  <a:gd name="connsiteY2" fmla="*/ 400985 h 476141"/>
                  <a:gd name="connsiteX3" fmla="*/ 226644 w 622838"/>
                  <a:gd name="connsiteY3" fmla="*/ 175517 h 476141"/>
                  <a:gd name="connsiteX4" fmla="*/ 452113 w 622838"/>
                  <a:gd name="connsiteY4" fmla="*/ 313303 h 476141"/>
                  <a:gd name="connsiteX5" fmla="*/ 376957 w 622838"/>
                  <a:gd name="connsiteY5" fmla="*/ 112886 h 476141"/>
                  <a:gd name="connsiteX6" fmla="*/ 526239 w 622838"/>
                  <a:gd name="connsiteY6" fmla="*/ 110781 h 476141"/>
                  <a:gd name="connsiteX7" fmla="*/ 622838 w 622838"/>
                  <a:gd name="connsiteY7" fmla="*/ 0 h 476141"/>
                  <a:gd name="connsiteX0" fmla="*/ 13702 w 622838"/>
                  <a:gd name="connsiteY0" fmla="*/ 476141 h 476141"/>
                  <a:gd name="connsiteX1" fmla="*/ 26228 w 622838"/>
                  <a:gd name="connsiteY1" fmla="*/ 250673 h 476141"/>
                  <a:gd name="connsiteX2" fmla="*/ 251696 w 622838"/>
                  <a:gd name="connsiteY2" fmla="*/ 400985 h 476141"/>
                  <a:gd name="connsiteX3" fmla="*/ 226644 w 622838"/>
                  <a:gd name="connsiteY3" fmla="*/ 175517 h 476141"/>
                  <a:gd name="connsiteX4" fmla="*/ 452113 w 622838"/>
                  <a:gd name="connsiteY4" fmla="*/ 313303 h 476141"/>
                  <a:gd name="connsiteX5" fmla="*/ 376957 w 622838"/>
                  <a:gd name="connsiteY5" fmla="*/ 112886 h 476141"/>
                  <a:gd name="connsiteX6" fmla="*/ 503763 w 622838"/>
                  <a:gd name="connsiteY6" fmla="*/ 69141 h 476141"/>
                  <a:gd name="connsiteX7" fmla="*/ 622838 w 622838"/>
                  <a:gd name="connsiteY7" fmla="*/ 0 h 476141"/>
                  <a:gd name="connsiteX0" fmla="*/ 7812 w 616948"/>
                  <a:gd name="connsiteY0" fmla="*/ 476141 h 476141"/>
                  <a:gd name="connsiteX1" fmla="*/ 20338 w 616948"/>
                  <a:gd name="connsiteY1" fmla="*/ 250673 h 476141"/>
                  <a:gd name="connsiteX2" fmla="*/ 139977 w 616948"/>
                  <a:gd name="connsiteY2" fmla="*/ 459162 h 476141"/>
                  <a:gd name="connsiteX3" fmla="*/ 220754 w 616948"/>
                  <a:gd name="connsiteY3" fmla="*/ 175517 h 476141"/>
                  <a:gd name="connsiteX4" fmla="*/ 446223 w 616948"/>
                  <a:gd name="connsiteY4" fmla="*/ 313303 h 476141"/>
                  <a:gd name="connsiteX5" fmla="*/ 371067 w 616948"/>
                  <a:gd name="connsiteY5" fmla="*/ 112886 h 476141"/>
                  <a:gd name="connsiteX6" fmla="*/ 497873 w 616948"/>
                  <a:gd name="connsiteY6" fmla="*/ 69141 h 476141"/>
                  <a:gd name="connsiteX7" fmla="*/ 616948 w 616948"/>
                  <a:gd name="connsiteY7" fmla="*/ 0 h 476141"/>
                  <a:gd name="connsiteX0" fmla="*/ 7812 w 616948"/>
                  <a:gd name="connsiteY0" fmla="*/ 476141 h 476141"/>
                  <a:gd name="connsiteX1" fmla="*/ 20338 w 616948"/>
                  <a:gd name="connsiteY1" fmla="*/ 250673 h 476141"/>
                  <a:gd name="connsiteX2" fmla="*/ 139977 w 616948"/>
                  <a:gd name="connsiteY2" fmla="*/ 459162 h 476141"/>
                  <a:gd name="connsiteX3" fmla="*/ 187150 w 616948"/>
                  <a:gd name="connsiteY3" fmla="*/ 112637 h 476141"/>
                  <a:gd name="connsiteX4" fmla="*/ 446223 w 616948"/>
                  <a:gd name="connsiteY4" fmla="*/ 313303 h 476141"/>
                  <a:gd name="connsiteX5" fmla="*/ 371067 w 616948"/>
                  <a:gd name="connsiteY5" fmla="*/ 112886 h 476141"/>
                  <a:gd name="connsiteX6" fmla="*/ 497873 w 616948"/>
                  <a:gd name="connsiteY6" fmla="*/ 69141 h 476141"/>
                  <a:gd name="connsiteX7" fmla="*/ 616948 w 616948"/>
                  <a:gd name="connsiteY7" fmla="*/ 0 h 476141"/>
                  <a:gd name="connsiteX0" fmla="*/ 7812 w 616948"/>
                  <a:gd name="connsiteY0" fmla="*/ 476141 h 476141"/>
                  <a:gd name="connsiteX1" fmla="*/ 20338 w 616948"/>
                  <a:gd name="connsiteY1" fmla="*/ 250673 h 476141"/>
                  <a:gd name="connsiteX2" fmla="*/ 139977 w 616948"/>
                  <a:gd name="connsiteY2" fmla="*/ 459162 h 476141"/>
                  <a:gd name="connsiteX3" fmla="*/ 187150 w 616948"/>
                  <a:gd name="connsiteY3" fmla="*/ 112637 h 476141"/>
                  <a:gd name="connsiteX4" fmla="*/ 301333 w 616948"/>
                  <a:gd name="connsiteY4" fmla="*/ 362447 h 476141"/>
                  <a:gd name="connsiteX5" fmla="*/ 371067 w 616948"/>
                  <a:gd name="connsiteY5" fmla="*/ 112886 h 476141"/>
                  <a:gd name="connsiteX6" fmla="*/ 497873 w 616948"/>
                  <a:gd name="connsiteY6" fmla="*/ 69141 h 476141"/>
                  <a:gd name="connsiteX7" fmla="*/ 616948 w 616948"/>
                  <a:gd name="connsiteY7" fmla="*/ 0 h 476141"/>
                  <a:gd name="connsiteX0" fmla="*/ 1623 w 695805"/>
                  <a:gd name="connsiteY0" fmla="*/ 477131 h 477132"/>
                  <a:gd name="connsiteX1" fmla="*/ 99195 w 695805"/>
                  <a:gd name="connsiteY1" fmla="*/ 250673 h 477132"/>
                  <a:gd name="connsiteX2" fmla="*/ 218834 w 695805"/>
                  <a:gd name="connsiteY2" fmla="*/ 459162 h 477132"/>
                  <a:gd name="connsiteX3" fmla="*/ 266007 w 695805"/>
                  <a:gd name="connsiteY3" fmla="*/ 112637 h 477132"/>
                  <a:gd name="connsiteX4" fmla="*/ 380190 w 695805"/>
                  <a:gd name="connsiteY4" fmla="*/ 362447 h 477132"/>
                  <a:gd name="connsiteX5" fmla="*/ 449924 w 695805"/>
                  <a:gd name="connsiteY5" fmla="*/ 112886 h 477132"/>
                  <a:gd name="connsiteX6" fmla="*/ 576730 w 695805"/>
                  <a:gd name="connsiteY6" fmla="*/ 69141 h 477132"/>
                  <a:gd name="connsiteX7" fmla="*/ 695805 w 695805"/>
                  <a:gd name="connsiteY7" fmla="*/ 0 h 477132"/>
                  <a:gd name="connsiteX0" fmla="*/ 0 w 694182"/>
                  <a:gd name="connsiteY0" fmla="*/ 477131 h 477132"/>
                  <a:gd name="connsiteX1" fmla="*/ 97572 w 694182"/>
                  <a:gd name="connsiteY1" fmla="*/ 250673 h 477132"/>
                  <a:gd name="connsiteX2" fmla="*/ 217211 w 694182"/>
                  <a:gd name="connsiteY2" fmla="*/ 459162 h 477132"/>
                  <a:gd name="connsiteX3" fmla="*/ 264384 w 694182"/>
                  <a:gd name="connsiteY3" fmla="*/ 112637 h 477132"/>
                  <a:gd name="connsiteX4" fmla="*/ 378567 w 694182"/>
                  <a:gd name="connsiteY4" fmla="*/ 362447 h 477132"/>
                  <a:gd name="connsiteX5" fmla="*/ 448301 w 694182"/>
                  <a:gd name="connsiteY5" fmla="*/ 112886 h 477132"/>
                  <a:gd name="connsiteX6" fmla="*/ 575107 w 694182"/>
                  <a:gd name="connsiteY6" fmla="*/ 69141 h 477132"/>
                  <a:gd name="connsiteX7" fmla="*/ 694182 w 694182"/>
                  <a:gd name="connsiteY7" fmla="*/ 0 h 47713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694182" h="477132">
                    <a:moveTo>
                      <a:pt x="0" y="477131"/>
                    </a:moveTo>
                    <a:cubicBezTo>
                      <a:pt x="24755" y="362305"/>
                      <a:pt x="61370" y="253668"/>
                      <a:pt x="97572" y="250673"/>
                    </a:cubicBezTo>
                    <a:cubicBezTo>
                      <a:pt x="133774" y="247678"/>
                      <a:pt x="189409" y="482168"/>
                      <a:pt x="217211" y="459162"/>
                    </a:cubicBezTo>
                    <a:cubicBezTo>
                      <a:pt x="245013" y="436156"/>
                      <a:pt x="237491" y="128756"/>
                      <a:pt x="264384" y="112637"/>
                    </a:cubicBezTo>
                    <a:cubicBezTo>
                      <a:pt x="291277" y="96518"/>
                      <a:pt x="347914" y="362406"/>
                      <a:pt x="378567" y="362447"/>
                    </a:cubicBezTo>
                    <a:cubicBezTo>
                      <a:pt x="409220" y="362488"/>
                      <a:pt x="415544" y="161770"/>
                      <a:pt x="448301" y="112886"/>
                    </a:cubicBezTo>
                    <a:cubicBezTo>
                      <a:pt x="481058" y="64002"/>
                      <a:pt x="534127" y="87955"/>
                      <a:pt x="575107" y="69141"/>
                    </a:cubicBezTo>
                    <a:cubicBezTo>
                      <a:pt x="616087" y="50327"/>
                      <a:pt x="671217" y="37578"/>
                      <a:pt x="694182" y="0"/>
                    </a:cubicBezTo>
                  </a:path>
                </a:pathLst>
              </a:custGeom>
              <a:noFill/>
              <a:ln w="28575">
                <a:solidFill>
                  <a:schemeClr val="tx1"/>
                </a:solidFill>
                <a:tailEnd type="triangle" w="lg" len="lg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562" name="CuadroTexto 561">
                <a:extLst>
                  <a:ext uri="{FF2B5EF4-FFF2-40B4-BE49-F238E27FC236}">
                    <a16:creationId xmlns:a16="http://schemas.microsoft.com/office/drawing/2014/main" id="{CC60A90B-C153-A94E-BF54-0F99D01D65CF}"/>
                  </a:ext>
                </a:extLst>
              </p:cNvPr>
              <p:cNvSpPr txBox="1"/>
              <p:nvPr/>
            </p:nvSpPr>
            <p:spPr>
              <a:xfrm>
                <a:off x="1148559" y="2021434"/>
                <a:ext cx="82548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 err="1"/>
                  <a:t>Release</a:t>
                </a:r>
                <a:endParaRPr lang="es-ES" sz="1600" dirty="0"/>
              </a:p>
            </p:txBody>
          </p:sp>
          <p:cxnSp>
            <p:nvCxnSpPr>
              <p:cNvPr id="585" name="Conector recto 584">
                <a:extLst>
                  <a:ext uri="{FF2B5EF4-FFF2-40B4-BE49-F238E27FC236}">
                    <a16:creationId xmlns:a16="http://schemas.microsoft.com/office/drawing/2014/main" id="{E436B79C-4593-B54E-BA92-B2B0FAD91F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7586" y="2451618"/>
                <a:ext cx="468000" cy="0"/>
              </a:xfrm>
              <a:prstGeom prst="line">
                <a:avLst/>
              </a:prstGeom>
              <a:ln w="28575">
                <a:solidFill>
                  <a:srgbClr val="C00000"/>
                </a:solidFill>
                <a:prstDash val="sysDash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1" name="CuadroTexto 590">
                <a:extLst>
                  <a:ext uri="{FF2B5EF4-FFF2-40B4-BE49-F238E27FC236}">
                    <a16:creationId xmlns:a16="http://schemas.microsoft.com/office/drawing/2014/main" id="{4E337625-AB6F-D749-AB9C-1C5D50434DD9}"/>
                  </a:ext>
                </a:extLst>
              </p:cNvPr>
              <p:cNvSpPr txBox="1"/>
              <p:nvPr/>
            </p:nvSpPr>
            <p:spPr>
              <a:xfrm>
                <a:off x="1152438" y="2282341"/>
                <a:ext cx="81772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 err="1"/>
                  <a:t>Process</a:t>
                </a:r>
                <a:endParaRPr lang="es-ES" sz="1600" dirty="0"/>
              </a:p>
            </p:txBody>
          </p:sp>
          <p:pic>
            <p:nvPicPr>
              <p:cNvPr id="594" name="Imagen 593">
                <a:extLst>
                  <a:ext uri="{FF2B5EF4-FFF2-40B4-BE49-F238E27FC236}">
                    <a16:creationId xmlns:a16="http://schemas.microsoft.com/office/drawing/2014/main" id="{1299587D-58EB-724D-AE36-272DBBAE4D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277586" y="2572916"/>
                <a:ext cx="900000" cy="265179"/>
              </a:xfrm>
              <a:prstGeom prst="rect">
                <a:avLst/>
              </a:prstGeom>
            </p:spPr>
          </p:pic>
          <p:sp>
            <p:nvSpPr>
              <p:cNvPr id="605" name="CuadroTexto 604">
                <a:extLst>
                  <a:ext uri="{FF2B5EF4-FFF2-40B4-BE49-F238E27FC236}">
                    <a16:creationId xmlns:a16="http://schemas.microsoft.com/office/drawing/2014/main" id="{98FEB123-04DA-0E4E-AD47-F9586D7CE230}"/>
                  </a:ext>
                </a:extLst>
              </p:cNvPr>
              <p:cNvSpPr txBox="1"/>
              <p:nvPr/>
            </p:nvSpPr>
            <p:spPr>
              <a:xfrm>
                <a:off x="1188955" y="2544880"/>
                <a:ext cx="74469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/>
                  <a:t>Rolling</a:t>
                </a:r>
              </a:p>
            </p:txBody>
          </p:sp>
        </p:grpSp>
        <p:sp>
          <p:nvSpPr>
            <p:cNvPr id="413" name="Rectángulo redondeado 412">
              <a:extLst>
                <a:ext uri="{FF2B5EF4-FFF2-40B4-BE49-F238E27FC236}">
                  <a16:creationId xmlns:a16="http://schemas.microsoft.com/office/drawing/2014/main" id="{4592E6CF-87B5-2E4B-B747-6F5C1DAC0F40}"/>
                </a:ext>
              </a:extLst>
            </p:cNvPr>
            <p:cNvSpPr/>
            <p:nvPr/>
          </p:nvSpPr>
          <p:spPr>
            <a:xfrm>
              <a:off x="854687" y="4163906"/>
              <a:ext cx="3660101" cy="5453426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14" name="CuadroTexto 413">
              <a:extLst>
                <a:ext uri="{FF2B5EF4-FFF2-40B4-BE49-F238E27FC236}">
                  <a16:creationId xmlns:a16="http://schemas.microsoft.com/office/drawing/2014/main" id="{B69ACDEB-CF7C-0441-97F0-2B800B6F91FB}"/>
                </a:ext>
              </a:extLst>
            </p:cNvPr>
            <p:cNvSpPr txBox="1"/>
            <p:nvPr/>
          </p:nvSpPr>
          <p:spPr>
            <a:xfrm>
              <a:off x="1853035" y="4183800"/>
              <a:ext cx="166340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b="1" dirty="0"/>
                <a:t>Figure </a:t>
              </a:r>
              <a:r>
                <a:rPr lang="es-ES" sz="2000" b="1" dirty="0" err="1"/>
                <a:t>Legend</a:t>
              </a:r>
              <a:endParaRPr lang="es-ES" sz="2000" b="1" dirty="0"/>
            </a:p>
          </p:txBody>
        </p:sp>
        <p:pic>
          <p:nvPicPr>
            <p:cNvPr id="415" name="Imagen 414">
              <a:extLst>
                <a:ext uri="{FF2B5EF4-FFF2-40B4-BE49-F238E27FC236}">
                  <a16:creationId xmlns:a16="http://schemas.microsoft.com/office/drawing/2014/main" id="{2A5648DB-E203-8E46-BD3F-009C24B91AFB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100541" y="7404260"/>
              <a:ext cx="421537" cy="360000"/>
            </a:xfrm>
            <a:prstGeom prst="rect">
              <a:avLst/>
            </a:prstGeom>
          </p:spPr>
        </p:pic>
        <p:pic>
          <p:nvPicPr>
            <p:cNvPr id="416" name="Imagen 415">
              <a:extLst>
                <a:ext uri="{FF2B5EF4-FFF2-40B4-BE49-F238E27FC236}">
                  <a16:creationId xmlns:a16="http://schemas.microsoft.com/office/drawing/2014/main" id="{97AD2483-0A17-FC41-9265-61E33A69C0A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21642" y="4793802"/>
              <a:ext cx="379334" cy="360000"/>
            </a:xfrm>
            <a:prstGeom prst="rect">
              <a:avLst/>
            </a:prstGeom>
          </p:spPr>
        </p:pic>
        <p:pic>
          <p:nvPicPr>
            <p:cNvPr id="417" name="Imagen 416">
              <a:extLst>
                <a:ext uri="{FF2B5EF4-FFF2-40B4-BE49-F238E27FC236}">
                  <a16:creationId xmlns:a16="http://schemas.microsoft.com/office/drawing/2014/main" id="{BE25DBDA-DDF5-A743-87CC-923CA4BDD33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602056" y="5200252"/>
              <a:ext cx="360000" cy="360000"/>
            </a:xfrm>
            <a:prstGeom prst="rect">
              <a:avLst/>
            </a:prstGeom>
          </p:spPr>
        </p:pic>
        <p:pic>
          <p:nvPicPr>
            <p:cNvPr id="418" name="Imagen 417">
              <a:extLst>
                <a:ext uri="{FF2B5EF4-FFF2-40B4-BE49-F238E27FC236}">
                  <a16:creationId xmlns:a16="http://schemas.microsoft.com/office/drawing/2014/main" id="{CF4FA245-9220-3846-B954-565AEAB58AC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92872" y="7404260"/>
              <a:ext cx="378368" cy="360000"/>
            </a:xfrm>
            <a:prstGeom prst="rect">
              <a:avLst/>
            </a:prstGeom>
          </p:spPr>
        </p:pic>
        <p:pic>
          <p:nvPicPr>
            <p:cNvPr id="419" name="Imagen 418">
              <a:extLst>
                <a:ext uri="{FF2B5EF4-FFF2-40B4-BE49-F238E27FC236}">
                  <a16:creationId xmlns:a16="http://schemas.microsoft.com/office/drawing/2014/main" id="{69656F64-8D82-EB4A-AB9A-61F740C3FF1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02056" y="6946291"/>
              <a:ext cx="360000" cy="360000"/>
            </a:xfrm>
            <a:prstGeom prst="rect">
              <a:avLst/>
            </a:prstGeom>
          </p:spPr>
        </p:pic>
        <p:pic>
          <p:nvPicPr>
            <p:cNvPr id="420" name="Imagen 419">
              <a:extLst>
                <a:ext uri="{FF2B5EF4-FFF2-40B4-BE49-F238E27FC236}">
                  <a16:creationId xmlns:a16="http://schemas.microsoft.com/office/drawing/2014/main" id="{9974388C-F239-174F-A785-84DE5FB8005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929808" y="6049982"/>
              <a:ext cx="763002" cy="355793"/>
            </a:xfrm>
            <a:prstGeom prst="rect">
              <a:avLst/>
            </a:prstGeom>
          </p:spPr>
        </p:pic>
        <p:pic>
          <p:nvPicPr>
            <p:cNvPr id="421" name="Imagen 420">
              <a:extLst>
                <a:ext uri="{FF2B5EF4-FFF2-40B4-BE49-F238E27FC236}">
                  <a16:creationId xmlns:a16="http://schemas.microsoft.com/office/drawing/2014/main" id="{12AAF306-4D57-CF4A-84C8-E5C21137928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73659" y="4793802"/>
              <a:ext cx="416794" cy="360000"/>
            </a:xfrm>
            <a:prstGeom prst="rect">
              <a:avLst/>
            </a:prstGeom>
          </p:spPr>
        </p:pic>
        <p:pic>
          <p:nvPicPr>
            <p:cNvPr id="423" name="Imagen 422">
              <a:extLst>
                <a:ext uri="{FF2B5EF4-FFF2-40B4-BE49-F238E27FC236}">
                  <a16:creationId xmlns:a16="http://schemas.microsoft.com/office/drawing/2014/main" id="{4E3121B2-CD0D-D744-9B5C-6C11457CDDD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tretch>
              <a:fillRect/>
            </a:stretch>
          </p:blipFill>
          <p:spPr>
            <a:xfrm>
              <a:off x="2591751" y="5642832"/>
              <a:ext cx="380611" cy="360000"/>
            </a:xfrm>
            <a:prstGeom prst="rect">
              <a:avLst/>
            </a:prstGeom>
          </p:spPr>
        </p:pic>
        <p:pic>
          <p:nvPicPr>
            <p:cNvPr id="436" name="Imagen 435">
              <a:extLst>
                <a:ext uri="{FF2B5EF4-FFF2-40B4-BE49-F238E27FC236}">
                  <a16:creationId xmlns:a16="http://schemas.microsoft.com/office/drawing/2014/main" id="{2BDB5C91-6E3F-E444-9B5D-6F3893468F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584056" y="6044665"/>
              <a:ext cx="396000" cy="366427"/>
            </a:xfrm>
            <a:prstGeom prst="rect">
              <a:avLst/>
            </a:prstGeom>
          </p:spPr>
        </p:pic>
        <p:sp>
          <p:nvSpPr>
            <p:cNvPr id="439" name="Nube 438">
              <a:extLst>
                <a:ext uri="{FF2B5EF4-FFF2-40B4-BE49-F238E27FC236}">
                  <a16:creationId xmlns:a16="http://schemas.microsoft.com/office/drawing/2014/main" id="{831E8AA6-7F99-1544-98C8-34F3BEC02220}"/>
                </a:ext>
              </a:extLst>
            </p:cNvPr>
            <p:cNvSpPr/>
            <p:nvPr/>
          </p:nvSpPr>
          <p:spPr>
            <a:xfrm>
              <a:off x="1183070" y="7003628"/>
              <a:ext cx="256478" cy="245327"/>
            </a:xfrm>
            <a:prstGeom prst="cloud">
              <a:avLst/>
            </a:prstGeom>
            <a:solidFill>
              <a:schemeClr val="accent2">
                <a:lumMod val="60000"/>
                <a:lumOff val="40000"/>
                <a:alpha val="65098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1" name="Elipse 460">
              <a:extLst>
                <a:ext uri="{FF2B5EF4-FFF2-40B4-BE49-F238E27FC236}">
                  <a16:creationId xmlns:a16="http://schemas.microsoft.com/office/drawing/2014/main" id="{74A051EC-FFD3-E34E-B6A2-4F11C92C202D}"/>
                </a:ext>
              </a:extLst>
            </p:cNvPr>
            <p:cNvSpPr>
              <a:spLocks/>
            </p:cNvSpPr>
            <p:nvPr/>
          </p:nvSpPr>
          <p:spPr>
            <a:xfrm rot="6452956" flipV="1">
              <a:off x="1221309" y="5074252"/>
              <a:ext cx="180000" cy="612000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66" name="Elipse 465">
              <a:extLst>
                <a:ext uri="{FF2B5EF4-FFF2-40B4-BE49-F238E27FC236}">
                  <a16:creationId xmlns:a16="http://schemas.microsoft.com/office/drawing/2014/main" id="{476DF135-70B8-4449-924C-39155A7CB7F8}"/>
                </a:ext>
              </a:extLst>
            </p:cNvPr>
            <p:cNvSpPr>
              <a:spLocks/>
            </p:cNvSpPr>
            <p:nvPr/>
          </p:nvSpPr>
          <p:spPr>
            <a:xfrm rot="17617904">
              <a:off x="1221309" y="5516832"/>
              <a:ext cx="180000" cy="612000"/>
            </a:xfrm>
            <a:prstGeom prst="ellips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467" name="Imagen 466">
              <a:extLst>
                <a:ext uri="{FF2B5EF4-FFF2-40B4-BE49-F238E27FC236}">
                  <a16:creationId xmlns:a16="http://schemas.microsoft.com/office/drawing/2014/main" id="{5FB77C84-613C-3C48-B5ED-C41CAA19112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rot="16200000">
              <a:off x="2592413" y="6485104"/>
              <a:ext cx="379286" cy="360000"/>
            </a:xfrm>
            <a:prstGeom prst="rect">
              <a:avLst/>
            </a:prstGeom>
          </p:spPr>
        </p:pic>
        <p:sp>
          <p:nvSpPr>
            <p:cNvPr id="468" name="CuadroTexto 467">
              <a:extLst>
                <a:ext uri="{FF2B5EF4-FFF2-40B4-BE49-F238E27FC236}">
                  <a16:creationId xmlns:a16="http://schemas.microsoft.com/office/drawing/2014/main" id="{AB4C3FBC-268B-4442-BACC-1A17393BE51C}"/>
                </a:ext>
              </a:extLst>
            </p:cNvPr>
            <p:cNvSpPr txBox="1"/>
            <p:nvPr/>
          </p:nvSpPr>
          <p:spPr>
            <a:xfrm>
              <a:off x="1603424" y="7414983"/>
              <a:ext cx="5180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APC</a:t>
              </a:r>
            </a:p>
          </p:txBody>
        </p:sp>
        <p:sp>
          <p:nvSpPr>
            <p:cNvPr id="474" name="CuadroTexto 473">
              <a:extLst>
                <a:ext uri="{FF2B5EF4-FFF2-40B4-BE49-F238E27FC236}">
                  <a16:creationId xmlns:a16="http://schemas.microsoft.com/office/drawing/2014/main" id="{3F29B4B5-54FB-A241-B661-D41643E3E309}"/>
                </a:ext>
              </a:extLst>
            </p:cNvPr>
            <p:cNvSpPr txBox="1"/>
            <p:nvPr/>
          </p:nvSpPr>
          <p:spPr>
            <a:xfrm>
              <a:off x="1774266" y="4804525"/>
              <a:ext cx="4251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NK</a:t>
              </a:r>
            </a:p>
          </p:txBody>
        </p:sp>
        <p:sp>
          <p:nvSpPr>
            <p:cNvPr id="475" name="CuadroTexto 474">
              <a:extLst>
                <a:ext uri="{FF2B5EF4-FFF2-40B4-BE49-F238E27FC236}">
                  <a16:creationId xmlns:a16="http://schemas.microsoft.com/office/drawing/2014/main" id="{226A7606-8497-1445-A028-531341AFF956}"/>
                </a:ext>
              </a:extLst>
            </p:cNvPr>
            <p:cNvSpPr txBox="1"/>
            <p:nvPr/>
          </p:nvSpPr>
          <p:spPr>
            <a:xfrm>
              <a:off x="3036021" y="5210975"/>
              <a:ext cx="10347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Monocyte</a:t>
              </a:r>
              <a:endParaRPr lang="es-ES" sz="1600" dirty="0"/>
            </a:p>
          </p:txBody>
        </p:sp>
        <p:sp>
          <p:nvSpPr>
            <p:cNvPr id="476" name="CuadroTexto 475">
              <a:extLst>
                <a:ext uri="{FF2B5EF4-FFF2-40B4-BE49-F238E27FC236}">
                  <a16:creationId xmlns:a16="http://schemas.microsoft.com/office/drawing/2014/main" id="{B7E52A18-F4F0-6E49-A040-E75C14302247}"/>
                </a:ext>
              </a:extLst>
            </p:cNvPr>
            <p:cNvSpPr txBox="1"/>
            <p:nvPr/>
          </p:nvSpPr>
          <p:spPr>
            <a:xfrm>
              <a:off x="3084196" y="7414983"/>
              <a:ext cx="10997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Linfocyte</a:t>
              </a:r>
              <a:r>
                <a:rPr lang="es-ES" sz="1600" dirty="0"/>
                <a:t> B</a:t>
              </a:r>
            </a:p>
          </p:txBody>
        </p:sp>
        <p:sp>
          <p:nvSpPr>
            <p:cNvPr id="478" name="CuadroTexto 477">
              <a:extLst>
                <a:ext uri="{FF2B5EF4-FFF2-40B4-BE49-F238E27FC236}">
                  <a16:creationId xmlns:a16="http://schemas.microsoft.com/office/drawing/2014/main" id="{DB0B6C93-12A3-AA41-9514-375D643CA92E}"/>
                </a:ext>
              </a:extLst>
            </p:cNvPr>
            <p:cNvSpPr txBox="1"/>
            <p:nvPr/>
          </p:nvSpPr>
          <p:spPr>
            <a:xfrm>
              <a:off x="1620676" y="6957014"/>
              <a:ext cx="8655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Platellet</a:t>
              </a:r>
              <a:endParaRPr lang="es-ES" sz="1600" dirty="0"/>
            </a:p>
          </p:txBody>
        </p:sp>
        <p:sp>
          <p:nvSpPr>
            <p:cNvPr id="479" name="Elipse 478">
              <a:extLst>
                <a:ext uri="{FF2B5EF4-FFF2-40B4-BE49-F238E27FC236}">
                  <a16:creationId xmlns:a16="http://schemas.microsoft.com/office/drawing/2014/main" id="{992D4EFD-BED3-DA40-A5D9-4AAE9C22708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85309" y="6539104"/>
              <a:ext cx="252000" cy="252000"/>
            </a:xfrm>
            <a:prstGeom prst="ellipse">
              <a:avLst/>
            </a:prstGeom>
            <a:gradFill flip="none" rotWithShape="1">
              <a:gsLst>
                <a:gs pos="3000">
                  <a:srgbClr val="FFFC00">
                    <a:shade val="30000"/>
                    <a:satMod val="115000"/>
                  </a:srgbClr>
                </a:gs>
                <a:gs pos="40000">
                  <a:srgbClr val="FFFC00">
                    <a:shade val="67500"/>
                    <a:satMod val="115000"/>
                  </a:srgbClr>
                </a:gs>
                <a:gs pos="34000">
                  <a:srgbClr val="FFFC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81" name="CuadroTexto 480">
              <a:extLst>
                <a:ext uri="{FF2B5EF4-FFF2-40B4-BE49-F238E27FC236}">
                  <a16:creationId xmlns:a16="http://schemas.microsoft.com/office/drawing/2014/main" id="{89692A89-9464-A04C-89D3-2D46ED9E5D2E}"/>
                </a:ext>
              </a:extLst>
            </p:cNvPr>
            <p:cNvSpPr txBox="1"/>
            <p:nvPr/>
          </p:nvSpPr>
          <p:spPr>
            <a:xfrm>
              <a:off x="3084196" y="6957014"/>
              <a:ext cx="1082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Neutrophil</a:t>
              </a:r>
              <a:endParaRPr lang="es-ES" sz="1600" dirty="0"/>
            </a:p>
          </p:txBody>
        </p:sp>
        <p:sp>
          <p:nvSpPr>
            <p:cNvPr id="482" name="CuadroTexto 481">
              <a:extLst>
                <a:ext uri="{FF2B5EF4-FFF2-40B4-BE49-F238E27FC236}">
                  <a16:creationId xmlns:a16="http://schemas.microsoft.com/office/drawing/2014/main" id="{5EF83BB0-BE83-DF4E-A3F5-CB9BDFB82A47}"/>
                </a:ext>
              </a:extLst>
            </p:cNvPr>
            <p:cNvSpPr txBox="1"/>
            <p:nvPr/>
          </p:nvSpPr>
          <p:spPr>
            <a:xfrm>
              <a:off x="1684850" y="6058601"/>
              <a:ext cx="6039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Mast</a:t>
              </a:r>
              <a:endParaRPr lang="es-ES" sz="1600" dirty="0"/>
            </a:p>
          </p:txBody>
        </p:sp>
        <p:sp>
          <p:nvSpPr>
            <p:cNvPr id="483" name="CuadroTexto 482">
              <a:extLst>
                <a:ext uri="{FF2B5EF4-FFF2-40B4-BE49-F238E27FC236}">
                  <a16:creationId xmlns:a16="http://schemas.microsoft.com/office/drawing/2014/main" id="{2D8F39A3-660F-1543-A331-B9B918109506}"/>
                </a:ext>
              </a:extLst>
            </p:cNvPr>
            <p:cNvSpPr txBox="1"/>
            <p:nvPr/>
          </p:nvSpPr>
          <p:spPr>
            <a:xfrm>
              <a:off x="1668468" y="5653555"/>
              <a:ext cx="6367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p-SEL</a:t>
              </a:r>
            </a:p>
          </p:txBody>
        </p:sp>
        <p:sp>
          <p:nvSpPr>
            <p:cNvPr id="484" name="CuadroTexto 483">
              <a:extLst>
                <a:ext uri="{FF2B5EF4-FFF2-40B4-BE49-F238E27FC236}">
                  <a16:creationId xmlns:a16="http://schemas.microsoft.com/office/drawing/2014/main" id="{5275BEC4-9D33-8541-8B90-87D189973972}"/>
                </a:ext>
              </a:extLst>
            </p:cNvPr>
            <p:cNvSpPr txBox="1"/>
            <p:nvPr/>
          </p:nvSpPr>
          <p:spPr>
            <a:xfrm>
              <a:off x="1670872" y="5210975"/>
              <a:ext cx="631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e-SEL</a:t>
              </a:r>
            </a:p>
          </p:txBody>
        </p:sp>
        <p:sp>
          <p:nvSpPr>
            <p:cNvPr id="485" name="CuadroTexto 484">
              <a:extLst>
                <a:ext uri="{FF2B5EF4-FFF2-40B4-BE49-F238E27FC236}">
                  <a16:creationId xmlns:a16="http://schemas.microsoft.com/office/drawing/2014/main" id="{A9FDA466-D905-9F42-A681-39A78F96D060}"/>
                </a:ext>
              </a:extLst>
            </p:cNvPr>
            <p:cNvSpPr txBox="1"/>
            <p:nvPr/>
          </p:nvSpPr>
          <p:spPr>
            <a:xfrm>
              <a:off x="3036021" y="4804525"/>
              <a:ext cx="12311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Macrophage</a:t>
              </a:r>
              <a:endParaRPr lang="es-ES" sz="1600" dirty="0"/>
            </a:p>
          </p:txBody>
        </p:sp>
        <p:sp>
          <p:nvSpPr>
            <p:cNvPr id="486" name="CuadroTexto 485">
              <a:extLst>
                <a:ext uri="{FF2B5EF4-FFF2-40B4-BE49-F238E27FC236}">
                  <a16:creationId xmlns:a16="http://schemas.microsoft.com/office/drawing/2014/main" id="{C5688F02-7A8A-C146-86F2-4254F45D82A7}"/>
                </a:ext>
              </a:extLst>
            </p:cNvPr>
            <p:cNvSpPr txBox="1"/>
            <p:nvPr/>
          </p:nvSpPr>
          <p:spPr>
            <a:xfrm>
              <a:off x="3036021" y="5653555"/>
              <a:ext cx="9957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Dendritic</a:t>
              </a:r>
              <a:r>
                <a:rPr lang="es-ES" sz="1600" dirty="0"/>
                <a:t> </a:t>
              </a:r>
            </a:p>
          </p:txBody>
        </p:sp>
        <p:sp>
          <p:nvSpPr>
            <p:cNvPr id="487" name="CuadroTexto 486">
              <a:extLst>
                <a:ext uri="{FF2B5EF4-FFF2-40B4-BE49-F238E27FC236}">
                  <a16:creationId xmlns:a16="http://schemas.microsoft.com/office/drawing/2014/main" id="{ACD1CC69-5F88-7F4D-AC8F-DE2A91E6A1C8}"/>
                </a:ext>
              </a:extLst>
            </p:cNvPr>
            <p:cNvSpPr txBox="1"/>
            <p:nvPr/>
          </p:nvSpPr>
          <p:spPr>
            <a:xfrm>
              <a:off x="3036021" y="6058601"/>
              <a:ext cx="10726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Leukocyte</a:t>
              </a:r>
              <a:r>
                <a:rPr lang="es-ES" sz="1600" dirty="0"/>
                <a:t> </a:t>
              </a:r>
            </a:p>
          </p:txBody>
        </p:sp>
        <p:sp>
          <p:nvSpPr>
            <p:cNvPr id="488" name="Elipse 487">
              <a:extLst>
                <a:ext uri="{FF2B5EF4-FFF2-40B4-BE49-F238E27FC236}">
                  <a16:creationId xmlns:a16="http://schemas.microsoft.com/office/drawing/2014/main" id="{618B83BF-B610-4145-B8F2-711EA58B4E92}"/>
                </a:ext>
              </a:extLst>
            </p:cNvPr>
            <p:cNvSpPr>
              <a:spLocks/>
            </p:cNvSpPr>
            <p:nvPr/>
          </p:nvSpPr>
          <p:spPr>
            <a:xfrm>
              <a:off x="1325756" y="9251199"/>
              <a:ext cx="180000" cy="180000"/>
            </a:xfrm>
            <a:prstGeom prst="ellipse">
              <a:avLst/>
            </a:prstGeom>
            <a:solidFill>
              <a:srgbClr val="92D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493" name="Elipse 492">
              <a:extLst>
                <a:ext uri="{FF2B5EF4-FFF2-40B4-BE49-F238E27FC236}">
                  <a16:creationId xmlns:a16="http://schemas.microsoft.com/office/drawing/2014/main" id="{47A40F41-986D-5146-B2AE-B100009B34D3}"/>
                </a:ext>
              </a:extLst>
            </p:cNvPr>
            <p:cNvSpPr>
              <a:spLocks/>
            </p:cNvSpPr>
            <p:nvPr/>
          </p:nvSpPr>
          <p:spPr>
            <a:xfrm>
              <a:off x="1325756" y="8888667"/>
              <a:ext cx="180000" cy="180000"/>
            </a:xfrm>
            <a:prstGeom prst="ellipse">
              <a:avLst/>
            </a:prstGeom>
            <a:solidFill>
              <a:srgbClr val="FF7E7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494" name="CuadroTexto 493">
              <a:extLst>
                <a:ext uri="{FF2B5EF4-FFF2-40B4-BE49-F238E27FC236}">
                  <a16:creationId xmlns:a16="http://schemas.microsoft.com/office/drawing/2014/main" id="{F30E51D0-1A0C-6646-805C-8D3A37701978}"/>
                </a:ext>
              </a:extLst>
            </p:cNvPr>
            <p:cNvSpPr txBox="1"/>
            <p:nvPr/>
          </p:nvSpPr>
          <p:spPr>
            <a:xfrm>
              <a:off x="1560232" y="9171922"/>
              <a:ext cx="246356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Anti-</a:t>
              </a:r>
              <a:r>
                <a:rPr lang="es-ES" sz="1600" dirty="0" err="1"/>
                <a:t>inflammatory</a:t>
              </a:r>
              <a:r>
                <a:rPr lang="es-ES" sz="1600" dirty="0"/>
                <a:t> </a:t>
              </a:r>
              <a:r>
                <a:rPr lang="es-ES" sz="1600" dirty="0" err="1"/>
                <a:t>cytokine</a:t>
              </a:r>
              <a:endParaRPr lang="es-ES" sz="1600" dirty="0"/>
            </a:p>
          </p:txBody>
        </p:sp>
        <p:sp>
          <p:nvSpPr>
            <p:cNvPr id="497" name="CuadroTexto 496">
              <a:extLst>
                <a:ext uri="{FF2B5EF4-FFF2-40B4-BE49-F238E27FC236}">
                  <a16:creationId xmlns:a16="http://schemas.microsoft.com/office/drawing/2014/main" id="{79C82EEA-1006-D343-BAE1-A3B78BDEB02F}"/>
                </a:ext>
              </a:extLst>
            </p:cNvPr>
            <p:cNvSpPr txBox="1"/>
            <p:nvPr/>
          </p:nvSpPr>
          <p:spPr>
            <a:xfrm>
              <a:off x="1560232" y="8809390"/>
              <a:ext cx="24076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Pro-</a:t>
              </a:r>
              <a:r>
                <a:rPr lang="es-ES" sz="1600" dirty="0" err="1"/>
                <a:t>inflammatory</a:t>
              </a:r>
              <a:r>
                <a:rPr lang="es-ES" sz="1600" dirty="0"/>
                <a:t> </a:t>
              </a:r>
              <a:r>
                <a:rPr lang="es-ES" sz="1600" dirty="0" err="1"/>
                <a:t>cytokine</a:t>
              </a:r>
              <a:endParaRPr lang="es-ES" sz="1600" dirty="0"/>
            </a:p>
          </p:txBody>
        </p:sp>
        <p:sp>
          <p:nvSpPr>
            <p:cNvPr id="499" name="CuadroTexto 498">
              <a:extLst>
                <a:ext uri="{FF2B5EF4-FFF2-40B4-BE49-F238E27FC236}">
                  <a16:creationId xmlns:a16="http://schemas.microsoft.com/office/drawing/2014/main" id="{BE45C664-E409-E545-93BA-7BBFFF083252}"/>
                </a:ext>
              </a:extLst>
            </p:cNvPr>
            <p:cNvSpPr txBox="1"/>
            <p:nvPr/>
          </p:nvSpPr>
          <p:spPr>
            <a:xfrm>
              <a:off x="3036021" y="6495827"/>
              <a:ext cx="129881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Inflammation</a:t>
              </a:r>
              <a:endParaRPr lang="es-ES" sz="1600" dirty="0"/>
            </a:p>
          </p:txBody>
        </p:sp>
        <p:sp>
          <p:nvSpPr>
            <p:cNvPr id="500" name="CuadroTexto 499">
              <a:extLst>
                <a:ext uri="{FF2B5EF4-FFF2-40B4-BE49-F238E27FC236}">
                  <a16:creationId xmlns:a16="http://schemas.microsoft.com/office/drawing/2014/main" id="{EFADDDD0-90DA-4B4D-93D8-DAA04517E822}"/>
                </a:ext>
              </a:extLst>
            </p:cNvPr>
            <p:cNvSpPr txBox="1"/>
            <p:nvPr/>
          </p:nvSpPr>
          <p:spPr>
            <a:xfrm>
              <a:off x="1526570" y="6495827"/>
              <a:ext cx="9205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Infection</a:t>
              </a:r>
              <a:endParaRPr lang="es-ES" sz="1600" dirty="0"/>
            </a:p>
          </p:txBody>
        </p:sp>
        <p:pic>
          <p:nvPicPr>
            <p:cNvPr id="501" name="Imagen 500">
              <a:extLst>
                <a:ext uri="{FF2B5EF4-FFF2-40B4-BE49-F238E27FC236}">
                  <a16:creationId xmlns:a16="http://schemas.microsoft.com/office/drawing/2014/main" id="{079B972C-55DF-F845-90D9-49E7B949E1F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199756" y="7942000"/>
              <a:ext cx="432000" cy="313321"/>
            </a:xfrm>
            <a:prstGeom prst="rect">
              <a:avLst/>
            </a:prstGeom>
          </p:spPr>
        </p:pic>
        <p:pic>
          <p:nvPicPr>
            <p:cNvPr id="502" name="Imagen 501">
              <a:extLst>
                <a:ext uri="{FF2B5EF4-FFF2-40B4-BE49-F238E27FC236}">
                  <a16:creationId xmlns:a16="http://schemas.microsoft.com/office/drawing/2014/main" id="{B8009B1F-CCF9-8446-8EB8-8FFD0C58469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99756" y="8378232"/>
              <a:ext cx="432000" cy="319674"/>
            </a:xfrm>
            <a:prstGeom prst="rect">
              <a:avLst/>
            </a:prstGeom>
          </p:spPr>
        </p:pic>
        <p:sp>
          <p:nvSpPr>
            <p:cNvPr id="533" name="CuadroTexto 532">
              <a:extLst>
                <a:ext uri="{FF2B5EF4-FFF2-40B4-BE49-F238E27FC236}">
                  <a16:creationId xmlns:a16="http://schemas.microsoft.com/office/drawing/2014/main" id="{3220C027-5C76-C44A-BB0F-112EAF31631C}"/>
                </a:ext>
              </a:extLst>
            </p:cNvPr>
            <p:cNvSpPr txBox="1"/>
            <p:nvPr/>
          </p:nvSpPr>
          <p:spPr>
            <a:xfrm>
              <a:off x="1676607" y="7929383"/>
              <a:ext cx="14542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Endothelial</a:t>
              </a:r>
              <a:r>
                <a:rPr lang="es-ES" sz="1600" dirty="0"/>
                <a:t> </a:t>
              </a:r>
              <a:r>
                <a:rPr lang="es-ES" sz="1600" dirty="0" err="1"/>
                <a:t>cell</a:t>
              </a:r>
              <a:endParaRPr lang="es-ES" sz="1600" dirty="0"/>
            </a:p>
          </p:txBody>
        </p:sp>
        <p:sp>
          <p:nvSpPr>
            <p:cNvPr id="536" name="CuadroTexto 535">
              <a:extLst>
                <a:ext uri="{FF2B5EF4-FFF2-40B4-BE49-F238E27FC236}">
                  <a16:creationId xmlns:a16="http://schemas.microsoft.com/office/drawing/2014/main" id="{CBAA1960-C2AC-F144-88BE-27B8CC650A33}"/>
                </a:ext>
              </a:extLst>
            </p:cNvPr>
            <p:cNvSpPr txBox="1"/>
            <p:nvPr/>
          </p:nvSpPr>
          <p:spPr>
            <a:xfrm>
              <a:off x="1676607" y="8368792"/>
              <a:ext cx="22854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Activated</a:t>
              </a:r>
              <a:r>
                <a:rPr lang="es-ES" sz="1600" dirty="0"/>
                <a:t> </a:t>
              </a:r>
              <a:r>
                <a:rPr lang="es-ES" sz="1600" dirty="0" err="1"/>
                <a:t>endothelial</a:t>
              </a:r>
              <a:r>
                <a:rPr lang="es-ES" sz="1600" dirty="0"/>
                <a:t> </a:t>
              </a:r>
              <a:r>
                <a:rPr lang="es-ES" sz="1600" dirty="0" err="1"/>
                <a:t>cell</a:t>
              </a:r>
              <a:endParaRPr lang="es-ES" sz="1600" dirty="0"/>
            </a:p>
          </p:txBody>
        </p:sp>
      </p:grpSp>
      <p:pic>
        <p:nvPicPr>
          <p:cNvPr id="401" name="Imagen 400">
            <a:extLst>
              <a:ext uri="{FF2B5EF4-FFF2-40B4-BE49-F238E27FC236}">
                <a16:creationId xmlns:a16="http://schemas.microsoft.com/office/drawing/2014/main" id="{10B1E059-1584-544F-9840-15692D895C7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20903" y="1044690"/>
            <a:ext cx="504000" cy="504000"/>
          </a:xfrm>
          <a:prstGeom prst="rect">
            <a:avLst/>
          </a:prstGeom>
        </p:spPr>
      </p:pic>
      <p:cxnSp>
        <p:nvCxnSpPr>
          <p:cNvPr id="406" name="Conector recto 405">
            <a:extLst>
              <a:ext uri="{FF2B5EF4-FFF2-40B4-BE49-F238E27FC236}">
                <a16:creationId xmlns:a16="http://schemas.microsoft.com/office/drawing/2014/main" id="{6BB78C6C-D711-474A-87BE-667384F15040}"/>
              </a:ext>
            </a:extLst>
          </p:cNvPr>
          <p:cNvCxnSpPr>
            <a:cxnSpLocks/>
          </p:cNvCxnSpPr>
          <p:nvPr/>
        </p:nvCxnSpPr>
        <p:spPr>
          <a:xfrm flipH="1">
            <a:off x="6757066" y="1612972"/>
            <a:ext cx="29317" cy="607704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8" name="Conector recto 407">
            <a:extLst>
              <a:ext uri="{FF2B5EF4-FFF2-40B4-BE49-F238E27FC236}">
                <a16:creationId xmlns:a16="http://schemas.microsoft.com/office/drawing/2014/main" id="{40432AC2-E1D4-8C43-89F4-004DF468437D}"/>
              </a:ext>
            </a:extLst>
          </p:cNvPr>
          <p:cNvCxnSpPr>
            <a:cxnSpLocks/>
          </p:cNvCxnSpPr>
          <p:nvPr/>
        </p:nvCxnSpPr>
        <p:spPr>
          <a:xfrm>
            <a:off x="6996268" y="1259372"/>
            <a:ext cx="380404" cy="179869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Conector recto 408">
            <a:extLst>
              <a:ext uri="{FF2B5EF4-FFF2-40B4-BE49-F238E27FC236}">
                <a16:creationId xmlns:a16="http://schemas.microsoft.com/office/drawing/2014/main" id="{B1DFF92E-3096-6A46-B189-C396D4AC3636}"/>
              </a:ext>
            </a:extLst>
          </p:cNvPr>
          <p:cNvCxnSpPr>
            <a:cxnSpLocks/>
          </p:cNvCxnSpPr>
          <p:nvPr/>
        </p:nvCxnSpPr>
        <p:spPr>
          <a:xfrm flipH="1">
            <a:off x="8839547" y="1227799"/>
            <a:ext cx="149779" cy="1518048"/>
          </a:xfrm>
          <a:prstGeom prst="line">
            <a:avLst/>
          </a:prstGeom>
          <a:ln w="28575">
            <a:solidFill>
              <a:srgbClr val="C00000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918326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92</TotalTime>
  <Words>221</Words>
  <Application>Microsoft Office PowerPoint</Application>
  <PresentationFormat>Custom</PresentationFormat>
  <Paragraphs>8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ebeca Osca Verdegal</dc:creator>
  <cp:lastModifiedBy>MDPI</cp:lastModifiedBy>
  <cp:revision>55</cp:revision>
  <dcterms:created xsi:type="dcterms:W3CDTF">2021-07-10T14:41:45Z</dcterms:created>
  <dcterms:modified xsi:type="dcterms:W3CDTF">2022-02-23T06:41:30Z</dcterms:modified>
</cp:coreProperties>
</file>